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embeddings/oleObject1.xlsx" ContentType="application/vnd.openxmlformats-officedocument.spreadsheetml.sheet"/>
  <Override PartName="/ppt/media/image1.wmf" ContentType="image/x-wmf"/>
  <Override PartName="/ppt/media/image2.png" ContentType="image/png"/>
  <Override PartName="/ppt/media/image3.jpeg" ContentType="image/jpeg"/>
  <Override PartName="/ppt/media/image4.png" ContentType="image/png"/>
  <Override PartName="/ppt/media/image5.png" ContentType="image/png"/>
  <Override PartName="/ppt/media/image6.png" ContentType="image/png"/>
  <Override PartName="/ppt/media/image7.png" ContentType="image/png"/>
  <Override PartName="/ppt/media/image8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D536985-E47E-4F84-897E-F8A9A377277D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7BF1A5B-09F8-4EF7-8A79-C0EEF8F7717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A80A508-C180-4E9F-AE4F-0A2667B4858A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FEB39A6-0094-4B4B-B8E4-EEDF6D24D53C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A664B95-6D4C-4915-9329-22B876801F1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6EE415C-F25A-4DB0-99E8-8B39F61A5A2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A6026D9-613E-4704-A647-3AA90E10426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57A21C0-9500-4EAC-A987-0F040EB24B0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BC99E68-8BF7-4810-BE27-6C90DE4E50E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A207A46-1B71-4204-A4EE-72EEFA05496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209733E-E7DA-4244-85E1-52C6C63160C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5938DC7-D93A-4081-BAC6-F498DA6AF9C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99F02583-FAFE-4CE0-9F9B-B7BEFA390824}" type="datetime">
              <a:rPr b="0" lang="en-US" sz="1200" spc="-1" strike="noStrike">
                <a:solidFill>
                  <a:srgbClr val="898989"/>
                </a:solidFill>
                <a:latin typeface="Calibri"/>
              </a:rPr>
              <a:t>08/29/26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F7FC6352-CB34-4950-B789-2282FAE3291C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package" Target="../embeddings/oleObject1.xlsx"/><Relationship Id="rId2" Type="http://schemas.openxmlformats.org/officeDocument/2006/relationships/image" Target="../media/image1.wmf"/><Relationship Id="rId3" Type="http://schemas.openxmlformats.org/officeDocument/2006/relationships/image" Target="../media/image2.png"/><Relationship Id="rId4" Type="http://schemas.openxmlformats.org/officeDocument/2006/relationships/image" Target="../media/image3.jpeg"/><Relationship Id="rId5" Type="http://schemas.openxmlformats.org/officeDocument/2006/relationships/image" Target="../media/image4.png"/><Relationship Id="rId6" Type="http://schemas.openxmlformats.org/officeDocument/2006/relationships/image" Target="../media/image5.png"/><Relationship Id="rId7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6.png"/><Relationship Id="rId2" Type="http://schemas.openxmlformats.org/officeDocument/2006/relationships/image" Target="../media/image7.png"/><Relationship Id="rId3" Type="http://schemas.openxmlformats.org/officeDocument/2006/relationships/image" Target="../media/image8.png"/><Relationship Id="rId4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"/>
          <p:cNvGrpSpPr/>
          <p:nvPr/>
        </p:nvGrpSpPr>
        <p:grpSpPr>
          <a:xfrm>
            <a:off x="330120" y="415440"/>
            <a:ext cx="8483760" cy="6230520"/>
            <a:chOff x="330120" y="415440"/>
            <a:chExt cx="8483760" cy="6230520"/>
          </a:xfrm>
        </p:grpSpPr>
        <p:sp>
          <p:nvSpPr>
            <p:cNvPr id="42" name="TextBox 1"/>
            <p:cNvSpPr/>
            <p:nvPr/>
          </p:nvSpPr>
          <p:spPr>
            <a:xfrm>
              <a:off x="330120" y="4909320"/>
              <a:ext cx="8483760" cy="1736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spAutoFit/>
            </a:bodyPr>
            <a:p>
              <a:pPr algn="just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Figure S5. </a:t>
              </a: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(A) Recombinant CD81 surface expression in HepG2 cells. </a:t>
              </a: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HepG2 cells transduced with a recombinant lentivirus encoding human CD81 (open line) or parental cells (grey) were analyzed by flow cytometry for stable surface expression of CD81; isotype IgG (black). </a:t>
              </a: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(B) Lack of infectious HCVrp production by BHK cells. </a:t>
              </a: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Huh-7.5 cells seeded in a 96-well plate were incubated for 1 hr with HCVrp produced in parental BHK-21 or BHK-WNV cells, followed by transfection with the reporter plasmid system. </a:t>
              </a:r>
              <a:r>
                <a:rPr b="0" i="1" lang="en-US" sz="12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Firefly</a:t>
              </a: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 luciferase activities were measured in cell lysates 24 hr later. </a:t>
              </a: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These results are representative of n = 3 independent experiments. </a:t>
              </a: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(C)</a:t>
              </a: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 </a:t>
              </a: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Knock-down of HCV candidate receptors in Huh-7.5 cells. </a:t>
              </a: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Huh-7.5 cells were treated with the indicated siRNA for 2 days and the reduction in protein expression was confirmed by WB (SR-BI), or flow cytometry (ASGPR-1 and CD81). siGlo siRNA was used to measure transfection efficiency. Numbers represent MFI. 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43" name=""/>
            <p:cNvGrpSpPr/>
            <p:nvPr/>
          </p:nvGrpSpPr>
          <p:grpSpPr>
            <a:xfrm>
              <a:off x="343080" y="415440"/>
              <a:ext cx="8342640" cy="4319280"/>
              <a:chOff x="343080" y="415440"/>
              <a:chExt cx="8342640" cy="4319280"/>
            </a:xfrm>
          </p:grpSpPr>
          <p:sp>
            <p:nvSpPr>
              <p:cNvPr id="44" name="Text Box 305"/>
              <p:cNvSpPr/>
              <p:nvPr/>
            </p:nvSpPr>
            <p:spPr>
              <a:xfrm>
                <a:off x="4345200" y="4473360"/>
                <a:ext cx="80244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1100" spc="-1" strike="noStrike">
                    <a:solidFill>
                      <a:srgbClr val="000000"/>
                    </a:solidFill>
                    <a:latin typeface="Arial"/>
                  </a:rPr>
                  <a:t>ASGP-R1</a:t>
                </a:r>
                <a:endParaRPr b="0" lang="en-US" sz="11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45" name=""/>
              <p:cNvGrpSpPr/>
              <p:nvPr/>
            </p:nvGrpSpPr>
            <p:grpSpPr>
              <a:xfrm>
                <a:off x="343080" y="415440"/>
                <a:ext cx="8342640" cy="4286160"/>
                <a:chOff x="343080" y="415440"/>
                <a:chExt cx="8342640" cy="4286160"/>
              </a:xfrm>
            </p:grpSpPr>
            <p:grpSp>
              <p:nvGrpSpPr>
                <p:cNvPr id="46" name="Group 17"/>
                <p:cNvGrpSpPr/>
                <p:nvPr/>
              </p:nvGrpSpPr>
              <p:grpSpPr>
                <a:xfrm>
                  <a:off x="414360" y="2196360"/>
                  <a:ext cx="3171960" cy="2505240"/>
                  <a:chOff x="414360" y="2196360"/>
                  <a:chExt cx="3171960" cy="2505240"/>
                </a:xfrm>
              </p:grpSpPr>
              <p:grpSp>
                <p:nvGrpSpPr>
                  <p:cNvPr id="47" name="Group 8"/>
                  <p:cNvGrpSpPr/>
                  <p:nvPr/>
                </p:nvGrpSpPr>
                <p:grpSpPr>
                  <a:xfrm>
                    <a:off x="414360" y="2205000"/>
                    <a:ext cx="3171960" cy="2496600"/>
                    <a:chOff x="414360" y="2205000"/>
                    <a:chExt cx="3171960" cy="2496600"/>
                  </a:xfrm>
                </p:grpSpPr>
                <p:graphicFrame>
                  <p:nvGraphicFramePr>
                    <p:cNvPr id="48" name="Object 33"/>
                    <p:cNvGraphicFramePr/>
                    <p:nvPr/>
                  </p:nvGraphicFramePr>
                  <p:xfrm>
                    <a:off x="678960" y="2205000"/>
                    <a:ext cx="2907360" cy="2250000"/>
                  </p:xfrm>
                  <a:graphic>
                    <a:graphicData uri="http://schemas.openxmlformats.org/presentationml/2006/ole">
                      <p:oleObj progId="Excel.Sheet.12" r:id="rId1" spid="">
                        <p:embed/>
                        <p:pic>
                          <p:nvPicPr>
                            <p:cNvPr id="49" name="Object 33" descr=""/>
                            <p:cNvPicPr/>
                            <p:nvPr/>
                          </p:nvPicPr>
                          <p:blipFill>
                            <a:blip r:embed="rId2"/>
                            <a:stretch/>
                          </p:blipFill>
                          <p:spPr>
                            <a:xfrm>
                              <a:off x="678960" y="2205000"/>
                              <a:ext cx="2907360" cy="2250000"/>
                            </a:xfrm>
                            <a:prstGeom prst="rect">
                              <a:avLst/>
                            </a:prstGeom>
                            <a:ln w="0">
                              <a:noFill/>
                            </a:ln>
                          </p:spPr>
                        </p:pic>
                      </p:oleObj>
                    </a:graphicData>
                  </a:graphic>
                </p:graphicFrame>
                <p:sp>
                  <p:nvSpPr>
                    <p:cNvPr id="50" name="Text Box 14"/>
                    <p:cNvSpPr/>
                    <p:nvPr/>
                  </p:nvSpPr>
                  <p:spPr>
                    <a:xfrm rot="16200000">
                      <a:off x="-373320" y="3306960"/>
                      <a:ext cx="1852560" cy="27648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90000" rIns="90000" tIns="46800" bIns="46800" anchor="t">
                      <a:spAutoFit/>
                    </a:bodyPr>
                    <a:p>
                      <a:pPr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i="1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Firefly</a:t>
                      </a: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 luciferase (RLU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51" name="Text Box 119"/>
                    <p:cNvSpPr/>
                    <p:nvPr/>
                  </p:nvSpPr>
                  <p:spPr>
                    <a:xfrm>
                      <a:off x="1289520" y="4425120"/>
                      <a:ext cx="1982160" cy="27648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90000" rIns="90000" tIns="46800" bIns="46800" anchor="t">
                      <a:spAutoFit/>
                    </a:bodyPr>
                    <a:p>
                      <a:pPr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Relative virus inoculums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</p:grpSp>
              <p:grpSp>
                <p:nvGrpSpPr>
                  <p:cNvPr id="52" name="Group 27"/>
                  <p:cNvGrpSpPr/>
                  <p:nvPr/>
                </p:nvGrpSpPr>
                <p:grpSpPr>
                  <a:xfrm>
                    <a:off x="1468800" y="2196360"/>
                    <a:ext cx="2045520" cy="489240"/>
                    <a:chOff x="1468800" y="2196360"/>
                    <a:chExt cx="2045520" cy="489240"/>
                  </a:xfrm>
                </p:grpSpPr>
                <p:grpSp>
                  <p:nvGrpSpPr>
                    <p:cNvPr id="53" name="Group 22"/>
                    <p:cNvGrpSpPr/>
                    <p:nvPr/>
                  </p:nvGrpSpPr>
                  <p:grpSpPr>
                    <a:xfrm>
                      <a:off x="1477080" y="2537280"/>
                      <a:ext cx="264960" cy="87120"/>
                      <a:chOff x="1477080" y="2537280"/>
                      <a:chExt cx="264960" cy="87120"/>
                    </a:xfrm>
                  </p:grpSpPr>
                  <p:sp>
                    <p:nvSpPr>
                      <p:cNvPr id="54" name="Oval 7"/>
                      <p:cNvSpPr/>
                      <p:nvPr/>
                    </p:nvSpPr>
                    <p:spPr>
                      <a:xfrm>
                        <a:off x="1577520" y="2537280"/>
                        <a:ext cx="81000" cy="87120"/>
                      </a:xfrm>
                      <a:prstGeom prst="ellipse">
                        <a:avLst/>
                      </a:prstGeom>
                      <a:solidFill>
                        <a:srgbClr val="000000"/>
                      </a:solidFill>
                      <a:ln w="19080">
                        <a:solidFill>
                          <a:srgbClr val="000000"/>
                        </a:solidFill>
                        <a:miter/>
                      </a:ln>
                    </p:spPr>
                    <p:style>
                      <a:lnRef idx="0"/>
                      <a:fillRef idx="0"/>
                      <a:effectRef idx="0"/>
                      <a:fontRef idx="minor"/>
                    </p:style>
                    <p:txBody>
                      <a:bodyPr wrap="none" lIns="90000" rIns="90000" tIns="15120" bIns="15120" anchor="ctr">
                        <a:noAutofit/>
                      </a:bodyPr>
                      <a:p>
                        <a:pPr>
                          <a:lnSpc>
                            <a:spcPct val="100000"/>
                          </a:lnSpc>
                          <a:tabLst>
                            <a:tab algn="l" pos="0"/>
                            <a:tab algn="l" pos="457200"/>
                            <a:tab algn="l" pos="914400"/>
                            <a:tab algn="l" pos="1371600"/>
                            <a:tab algn="l" pos="1828800"/>
                            <a:tab algn="l" pos="2286000"/>
                            <a:tab algn="l" pos="2743200"/>
                            <a:tab algn="l" pos="3200400"/>
                            <a:tab algn="l" pos="3657600"/>
                            <a:tab algn="l" pos="4114800"/>
                            <a:tab algn="l" pos="4572000"/>
                            <a:tab algn="l" pos="5029200"/>
                            <a:tab algn="l" pos="5486400"/>
                            <a:tab algn="l" pos="5943600"/>
                            <a:tab algn="l" pos="6400800"/>
                            <a:tab algn="l" pos="6858000"/>
                            <a:tab algn="l" pos="7315200"/>
                            <a:tab algn="l" pos="7772400"/>
                            <a:tab algn="l" pos="8229600"/>
                            <a:tab algn="l" pos="8686800"/>
                            <a:tab algn="l" pos="9144000"/>
                          </a:tabLst>
                        </a:pPr>
                        <a:endParaRPr b="0" lang="en-US" sz="2400" spc="-1" strike="noStrike">
                          <a:solidFill>
                            <a:srgbClr val="000000"/>
                          </a:solidFill>
                          <a:latin typeface="Arial"/>
                        </a:endParaRPr>
                      </a:p>
                    </p:txBody>
                  </p:sp>
                  <p:sp>
                    <p:nvSpPr>
                      <p:cNvPr id="55" name="Line 8"/>
                      <p:cNvSpPr/>
                      <p:nvPr/>
                    </p:nvSpPr>
                    <p:spPr>
                      <a:xfrm>
                        <a:off x="1477080" y="2576520"/>
                        <a:ext cx="264960" cy="0"/>
                      </a:xfrm>
                      <a:prstGeom prst="line">
                        <a:avLst/>
                      </a:prstGeom>
                      <a:ln w="12600">
                        <a:solidFill>
                          <a:srgbClr val="000000"/>
                        </a:solidFill>
                        <a:miter/>
                      </a:ln>
                    </p:spPr>
                    <p:style>
                      <a:lnRef idx="0"/>
                      <a:fillRef idx="0"/>
                      <a:effectRef idx="0"/>
                      <a:fontRef idx="minor"/>
                    </p:style>
                    <p:txBody>
                      <a:bodyPr lIns="90000" rIns="90000" tIns="-46800" bIns="-46800" anchor="ctr">
                        <a:noAutofit/>
                      </a:bodyPr>
                      <a:p>
                        <a:endParaRPr b="0" lang="en-US" sz="2400" spc="-1" strike="noStrike">
                          <a:solidFill>
                            <a:srgbClr val="000000"/>
                          </a:solidFill>
                          <a:latin typeface="Arial"/>
                        </a:endParaRPr>
                      </a:p>
                    </p:txBody>
                  </p:sp>
                </p:grpSp>
                <p:grpSp>
                  <p:nvGrpSpPr>
                    <p:cNvPr id="56" name="Group 21"/>
                    <p:cNvGrpSpPr/>
                    <p:nvPr/>
                  </p:nvGrpSpPr>
                  <p:grpSpPr>
                    <a:xfrm>
                      <a:off x="1468800" y="2331000"/>
                      <a:ext cx="264960" cy="87120"/>
                      <a:chOff x="1468800" y="2331000"/>
                      <a:chExt cx="264960" cy="87120"/>
                    </a:xfrm>
                  </p:grpSpPr>
                  <p:sp>
                    <p:nvSpPr>
                      <p:cNvPr id="57" name="Line 10"/>
                      <p:cNvSpPr/>
                      <p:nvPr/>
                    </p:nvSpPr>
                    <p:spPr>
                      <a:xfrm>
                        <a:off x="1468800" y="2374560"/>
                        <a:ext cx="264960" cy="0"/>
                      </a:xfrm>
                      <a:prstGeom prst="line">
                        <a:avLst/>
                      </a:prstGeom>
                      <a:ln w="12600">
                        <a:solidFill>
                          <a:srgbClr val="000000"/>
                        </a:solidFill>
                        <a:prstDash val="dash"/>
                        <a:miter/>
                      </a:ln>
                    </p:spPr>
                    <p:style>
                      <a:lnRef idx="0"/>
                      <a:fillRef idx="0"/>
                      <a:effectRef idx="0"/>
                      <a:fontRef idx="minor"/>
                    </p:style>
                    <p:txBody>
                      <a:bodyPr lIns="90000" rIns="90000" tIns="-46800" bIns="-46800" anchor="ctr">
                        <a:noAutofit/>
                      </a:bodyPr>
                      <a:p>
                        <a:endParaRPr b="0" lang="en-US" sz="2400" spc="-1" strike="noStrike">
                          <a:solidFill>
                            <a:srgbClr val="000000"/>
                          </a:solidFill>
                          <a:latin typeface="Arial"/>
                        </a:endParaRPr>
                      </a:p>
                    </p:txBody>
                  </p:sp>
                  <p:sp>
                    <p:nvSpPr>
                      <p:cNvPr id="58" name="Oval 6"/>
                      <p:cNvSpPr/>
                      <p:nvPr/>
                    </p:nvSpPr>
                    <p:spPr>
                      <a:xfrm>
                        <a:off x="1560960" y="2331000"/>
                        <a:ext cx="80640" cy="87120"/>
                      </a:xfrm>
                      <a:prstGeom prst="ellipse">
                        <a:avLst/>
                      </a:prstGeom>
                      <a:solidFill>
                        <a:srgbClr val="ffffff"/>
                      </a:solidFill>
                      <a:ln w="12600">
                        <a:solidFill>
                          <a:srgbClr val="000000"/>
                        </a:solidFill>
                        <a:miter/>
                      </a:ln>
                    </p:spPr>
                    <p:style>
                      <a:lnRef idx="0"/>
                      <a:fillRef idx="0"/>
                      <a:effectRef idx="0"/>
                      <a:fontRef idx="minor"/>
                    </p:style>
                    <p:txBody>
                      <a:bodyPr wrap="none" lIns="90000" rIns="90000" tIns="15120" bIns="15120" anchor="ctr">
                        <a:noAutofit/>
                      </a:bodyPr>
                      <a:p>
                        <a:pPr>
                          <a:lnSpc>
                            <a:spcPct val="100000"/>
                          </a:lnSpc>
                          <a:tabLst>
                            <a:tab algn="l" pos="0"/>
                            <a:tab algn="l" pos="457200"/>
                            <a:tab algn="l" pos="914400"/>
                            <a:tab algn="l" pos="1371600"/>
                            <a:tab algn="l" pos="1828800"/>
                            <a:tab algn="l" pos="2286000"/>
                            <a:tab algn="l" pos="2743200"/>
                            <a:tab algn="l" pos="3200400"/>
                            <a:tab algn="l" pos="3657600"/>
                            <a:tab algn="l" pos="4114800"/>
                            <a:tab algn="l" pos="4572000"/>
                            <a:tab algn="l" pos="5029200"/>
                            <a:tab algn="l" pos="5486400"/>
                            <a:tab algn="l" pos="5943600"/>
                            <a:tab algn="l" pos="6400800"/>
                            <a:tab algn="l" pos="6858000"/>
                            <a:tab algn="l" pos="7315200"/>
                            <a:tab algn="l" pos="7772400"/>
                            <a:tab algn="l" pos="8229600"/>
                            <a:tab algn="l" pos="8686800"/>
                            <a:tab algn="l" pos="9144000"/>
                          </a:tabLst>
                        </a:pPr>
                        <a:endParaRPr b="0" lang="en-US" sz="2400" spc="-1" strike="noStrike">
                          <a:solidFill>
                            <a:srgbClr val="000000"/>
                          </a:solidFill>
                          <a:latin typeface="Arial"/>
                        </a:endParaRPr>
                      </a:p>
                    </p:txBody>
                  </p:sp>
                </p:grpSp>
                <p:sp>
                  <p:nvSpPr>
                    <p:cNvPr id="59" name="Text Box 4"/>
                    <p:cNvSpPr/>
                    <p:nvPr/>
                  </p:nvSpPr>
                  <p:spPr>
                    <a:xfrm>
                      <a:off x="1771920" y="2196360"/>
                      <a:ext cx="1742400" cy="48924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spAutoFit/>
                    </a:bodyPr>
                    <a:p>
                      <a:pPr>
                        <a:lnSpc>
                          <a:spcPct val="13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BHK-2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3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BHK- WNV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</p:grpSp>
            </p:grpSp>
            <p:sp>
              <p:nvSpPr>
                <p:cNvPr id="60" name="TextBox 483"/>
                <p:cNvSpPr/>
                <p:nvPr/>
              </p:nvSpPr>
              <p:spPr>
                <a:xfrm>
                  <a:off x="343080" y="415440"/>
                  <a:ext cx="444240" cy="3988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1" lang="en-US" sz="2000" spc="-1" strike="noStrike">
                      <a:solidFill>
                        <a:srgbClr val="000000"/>
                      </a:solidFill>
                      <a:latin typeface="Arial"/>
                    </a:rPr>
                    <a:t>A</a:t>
                  </a:r>
                  <a:endParaRPr b="0" lang="en-US" sz="2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grpSp>
              <p:nvGrpSpPr>
                <p:cNvPr id="61" name="Group 584"/>
                <p:cNvGrpSpPr/>
                <p:nvPr/>
              </p:nvGrpSpPr>
              <p:grpSpPr>
                <a:xfrm>
                  <a:off x="3621960" y="455400"/>
                  <a:ext cx="3050640" cy="1848960"/>
                  <a:chOff x="3621960" y="455400"/>
                  <a:chExt cx="3050640" cy="1848960"/>
                </a:xfrm>
              </p:grpSpPr>
              <p:pic>
                <p:nvPicPr>
                  <p:cNvPr id="62" name="Picture 19" descr="siRNA-SRBI"/>
                  <p:cNvPicPr/>
                  <p:nvPr/>
                </p:nvPicPr>
                <p:blipFill>
                  <a:blip r:embed="rId3"/>
                  <a:stretch/>
                </p:blipFill>
                <p:spPr>
                  <a:xfrm>
                    <a:off x="4318920" y="1297440"/>
                    <a:ext cx="1971720" cy="4968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  <p:sp>
                <p:nvSpPr>
                  <p:cNvPr id="63" name="Text Box 21"/>
                  <p:cNvSpPr/>
                  <p:nvPr/>
                </p:nvSpPr>
                <p:spPr>
                  <a:xfrm>
                    <a:off x="3746520" y="1436400"/>
                    <a:ext cx="561600" cy="26136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t">
                    <a:spAutoFit/>
                  </a:bodyPr>
                  <a:p>
                    <a:pPr algn="r">
                      <a:tabLst>
                        <a:tab algn="l" pos="0"/>
                        <a:tab algn="l" pos="457200"/>
                        <a:tab algn="l" pos="914400"/>
                        <a:tab algn="l" pos="1371600"/>
                        <a:tab algn="l" pos="1828800"/>
                        <a:tab algn="l" pos="2286000"/>
                        <a:tab algn="l" pos="2743200"/>
                        <a:tab algn="l" pos="3200400"/>
                        <a:tab algn="l" pos="3657600"/>
                        <a:tab algn="l" pos="4114800"/>
                        <a:tab algn="l" pos="4572000"/>
                        <a:tab algn="l" pos="5029200"/>
                        <a:tab algn="l" pos="5486400"/>
                        <a:tab algn="l" pos="5943600"/>
                        <a:tab algn="l" pos="6400800"/>
                        <a:tab algn="l" pos="6858000"/>
                        <a:tab algn="l" pos="7315200"/>
                        <a:tab algn="l" pos="7772400"/>
                        <a:tab algn="l" pos="8229600"/>
                        <a:tab algn="l" pos="8686800"/>
                        <a:tab algn="l" pos="9144000"/>
                      </a:tabLst>
                    </a:pPr>
                    <a:r>
                      <a:rPr b="1" lang="en-US" sz="1100" spc="-1" strike="noStrike">
                        <a:solidFill>
                          <a:srgbClr val="000000"/>
                        </a:solidFill>
                        <a:latin typeface="Arial"/>
                      </a:rPr>
                      <a:t>SR-BI</a:t>
                    </a:r>
                    <a:endParaRPr b="0" lang="en-US" sz="11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4" name="Text Box 22"/>
                  <p:cNvSpPr/>
                  <p:nvPr/>
                </p:nvSpPr>
                <p:spPr>
                  <a:xfrm>
                    <a:off x="3621960" y="1909440"/>
                    <a:ext cx="685080" cy="26136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t">
                    <a:spAutoFit/>
                  </a:bodyPr>
                  <a:p>
                    <a:pPr algn="r">
                      <a:tabLst>
                        <a:tab algn="l" pos="0"/>
                        <a:tab algn="l" pos="457200"/>
                        <a:tab algn="l" pos="914400"/>
                        <a:tab algn="l" pos="1371600"/>
                        <a:tab algn="l" pos="1828800"/>
                        <a:tab algn="l" pos="2286000"/>
                        <a:tab algn="l" pos="2743200"/>
                        <a:tab algn="l" pos="3200400"/>
                        <a:tab algn="l" pos="3657600"/>
                        <a:tab algn="l" pos="4114800"/>
                        <a:tab algn="l" pos="4572000"/>
                        <a:tab algn="l" pos="5029200"/>
                        <a:tab algn="l" pos="5486400"/>
                        <a:tab algn="l" pos="5943600"/>
                        <a:tab algn="l" pos="6400800"/>
                        <a:tab algn="l" pos="6858000"/>
                        <a:tab algn="l" pos="7315200"/>
                        <a:tab algn="l" pos="7772400"/>
                        <a:tab algn="l" pos="8229600"/>
                        <a:tab algn="l" pos="8686800"/>
                        <a:tab algn="l" pos="9144000"/>
                      </a:tabLst>
                    </a:pPr>
                    <a:r>
                      <a:rPr b="1" lang="en-US" sz="1100" spc="-1" strike="noStrike">
                        <a:solidFill>
                          <a:srgbClr val="000000"/>
                        </a:solidFill>
                        <a:latin typeface="Arial"/>
                      </a:rPr>
                      <a:t>GAPDH</a:t>
                    </a:r>
                    <a:endParaRPr b="0" lang="en-US" sz="11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5" name="Text Box 23"/>
                  <p:cNvSpPr/>
                  <p:nvPr/>
                </p:nvSpPr>
                <p:spPr>
                  <a:xfrm>
                    <a:off x="3722760" y="910800"/>
                    <a:ext cx="646920" cy="26136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t">
                    <a:spAutoFit/>
                  </a:bodyPr>
                  <a:p>
                    <a:pPr>
                      <a:tabLst>
                        <a:tab algn="l" pos="0"/>
                        <a:tab algn="l" pos="457200"/>
                        <a:tab algn="l" pos="914400"/>
                        <a:tab algn="l" pos="1371600"/>
                        <a:tab algn="l" pos="1828800"/>
                        <a:tab algn="l" pos="2286000"/>
                        <a:tab algn="l" pos="2743200"/>
                        <a:tab algn="l" pos="3200400"/>
                        <a:tab algn="l" pos="3657600"/>
                        <a:tab algn="l" pos="4114800"/>
                        <a:tab algn="l" pos="4572000"/>
                        <a:tab algn="l" pos="5029200"/>
                        <a:tab algn="l" pos="5486400"/>
                        <a:tab algn="l" pos="5943600"/>
                        <a:tab algn="l" pos="6400800"/>
                        <a:tab algn="l" pos="6858000"/>
                        <a:tab algn="l" pos="7315200"/>
                        <a:tab algn="l" pos="7772400"/>
                        <a:tab algn="l" pos="8229600"/>
                        <a:tab algn="l" pos="8686800"/>
                        <a:tab algn="l" pos="9144000"/>
                      </a:tabLst>
                    </a:pPr>
                    <a:r>
                      <a:rPr b="1" lang="en-US" sz="1100" spc="-1" strike="noStrike">
                        <a:solidFill>
                          <a:srgbClr val="000000"/>
                        </a:solidFill>
                        <a:latin typeface="Arial"/>
                      </a:rPr>
                      <a:t>siRNA:</a:t>
                    </a:r>
                    <a:endParaRPr b="0" lang="en-US" sz="11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6" name="Text Box 24"/>
                  <p:cNvSpPr/>
                  <p:nvPr/>
                </p:nvSpPr>
                <p:spPr>
                  <a:xfrm rot="18805200">
                    <a:off x="4268160" y="792360"/>
                    <a:ext cx="874080" cy="26136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t">
                    <a:spAutoFit/>
                  </a:bodyPr>
                  <a:p>
                    <a:pPr>
                      <a:tabLst>
                        <a:tab algn="l" pos="0"/>
                        <a:tab algn="l" pos="457200"/>
                        <a:tab algn="l" pos="914400"/>
                        <a:tab algn="l" pos="1371600"/>
                        <a:tab algn="l" pos="1828800"/>
                        <a:tab algn="l" pos="2286000"/>
                        <a:tab algn="l" pos="2743200"/>
                        <a:tab algn="l" pos="3200400"/>
                        <a:tab algn="l" pos="3657600"/>
                        <a:tab algn="l" pos="4114800"/>
                        <a:tab algn="l" pos="4572000"/>
                        <a:tab algn="l" pos="5029200"/>
                        <a:tab algn="l" pos="5486400"/>
                        <a:tab algn="l" pos="5943600"/>
                        <a:tab algn="l" pos="6400800"/>
                        <a:tab algn="l" pos="6858000"/>
                        <a:tab algn="l" pos="7315200"/>
                        <a:tab algn="l" pos="7772400"/>
                        <a:tab algn="l" pos="8229600"/>
                        <a:tab algn="l" pos="8686800"/>
                        <a:tab algn="l" pos="9144000"/>
                      </a:tabLst>
                    </a:pPr>
                    <a:r>
                      <a:rPr b="1" lang="en-US" sz="1100" spc="-1" strike="noStrike">
                        <a:solidFill>
                          <a:srgbClr val="000000"/>
                        </a:solidFill>
                        <a:latin typeface="Arial"/>
                      </a:rPr>
                      <a:t>w/o siRNA</a:t>
                    </a:r>
                    <a:endParaRPr b="0" lang="en-US" sz="11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7" name="Text Box 25"/>
                  <p:cNvSpPr/>
                  <p:nvPr/>
                </p:nvSpPr>
                <p:spPr>
                  <a:xfrm rot="18805200">
                    <a:off x="4664880" y="908280"/>
                    <a:ext cx="537480" cy="26136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t">
                    <a:spAutoFit/>
                  </a:bodyPr>
                  <a:p>
                    <a:pPr>
                      <a:tabLst>
                        <a:tab algn="l" pos="0"/>
                        <a:tab algn="l" pos="457200"/>
                        <a:tab algn="l" pos="914400"/>
                        <a:tab algn="l" pos="1371600"/>
                        <a:tab algn="l" pos="1828800"/>
                        <a:tab algn="l" pos="2286000"/>
                        <a:tab algn="l" pos="2743200"/>
                        <a:tab algn="l" pos="3200400"/>
                        <a:tab algn="l" pos="3657600"/>
                        <a:tab algn="l" pos="4114800"/>
                        <a:tab algn="l" pos="4572000"/>
                        <a:tab algn="l" pos="5029200"/>
                        <a:tab algn="l" pos="5486400"/>
                        <a:tab algn="l" pos="5943600"/>
                        <a:tab algn="l" pos="6400800"/>
                        <a:tab algn="l" pos="6858000"/>
                        <a:tab algn="l" pos="7315200"/>
                        <a:tab algn="l" pos="7772400"/>
                        <a:tab algn="l" pos="8229600"/>
                        <a:tab algn="l" pos="8686800"/>
                        <a:tab algn="l" pos="9144000"/>
                      </a:tabLst>
                    </a:pPr>
                    <a:r>
                      <a:rPr b="1" lang="en-US" sz="1100" spc="-1" strike="noStrike">
                        <a:solidFill>
                          <a:srgbClr val="000000"/>
                        </a:solidFill>
                        <a:latin typeface="Arial"/>
                      </a:rPr>
                      <a:t>CD81</a:t>
                    </a:r>
                    <a:endParaRPr b="0" lang="en-US" sz="11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8" name="Text Box 26"/>
                  <p:cNvSpPr/>
                  <p:nvPr/>
                </p:nvSpPr>
                <p:spPr>
                  <a:xfrm rot="18805200">
                    <a:off x="4932720" y="927360"/>
                    <a:ext cx="561600" cy="26136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t">
                    <a:spAutoFit/>
                  </a:bodyPr>
                  <a:p>
                    <a:pPr>
                      <a:tabLst>
                        <a:tab algn="l" pos="0"/>
                        <a:tab algn="l" pos="457200"/>
                        <a:tab algn="l" pos="914400"/>
                        <a:tab algn="l" pos="1371600"/>
                        <a:tab algn="l" pos="1828800"/>
                        <a:tab algn="l" pos="2286000"/>
                        <a:tab algn="l" pos="2743200"/>
                        <a:tab algn="l" pos="3200400"/>
                        <a:tab algn="l" pos="3657600"/>
                        <a:tab algn="l" pos="4114800"/>
                        <a:tab algn="l" pos="4572000"/>
                        <a:tab algn="l" pos="5029200"/>
                        <a:tab algn="l" pos="5486400"/>
                        <a:tab algn="l" pos="5943600"/>
                        <a:tab algn="l" pos="6400800"/>
                        <a:tab algn="l" pos="6858000"/>
                        <a:tab algn="l" pos="7315200"/>
                        <a:tab algn="l" pos="7772400"/>
                        <a:tab algn="l" pos="8229600"/>
                        <a:tab algn="l" pos="8686800"/>
                        <a:tab algn="l" pos="9144000"/>
                      </a:tabLst>
                    </a:pPr>
                    <a:r>
                      <a:rPr b="1" lang="en-US" sz="1100" spc="-1" strike="noStrike">
                        <a:solidFill>
                          <a:srgbClr val="000000"/>
                        </a:solidFill>
                        <a:latin typeface="Arial"/>
                      </a:rPr>
                      <a:t>SR-BI</a:t>
                    </a:r>
                    <a:endParaRPr b="0" lang="en-US" sz="11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9" name="Text Box 27"/>
                  <p:cNvSpPr/>
                  <p:nvPr/>
                </p:nvSpPr>
                <p:spPr>
                  <a:xfrm rot="18805200">
                    <a:off x="5164200" y="770400"/>
                    <a:ext cx="981000" cy="26136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t">
                    <a:spAutoFit/>
                  </a:bodyPr>
                  <a:p>
                    <a:pPr>
                      <a:tabLst>
                        <a:tab algn="l" pos="0"/>
                        <a:tab algn="l" pos="457200"/>
                        <a:tab algn="l" pos="914400"/>
                        <a:tab algn="l" pos="1371600"/>
                        <a:tab algn="l" pos="1828800"/>
                        <a:tab algn="l" pos="2286000"/>
                        <a:tab algn="l" pos="2743200"/>
                        <a:tab algn="l" pos="3200400"/>
                        <a:tab algn="l" pos="3657600"/>
                        <a:tab algn="l" pos="4114800"/>
                        <a:tab algn="l" pos="4572000"/>
                        <a:tab algn="l" pos="5029200"/>
                        <a:tab algn="l" pos="5486400"/>
                        <a:tab algn="l" pos="5943600"/>
                        <a:tab algn="l" pos="6400800"/>
                        <a:tab algn="l" pos="6858000"/>
                        <a:tab algn="l" pos="7315200"/>
                        <a:tab algn="l" pos="7772400"/>
                        <a:tab algn="l" pos="8229600"/>
                        <a:tab algn="l" pos="8686800"/>
                        <a:tab algn="l" pos="9144000"/>
                      </a:tabLst>
                    </a:pPr>
                    <a:r>
                      <a:rPr b="1" lang="en-US" sz="1100" spc="-1" strike="noStrike">
                        <a:solidFill>
                          <a:srgbClr val="000000"/>
                        </a:solidFill>
                        <a:latin typeface="Arial"/>
                      </a:rPr>
                      <a:t>ASGP-R1&amp;2</a:t>
                    </a:r>
                    <a:endParaRPr b="0" lang="en-US" sz="11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70" name="Text Box 28"/>
                  <p:cNvSpPr/>
                  <p:nvPr/>
                </p:nvSpPr>
                <p:spPr>
                  <a:xfrm rot="18805200">
                    <a:off x="5534280" y="801360"/>
                    <a:ext cx="819360" cy="26136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t">
                    <a:spAutoFit/>
                  </a:bodyPr>
                  <a:p>
                    <a:pPr>
                      <a:tabLst>
                        <a:tab algn="l" pos="0"/>
                        <a:tab algn="l" pos="457200"/>
                        <a:tab algn="l" pos="914400"/>
                        <a:tab algn="l" pos="1371600"/>
                        <a:tab algn="l" pos="1828800"/>
                        <a:tab algn="l" pos="2286000"/>
                        <a:tab algn="l" pos="2743200"/>
                        <a:tab algn="l" pos="3200400"/>
                        <a:tab algn="l" pos="3657600"/>
                        <a:tab algn="l" pos="4114800"/>
                        <a:tab algn="l" pos="4572000"/>
                        <a:tab algn="l" pos="5029200"/>
                        <a:tab algn="l" pos="5486400"/>
                        <a:tab algn="l" pos="5943600"/>
                        <a:tab algn="l" pos="6400800"/>
                        <a:tab algn="l" pos="6858000"/>
                        <a:tab algn="l" pos="7315200"/>
                        <a:tab algn="l" pos="7772400"/>
                        <a:tab algn="l" pos="8229600"/>
                        <a:tab algn="l" pos="8686800"/>
                        <a:tab algn="l" pos="9144000"/>
                      </a:tabLst>
                    </a:pPr>
                    <a:r>
                      <a:rPr b="1" lang="en-US" sz="1100" spc="-1" strike="noStrike">
                        <a:solidFill>
                          <a:srgbClr val="000000"/>
                        </a:solidFill>
                        <a:latin typeface="Arial"/>
                      </a:rPr>
                      <a:t>Claudin-1</a:t>
                    </a:r>
                    <a:endParaRPr b="0" lang="en-US" sz="11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71" name="Text Box 29"/>
                  <p:cNvSpPr/>
                  <p:nvPr/>
                </p:nvSpPr>
                <p:spPr>
                  <a:xfrm rot="18805200">
                    <a:off x="5840280" y="776160"/>
                    <a:ext cx="874080" cy="26136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t">
                    <a:spAutoFit/>
                  </a:bodyPr>
                  <a:p>
                    <a:pPr>
                      <a:tabLst>
                        <a:tab algn="l" pos="0"/>
                        <a:tab algn="l" pos="457200"/>
                        <a:tab algn="l" pos="914400"/>
                        <a:tab algn="l" pos="1371600"/>
                        <a:tab algn="l" pos="1828800"/>
                        <a:tab algn="l" pos="2286000"/>
                        <a:tab algn="l" pos="2743200"/>
                        <a:tab algn="l" pos="3200400"/>
                        <a:tab algn="l" pos="3657600"/>
                        <a:tab algn="l" pos="4114800"/>
                        <a:tab algn="l" pos="4572000"/>
                        <a:tab algn="l" pos="5029200"/>
                        <a:tab algn="l" pos="5486400"/>
                        <a:tab algn="l" pos="5943600"/>
                        <a:tab algn="l" pos="6400800"/>
                        <a:tab algn="l" pos="6858000"/>
                        <a:tab algn="l" pos="7315200"/>
                        <a:tab algn="l" pos="7772400"/>
                        <a:tab algn="l" pos="8229600"/>
                        <a:tab algn="l" pos="8686800"/>
                        <a:tab algn="l" pos="9144000"/>
                      </a:tabLst>
                    </a:pPr>
                    <a:r>
                      <a:rPr b="1" lang="en-US" sz="1100" spc="-1" strike="noStrike">
                        <a:solidFill>
                          <a:srgbClr val="000000"/>
                        </a:solidFill>
                        <a:latin typeface="Arial"/>
                      </a:rPr>
                      <a:t>non-target</a:t>
                    </a:r>
                    <a:endParaRPr b="0" lang="en-US" sz="11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pic>
                <p:nvPicPr>
                  <p:cNvPr id="72" name="Picture 296" descr="gapdh-crop"/>
                  <p:cNvPicPr/>
                  <p:nvPr/>
                </p:nvPicPr>
                <p:blipFill>
                  <a:blip r:embed="rId4"/>
                  <a:stretch/>
                </p:blipFill>
                <p:spPr>
                  <a:xfrm>
                    <a:off x="4307400" y="1860480"/>
                    <a:ext cx="1983240" cy="44388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grpSp>
            <p:grpSp>
              <p:nvGrpSpPr>
                <p:cNvPr id="73" name="Group 287"/>
                <p:cNvGrpSpPr/>
                <p:nvPr/>
              </p:nvGrpSpPr>
              <p:grpSpPr>
                <a:xfrm>
                  <a:off x="6662880" y="563040"/>
                  <a:ext cx="2006640" cy="1911600"/>
                  <a:chOff x="6662880" y="563040"/>
                  <a:chExt cx="2006640" cy="1911600"/>
                </a:xfrm>
              </p:grpSpPr>
              <p:sp>
                <p:nvSpPr>
                  <p:cNvPr id="74" name="Rectangle 122"/>
                  <p:cNvSpPr/>
                  <p:nvPr/>
                </p:nvSpPr>
                <p:spPr>
                  <a:xfrm>
                    <a:off x="6848280" y="2198160"/>
                    <a:ext cx="639720" cy="27648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t">
                    <a:spAutoFit/>
                  </a:bodyPr>
                  <a:p>
                    <a:pPr>
                      <a:tabLst>
                        <a:tab algn="l" pos="0"/>
                        <a:tab algn="l" pos="457200"/>
                        <a:tab algn="l" pos="914400"/>
                        <a:tab algn="l" pos="1371600"/>
                        <a:tab algn="l" pos="1828800"/>
                        <a:tab algn="l" pos="2286000"/>
                        <a:tab algn="l" pos="2743200"/>
                        <a:tab algn="l" pos="3200400"/>
                        <a:tab algn="l" pos="3657600"/>
                        <a:tab algn="l" pos="4114800"/>
                        <a:tab algn="l" pos="4572000"/>
                        <a:tab algn="l" pos="5029200"/>
                        <a:tab algn="l" pos="5486400"/>
                        <a:tab algn="l" pos="5943600"/>
                        <a:tab algn="l" pos="6400800"/>
                        <a:tab algn="l" pos="6858000"/>
                        <a:tab algn="l" pos="7315200"/>
                        <a:tab algn="l" pos="7772400"/>
                        <a:tab algn="l" pos="8229600"/>
                        <a:tab algn="l" pos="8686800"/>
                        <a:tab algn="l" pos="9144000"/>
                      </a:tabLst>
                    </a:pPr>
                    <a:r>
                      <a:rPr b="1" lang="en-US" sz="1200" spc="-1" strike="noStrike">
                        <a:solidFill>
                          <a:srgbClr val="000000"/>
                        </a:solidFill>
                        <a:latin typeface="Arial"/>
                      </a:rPr>
                      <a:t>si</a:t>
                    </a:r>
                    <a:r>
                      <a:rPr b="1" i="1" lang="en-US" sz="1200" spc="-1" strike="noStrike">
                        <a:solidFill>
                          <a:srgbClr val="000000"/>
                        </a:solidFill>
                        <a:latin typeface="Arial"/>
                      </a:rPr>
                      <a:t>GLO</a:t>
                    </a:r>
                    <a:endParaRPr b="0" lang="en-US" sz="12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grpSp>
                <p:nvGrpSpPr>
                  <p:cNvPr id="75" name="Group 116"/>
                  <p:cNvGrpSpPr/>
                  <p:nvPr/>
                </p:nvGrpSpPr>
                <p:grpSpPr>
                  <a:xfrm>
                    <a:off x="6662880" y="563040"/>
                    <a:ext cx="2006640" cy="1667160"/>
                    <a:chOff x="6662880" y="563040"/>
                    <a:chExt cx="2006640" cy="1667160"/>
                  </a:xfrm>
                </p:grpSpPr>
                <p:sp>
                  <p:nvSpPr>
                    <p:cNvPr id="76" name="Rectangle 36"/>
                    <p:cNvSpPr/>
                    <p:nvPr/>
                  </p:nvSpPr>
                  <p:spPr>
                    <a:xfrm>
                      <a:off x="7125120" y="585000"/>
                      <a:ext cx="1417680" cy="1419480"/>
                    </a:xfrm>
                    <a:prstGeom prst="rect">
                      <a:avLst/>
                    </a:prstGeom>
                    <a:solidFill>
                      <a:srgbClr val="ffffff"/>
                    </a:solidFill>
                    <a:ln w="792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77" name="Line 37"/>
                    <p:cNvSpPr/>
                    <p:nvPr/>
                  </p:nvSpPr>
                  <p:spPr>
                    <a:xfrm>
                      <a:off x="7125120" y="1998720"/>
                      <a:ext cx="1411920" cy="1080"/>
                    </a:xfrm>
                    <a:prstGeom prst="line">
                      <a:avLst/>
                    </a:prstGeom>
                    <a:ln w="792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5720" bIns="-4572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grpSp>
                  <p:nvGrpSpPr>
                    <p:cNvPr id="78" name="Group 38"/>
                    <p:cNvGrpSpPr/>
                    <p:nvPr/>
                  </p:nvGrpSpPr>
                  <p:grpSpPr>
                    <a:xfrm>
                      <a:off x="7124400" y="2004480"/>
                      <a:ext cx="1413000" cy="31320"/>
                      <a:chOff x="7124400" y="2004480"/>
                      <a:chExt cx="1413000" cy="31320"/>
                    </a:xfrm>
                  </p:grpSpPr>
                  <p:sp>
                    <p:nvSpPr>
                      <p:cNvPr id="79" name="Line 39"/>
                      <p:cNvSpPr/>
                      <p:nvPr/>
                    </p:nvSpPr>
                    <p:spPr>
                      <a:xfrm>
                        <a:off x="7124400" y="2004480"/>
                        <a:ext cx="720" cy="31320"/>
                      </a:xfrm>
                      <a:prstGeom prst="line">
                        <a:avLst/>
                      </a:prstGeom>
                      <a:ln w="7920">
                        <a:solidFill>
                          <a:srgbClr val="000000"/>
                        </a:solidFill>
                        <a:miter/>
                      </a:ln>
                    </p:spPr>
                    <p:style>
                      <a:lnRef idx="0"/>
                      <a:fillRef idx="0"/>
                      <a:effectRef idx="0"/>
                      <a:fontRef idx="minor"/>
                    </p:style>
                    <p:txBody>
                      <a:bodyPr lIns="90000" rIns="90000" tIns="-15480" bIns="-15480" anchor="t">
                        <a:noAutofit/>
                      </a:bodyPr>
                      <a:p>
                        <a:endParaRPr b="0" lang="en-US" sz="2400" spc="-1" strike="noStrike">
                          <a:solidFill>
                            <a:srgbClr val="000000"/>
                          </a:solidFill>
                          <a:latin typeface="Arial"/>
                        </a:endParaRPr>
                      </a:p>
                    </p:txBody>
                  </p:sp>
                  <p:sp>
                    <p:nvSpPr>
                      <p:cNvPr id="80" name="Line 40"/>
                      <p:cNvSpPr/>
                      <p:nvPr/>
                    </p:nvSpPr>
                    <p:spPr>
                      <a:xfrm>
                        <a:off x="7228080" y="2004480"/>
                        <a:ext cx="720" cy="10080"/>
                      </a:xfrm>
                      <a:prstGeom prst="line">
                        <a:avLst/>
                      </a:prstGeom>
                      <a:ln w="7920">
                        <a:solidFill>
                          <a:srgbClr val="000000"/>
                        </a:solidFill>
                        <a:miter/>
                      </a:ln>
                    </p:spPr>
                    <p:style>
                      <a:lnRef idx="0"/>
                      <a:fillRef idx="0"/>
                      <a:effectRef idx="0"/>
                      <a:fontRef idx="minor"/>
                    </p:style>
                    <p:txBody>
                      <a:bodyPr lIns="90000" rIns="90000" tIns="-36720" bIns="-36720" anchor="t">
                        <a:noAutofit/>
                      </a:bodyPr>
                      <a:p>
                        <a:endParaRPr b="0" lang="en-US" sz="2400" spc="-1" strike="noStrike">
                          <a:solidFill>
                            <a:srgbClr val="000000"/>
                          </a:solidFill>
                          <a:latin typeface="Arial"/>
                        </a:endParaRPr>
                      </a:p>
                    </p:txBody>
                  </p:sp>
                  <p:sp>
                    <p:nvSpPr>
                      <p:cNvPr id="81" name="Line 41"/>
                      <p:cNvSpPr/>
                      <p:nvPr/>
                    </p:nvSpPr>
                    <p:spPr>
                      <a:xfrm>
                        <a:off x="7288560" y="2004480"/>
                        <a:ext cx="720" cy="10080"/>
                      </a:xfrm>
                      <a:prstGeom prst="line">
                        <a:avLst/>
                      </a:prstGeom>
                      <a:ln w="7920">
                        <a:solidFill>
                          <a:srgbClr val="000000"/>
                        </a:solidFill>
                        <a:miter/>
                      </a:ln>
                    </p:spPr>
                    <p:style>
                      <a:lnRef idx="0"/>
                      <a:fillRef idx="0"/>
                      <a:effectRef idx="0"/>
                      <a:fontRef idx="minor"/>
                    </p:style>
                    <p:txBody>
                      <a:bodyPr lIns="90000" rIns="90000" tIns="-36720" bIns="-36720" anchor="t">
                        <a:noAutofit/>
                      </a:bodyPr>
                      <a:p>
                        <a:endParaRPr b="0" lang="en-US" sz="2400" spc="-1" strike="noStrike">
                          <a:solidFill>
                            <a:srgbClr val="000000"/>
                          </a:solidFill>
                          <a:latin typeface="Arial"/>
                        </a:endParaRPr>
                      </a:p>
                    </p:txBody>
                  </p:sp>
                  <p:sp>
                    <p:nvSpPr>
                      <p:cNvPr id="82" name="Line 42"/>
                      <p:cNvSpPr/>
                      <p:nvPr/>
                    </p:nvSpPr>
                    <p:spPr>
                      <a:xfrm>
                        <a:off x="7333200" y="2004480"/>
                        <a:ext cx="720" cy="10080"/>
                      </a:xfrm>
                      <a:prstGeom prst="line">
                        <a:avLst/>
                      </a:prstGeom>
                      <a:ln w="7920">
                        <a:solidFill>
                          <a:srgbClr val="000000"/>
                        </a:solidFill>
                        <a:miter/>
                      </a:ln>
                    </p:spPr>
                    <p:style>
                      <a:lnRef idx="0"/>
                      <a:fillRef idx="0"/>
                      <a:effectRef idx="0"/>
                      <a:fontRef idx="minor"/>
                    </p:style>
                    <p:txBody>
                      <a:bodyPr lIns="90000" rIns="90000" tIns="-36720" bIns="-36720" anchor="t">
                        <a:noAutofit/>
                      </a:bodyPr>
                      <a:p>
                        <a:endParaRPr b="0" lang="en-US" sz="2400" spc="-1" strike="noStrike">
                          <a:solidFill>
                            <a:srgbClr val="000000"/>
                          </a:solidFill>
                          <a:latin typeface="Arial"/>
                        </a:endParaRPr>
                      </a:p>
                    </p:txBody>
                  </p:sp>
                  <p:sp>
                    <p:nvSpPr>
                      <p:cNvPr id="83" name="Line 43"/>
                      <p:cNvSpPr/>
                      <p:nvPr/>
                    </p:nvSpPr>
                    <p:spPr>
                      <a:xfrm>
                        <a:off x="7370640" y="2004480"/>
                        <a:ext cx="720" cy="21240"/>
                      </a:xfrm>
                      <a:prstGeom prst="line">
                        <a:avLst/>
                      </a:prstGeom>
                      <a:ln w="7920">
                        <a:solidFill>
                          <a:srgbClr val="000000"/>
                        </a:solidFill>
                        <a:miter/>
                      </a:ln>
                    </p:spPr>
                    <p:style>
                      <a:lnRef idx="0"/>
                      <a:fillRef idx="0"/>
                      <a:effectRef idx="0"/>
                      <a:fontRef idx="minor"/>
                    </p:style>
                    <p:txBody>
                      <a:bodyPr lIns="90000" rIns="90000" tIns="-25560" bIns="-25560" anchor="t">
                        <a:noAutofit/>
                      </a:bodyPr>
                      <a:p>
                        <a:endParaRPr b="0" lang="en-US" sz="2400" spc="-1" strike="noStrike">
                          <a:solidFill>
                            <a:srgbClr val="000000"/>
                          </a:solidFill>
                          <a:latin typeface="Arial"/>
                        </a:endParaRPr>
                      </a:p>
                    </p:txBody>
                  </p:sp>
                  <p:sp>
                    <p:nvSpPr>
                      <p:cNvPr id="84" name="Line 44"/>
                      <p:cNvSpPr/>
                      <p:nvPr/>
                    </p:nvSpPr>
                    <p:spPr>
                      <a:xfrm>
                        <a:off x="7398000" y="2004480"/>
                        <a:ext cx="720" cy="10080"/>
                      </a:xfrm>
                      <a:prstGeom prst="line">
                        <a:avLst/>
                      </a:prstGeom>
                      <a:ln w="7920">
                        <a:solidFill>
                          <a:srgbClr val="000000"/>
                        </a:solidFill>
                        <a:miter/>
                      </a:ln>
                    </p:spPr>
                    <p:style>
                      <a:lnRef idx="0"/>
                      <a:fillRef idx="0"/>
                      <a:effectRef idx="0"/>
                      <a:fontRef idx="minor"/>
                    </p:style>
                    <p:txBody>
                      <a:bodyPr lIns="90000" rIns="90000" tIns="-36720" bIns="-36720" anchor="t">
                        <a:noAutofit/>
                      </a:bodyPr>
                      <a:p>
                        <a:endParaRPr b="0" lang="en-US" sz="2400" spc="-1" strike="noStrike">
                          <a:solidFill>
                            <a:srgbClr val="000000"/>
                          </a:solidFill>
                          <a:latin typeface="Arial"/>
                        </a:endParaRPr>
                      </a:p>
                    </p:txBody>
                  </p:sp>
                  <p:sp>
                    <p:nvSpPr>
                      <p:cNvPr id="85" name="Line 45"/>
                      <p:cNvSpPr/>
                      <p:nvPr/>
                    </p:nvSpPr>
                    <p:spPr>
                      <a:xfrm>
                        <a:off x="7419960" y="2004480"/>
                        <a:ext cx="720" cy="10080"/>
                      </a:xfrm>
                      <a:prstGeom prst="line">
                        <a:avLst/>
                      </a:prstGeom>
                      <a:ln w="7920">
                        <a:solidFill>
                          <a:srgbClr val="000000"/>
                        </a:solidFill>
                        <a:miter/>
                      </a:ln>
                    </p:spPr>
                    <p:style>
                      <a:lnRef idx="0"/>
                      <a:fillRef idx="0"/>
                      <a:effectRef idx="0"/>
                      <a:fontRef idx="minor"/>
                    </p:style>
                    <p:txBody>
                      <a:bodyPr lIns="90000" rIns="90000" tIns="-36720" bIns="-36720" anchor="t">
                        <a:noAutofit/>
                      </a:bodyPr>
                      <a:p>
                        <a:endParaRPr b="0" lang="en-US" sz="2400" spc="-1" strike="noStrike">
                          <a:solidFill>
                            <a:srgbClr val="000000"/>
                          </a:solidFill>
                          <a:latin typeface="Arial"/>
                        </a:endParaRPr>
                      </a:p>
                    </p:txBody>
                  </p:sp>
                  <p:sp>
                    <p:nvSpPr>
                      <p:cNvPr id="86" name="Line 46"/>
                      <p:cNvSpPr/>
                      <p:nvPr/>
                    </p:nvSpPr>
                    <p:spPr>
                      <a:xfrm>
                        <a:off x="7441560" y="2004480"/>
                        <a:ext cx="1080" cy="10080"/>
                      </a:xfrm>
                      <a:prstGeom prst="line">
                        <a:avLst/>
                      </a:prstGeom>
                      <a:ln w="7920">
                        <a:solidFill>
                          <a:srgbClr val="000000"/>
                        </a:solidFill>
                        <a:miter/>
                      </a:ln>
                    </p:spPr>
                    <p:style>
                      <a:lnRef idx="0"/>
                      <a:fillRef idx="0"/>
                      <a:effectRef idx="0"/>
                      <a:fontRef idx="minor"/>
                    </p:style>
                    <p:txBody>
                      <a:bodyPr lIns="90000" rIns="90000" tIns="-36720" bIns="-36720" anchor="t">
                        <a:noAutofit/>
                      </a:bodyPr>
                      <a:p>
                        <a:endParaRPr b="0" lang="en-US" sz="2400" spc="-1" strike="noStrike">
                          <a:solidFill>
                            <a:srgbClr val="000000"/>
                          </a:solidFill>
                          <a:latin typeface="Arial"/>
                        </a:endParaRPr>
                      </a:p>
                    </p:txBody>
                  </p:sp>
                  <p:sp>
                    <p:nvSpPr>
                      <p:cNvPr id="87" name="Line 47"/>
                      <p:cNvSpPr/>
                      <p:nvPr/>
                    </p:nvSpPr>
                    <p:spPr>
                      <a:xfrm>
                        <a:off x="7458840" y="2004480"/>
                        <a:ext cx="720" cy="10080"/>
                      </a:xfrm>
                      <a:prstGeom prst="line">
                        <a:avLst/>
                      </a:prstGeom>
                      <a:ln w="7920">
                        <a:solidFill>
                          <a:srgbClr val="000000"/>
                        </a:solidFill>
                        <a:miter/>
                      </a:ln>
                    </p:spPr>
                    <p:style>
                      <a:lnRef idx="0"/>
                      <a:fillRef idx="0"/>
                      <a:effectRef idx="0"/>
                      <a:fontRef idx="minor"/>
                    </p:style>
                    <p:txBody>
                      <a:bodyPr lIns="90000" rIns="90000" tIns="-36720" bIns="-36720" anchor="t">
                        <a:noAutofit/>
                      </a:bodyPr>
                      <a:p>
                        <a:endParaRPr b="0" lang="en-US" sz="2400" spc="-1" strike="noStrike">
                          <a:solidFill>
                            <a:srgbClr val="000000"/>
                          </a:solidFill>
                          <a:latin typeface="Arial"/>
                        </a:endParaRPr>
                      </a:p>
                    </p:txBody>
                  </p:sp>
                  <p:sp>
                    <p:nvSpPr>
                      <p:cNvPr id="88" name="Line 48"/>
                      <p:cNvSpPr/>
                      <p:nvPr/>
                    </p:nvSpPr>
                    <p:spPr>
                      <a:xfrm>
                        <a:off x="7474680" y="2004480"/>
                        <a:ext cx="1080" cy="31320"/>
                      </a:xfrm>
                      <a:prstGeom prst="line">
                        <a:avLst/>
                      </a:prstGeom>
                      <a:ln w="7920">
                        <a:solidFill>
                          <a:srgbClr val="000000"/>
                        </a:solidFill>
                        <a:miter/>
                      </a:ln>
                    </p:spPr>
                    <p:style>
                      <a:lnRef idx="0"/>
                      <a:fillRef idx="0"/>
                      <a:effectRef idx="0"/>
                      <a:fontRef idx="minor"/>
                    </p:style>
                    <p:txBody>
                      <a:bodyPr lIns="90000" rIns="90000" tIns="-15480" bIns="-15480" anchor="t">
                        <a:noAutofit/>
                      </a:bodyPr>
                      <a:p>
                        <a:endParaRPr b="0" lang="en-US" sz="2400" spc="-1" strike="noStrike">
                          <a:solidFill>
                            <a:srgbClr val="000000"/>
                          </a:solidFill>
                          <a:latin typeface="Arial"/>
                        </a:endParaRPr>
                      </a:p>
                    </p:txBody>
                  </p:sp>
                  <p:sp>
                    <p:nvSpPr>
                      <p:cNvPr id="89" name="Line 49"/>
                      <p:cNvSpPr/>
                      <p:nvPr/>
                    </p:nvSpPr>
                    <p:spPr>
                      <a:xfrm>
                        <a:off x="7584480" y="2004480"/>
                        <a:ext cx="720" cy="10080"/>
                      </a:xfrm>
                      <a:prstGeom prst="line">
                        <a:avLst/>
                      </a:prstGeom>
                      <a:ln w="7920">
                        <a:solidFill>
                          <a:srgbClr val="000000"/>
                        </a:solidFill>
                        <a:miter/>
                      </a:ln>
                    </p:spPr>
                    <p:style>
                      <a:lnRef idx="0"/>
                      <a:fillRef idx="0"/>
                      <a:effectRef idx="0"/>
                      <a:fontRef idx="minor"/>
                    </p:style>
                    <p:txBody>
                      <a:bodyPr lIns="90000" rIns="90000" tIns="-36720" bIns="-36720" anchor="t">
                        <a:noAutofit/>
                      </a:bodyPr>
                      <a:p>
                        <a:endParaRPr b="0" lang="en-US" sz="2400" spc="-1" strike="noStrike">
                          <a:solidFill>
                            <a:srgbClr val="000000"/>
                          </a:solidFill>
                          <a:latin typeface="Arial"/>
                        </a:endParaRPr>
                      </a:p>
                    </p:txBody>
                  </p:sp>
                  <p:sp>
                    <p:nvSpPr>
                      <p:cNvPr id="90" name="Line 50"/>
                      <p:cNvSpPr/>
                      <p:nvPr/>
                    </p:nvSpPr>
                    <p:spPr>
                      <a:xfrm>
                        <a:off x="7644600" y="2004480"/>
                        <a:ext cx="1080" cy="10080"/>
                      </a:xfrm>
                      <a:prstGeom prst="line">
                        <a:avLst/>
                      </a:prstGeom>
                      <a:ln w="7920">
                        <a:solidFill>
                          <a:srgbClr val="000000"/>
                        </a:solidFill>
                        <a:miter/>
                      </a:ln>
                    </p:spPr>
                    <p:style>
                      <a:lnRef idx="0"/>
                      <a:fillRef idx="0"/>
                      <a:effectRef idx="0"/>
                      <a:fontRef idx="minor"/>
                    </p:style>
                    <p:txBody>
                      <a:bodyPr lIns="90000" rIns="90000" tIns="-36720" bIns="-36720" anchor="t">
                        <a:noAutofit/>
                      </a:bodyPr>
                      <a:p>
                        <a:endParaRPr b="0" lang="en-US" sz="2400" spc="-1" strike="noStrike">
                          <a:solidFill>
                            <a:srgbClr val="000000"/>
                          </a:solidFill>
                          <a:latin typeface="Arial"/>
                        </a:endParaRPr>
                      </a:p>
                    </p:txBody>
                  </p:sp>
                  <p:sp>
                    <p:nvSpPr>
                      <p:cNvPr id="91" name="Line 51"/>
                      <p:cNvSpPr/>
                      <p:nvPr/>
                    </p:nvSpPr>
                    <p:spPr>
                      <a:xfrm>
                        <a:off x="7688160" y="2004480"/>
                        <a:ext cx="720" cy="10080"/>
                      </a:xfrm>
                      <a:prstGeom prst="line">
                        <a:avLst/>
                      </a:prstGeom>
                      <a:ln w="7920">
                        <a:solidFill>
                          <a:srgbClr val="000000"/>
                        </a:solidFill>
                        <a:miter/>
                      </a:ln>
                    </p:spPr>
                    <p:style>
                      <a:lnRef idx="0"/>
                      <a:fillRef idx="0"/>
                      <a:effectRef idx="0"/>
                      <a:fontRef idx="minor"/>
                    </p:style>
                    <p:txBody>
                      <a:bodyPr lIns="90000" rIns="90000" tIns="-36720" bIns="-36720" anchor="t">
                        <a:noAutofit/>
                      </a:bodyPr>
                      <a:p>
                        <a:endParaRPr b="0" lang="en-US" sz="2400" spc="-1" strike="noStrike">
                          <a:solidFill>
                            <a:srgbClr val="000000"/>
                          </a:solidFill>
                          <a:latin typeface="Arial"/>
                        </a:endParaRPr>
                      </a:p>
                    </p:txBody>
                  </p:sp>
                  <p:sp>
                    <p:nvSpPr>
                      <p:cNvPr id="92" name="Line 52"/>
                      <p:cNvSpPr/>
                      <p:nvPr/>
                    </p:nvSpPr>
                    <p:spPr>
                      <a:xfrm>
                        <a:off x="7721280" y="2004480"/>
                        <a:ext cx="720" cy="21240"/>
                      </a:xfrm>
                      <a:prstGeom prst="line">
                        <a:avLst/>
                      </a:prstGeom>
                      <a:ln w="7920">
                        <a:solidFill>
                          <a:srgbClr val="000000"/>
                        </a:solidFill>
                        <a:miter/>
                      </a:ln>
                    </p:spPr>
                    <p:style>
                      <a:lnRef idx="0"/>
                      <a:fillRef idx="0"/>
                      <a:effectRef idx="0"/>
                      <a:fontRef idx="minor"/>
                    </p:style>
                    <p:txBody>
                      <a:bodyPr lIns="90000" rIns="90000" tIns="-25560" bIns="-25560" anchor="t">
                        <a:noAutofit/>
                      </a:bodyPr>
                      <a:p>
                        <a:endParaRPr b="0" lang="en-US" sz="2400" spc="-1" strike="noStrike">
                          <a:solidFill>
                            <a:srgbClr val="000000"/>
                          </a:solidFill>
                          <a:latin typeface="Arial"/>
                        </a:endParaRPr>
                      </a:p>
                    </p:txBody>
                  </p:sp>
                  <p:sp>
                    <p:nvSpPr>
                      <p:cNvPr id="93" name="Line 53"/>
                      <p:cNvSpPr/>
                      <p:nvPr/>
                    </p:nvSpPr>
                    <p:spPr>
                      <a:xfrm>
                        <a:off x="7754400" y="2004480"/>
                        <a:ext cx="720" cy="10080"/>
                      </a:xfrm>
                      <a:prstGeom prst="line">
                        <a:avLst/>
                      </a:prstGeom>
                      <a:ln w="7920">
                        <a:solidFill>
                          <a:srgbClr val="000000"/>
                        </a:solidFill>
                        <a:miter/>
                      </a:ln>
                    </p:spPr>
                    <p:style>
                      <a:lnRef idx="0"/>
                      <a:fillRef idx="0"/>
                      <a:effectRef idx="0"/>
                      <a:fontRef idx="minor"/>
                    </p:style>
                    <p:txBody>
                      <a:bodyPr lIns="90000" rIns="90000" tIns="-36720" bIns="-36720" anchor="t">
                        <a:noAutofit/>
                      </a:bodyPr>
                      <a:p>
                        <a:endParaRPr b="0" lang="en-US" sz="2400" spc="-1" strike="noStrike">
                          <a:solidFill>
                            <a:srgbClr val="000000"/>
                          </a:solidFill>
                          <a:latin typeface="Arial"/>
                        </a:endParaRPr>
                      </a:p>
                    </p:txBody>
                  </p:sp>
                  <p:sp>
                    <p:nvSpPr>
                      <p:cNvPr id="94" name="Line 54"/>
                      <p:cNvSpPr/>
                      <p:nvPr/>
                    </p:nvSpPr>
                    <p:spPr>
                      <a:xfrm>
                        <a:off x="7776000" y="2004480"/>
                        <a:ext cx="1080" cy="10080"/>
                      </a:xfrm>
                      <a:prstGeom prst="line">
                        <a:avLst/>
                      </a:prstGeom>
                      <a:ln w="7920">
                        <a:solidFill>
                          <a:srgbClr val="000000"/>
                        </a:solidFill>
                        <a:miter/>
                      </a:ln>
                    </p:spPr>
                    <p:style>
                      <a:lnRef idx="0"/>
                      <a:fillRef idx="0"/>
                      <a:effectRef idx="0"/>
                      <a:fontRef idx="minor"/>
                    </p:style>
                    <p:txBody>
                      <a:bodyPr lIns="90000" rIns="90000" tIns="-36720" bIns="-36720" anchor="t">
                        <a:noAutofit/>
                      </a:bodyPr>
                      <a:p>
                        <a:endParaRPr b="0" lang="en-US" sz="2400" spc="-1" strike="noStrike">
                          <a:solidFill>
                            <a:srgbClr val="000000"/>
                          </a:solidFill>
                          <a:latin typeface="Arial"/>
                        </a:endParaRPr>
                      </a:p>
                    </p:txBody>
                  </p:sp>
                  <p:sp>
                    <p:nvSpPr>
                      <p:cNvPr id="95" name="Line 55"/>
                      <p:cNvSpPr/>
                      <p:nvPr/>
                    </p:nvSpPr>
                    <p:spPr>
                      <a:xfrm>
                        <a:off x="7797600" y="2004480"/>
                        <a:ext cx="1080" cy="10080"/>
                      </a:xfrm>
                      <a:prstGeom prst="line">
                        <a:avLst/>
                      </a:prstGeom>
                      <a:ln w="7920">
                        <a:solidFill>
                          <a:srgbClr val="000000"/>
                        </a:solidFill>
                        <a:miter/>
                      </a:ln>
                    </p:spPr>
                    <p:style>
                      <a:lnRef idx="0"/>
                      <a:fillRef idx="0"/>
                      <a:effectRef idx="0"/>
                      <a:fontRef idx="minor"/>
                    </p:style>
                    <p:txBody>
                      <a:bodyPr lIns="90000" rIns="90000" tIns="-36720" bIns="-36720" anchor="t">
                        <a:noAutofit/>
                      </a:bodyPr>
                      <a:p>
                        <a:endParaRPr b="0" lang="en-US" sz="2400" spc="-1" strike="noStrike">
                          <a:solidFill>
                            <a:srgbClr val="000000"/>
                          </a:solidFill>
                          <a:latin typeface="Arial"/>
                        </a:endParaRPr>
                      </a:p>
                    </p:txBody>
                  </p:sp>
                  <p:sp>
                    <p:nvSpPr>
                      <p:cNvPr id="96" name="Line 56"/>
                      <p:cNvSpPr/>
                      <p:nvPr/>
                    </p:nvSpPr>
                    <p:spPr>
                      <a:xfrm>
                        <a:off x="7814880" y="2004480"/>
                        <a:ext cx="1080" cy="10080"/>
                      </a:xfrm>
                      <a:prstGeom prst="line">
                        <a:avLst/>
                      </a:prstGeom>
                      <a:ln w="7920">
                        <a:solidFill>
                          <a:srgbClr val="000000"/>
                        </a:solidFill>
                        <a:miter/>
                      </a:ln>
                    </p:spPr>
                    <p:style>
                      <a:lnRef idx="0"/>
                      <a:fillRef idx="0"/>
                      <a:effectRef idx="0"/>
                      <a:fontRef idx="minor"/>
                    </p:style>
                    <p:txBody>
                      <a:bodyPr lIns="90000" rIns="90000" tIns="-36720" bIns="-36720" anchor="t">
                        <a:noAutofit/>
                      </a:bodyPr>
                      <a:p>
                        <a:endParaRPr b="0" lang="en-US" sz="2400" spc="-1" strike="noStrike">
                          <a:solidFill>
                            <a:srgbClr val="000000"/>
                          </a:solidFill>
                          <a:latin typeface="Arial"/>
                        </a:endParaRPr>
                      </a:p>
                    </p:txBody>
                  </p:sp>
                  <p:sp>
                    <p:nvSpPr>
                      <p:cNvPr id="97" name="Line 57"/>
                      <p:cNvSpPr/>
                      <p:nvPr/>
                    </p:nvSpPr>
                    <p:spPr>
                      <a:xfrm>
                        <a:off x="7830720" y="2004480"/>
                        <a:ext cx="1080" cy="31320"/>
                      </a:xfrm>
                      <a:prstGeom prst="line">
                        <a:avLst/>
                      </a:prstGeom>
                      <a:ln w="7920">
                        <a:solidFill>
                          <a:srgbClr val="000000"/>
                        </a:solidFill>
                        <a:miter/>
                      </a:ln>
                    </p:spPr>
                    <p:style>
                      <a:lnRef idx="0"/>
                      <a:fillRef idx="0"/>
                      <a:effectRef idx="0"/>
                      <a:fontRef idx="minor"/>
                    </p:style>
                    <p:txBody>
                      <a:bodyPr lIns="90000" rIns="90000" tIns="-15480" bIns="-15480" anchor="t">
                        <a:noAutofit/>
                      </a:bodyPr>
                      <a:p>
                        <a:endParaRPr b="0" lang="en-US" sz="2400" spc="-1" strike="noStrike">
                          <a:solidFill>
                            <a:srgbClr val="000000"/>
                          </a:solidFill>
                          <a:latin typeface="Arial"/>
                        </a:endParaRPr>
                      </a:p>
                    </p:txBody>
                  </p:sp>
                  <p:sp>
                    <p:nvSpPr>
                      <p:cNvPr id="98" name="Line 58"/>
                      <p:cNvSpPr/>
                      <p:nvPr/>
                    </p:nvSpPr>
                    <p:spPr>
                      <a:xfrm>
                        <a:off x="7934760" y="2004480"/>
                        <a:ext cx="1080" cy="10080"/>
                      </a:xfrm>
                      <a:prstGeom prst="line">
                        <a:avLst/>
                      </a:prstGeom>
                      <a:ln w="7920">
                        <a:solidFill>
                          <a:srgbClr val="000000"/>
                        </a:solidFill>
                        <a:miter/>
                      </a:ln>
                    </p:spPr>
                    <p:style>
                      <a:lnRef idx="0"/>
                      <a:fillRef idx="0"/>
                      <a:effectRef idx="0"/>
                      <a:fontRef idx="minor"/>
                    </p:style>
                    <p:txBody>
                      <a:bodyPr lIns="90000" rIns="90000" tIns="-36720" bIns="-36720" anchor="t">
                        <a:noAutofit/>
                      </a:bodyPr>
                      <a:p>
                        <a:endParaRPr b="0" lang="en-US" sz="2400" spc="-1" strike="noStrike">
                          <a:solidFill>
                            <a:srgbClr val="000000"/>
                          </a:solidFill>
                          <a:latin typeface="Arial"/>
                        </a:endParaRPr>
                      </a:p>
                    </p:txBody>
                  </p:sp>
                  <p:sp>
                    <p:nvSpPr>
                      <p:cNvPr id="99" name="Line 59"/>
                      <p:cNvSpPr/>
                      <p:nvPr/>
                    </p:nvSpPr>
                    <p:spPr>
                      <a:xfrm>
                        <a:off x="8001000" y="2004480"/>
                        <a:ext cx="1080" cy="10080"/>
                      </a:xfrm>
                      <a:prstGeom prst="line">
                        <a:avLst/>
                      </a:prstGeom>
                      <a:ln w="7920">
                        <a:solidFill>
                          <a:srgbClr val="000000"/>
                        </a:solidFill>
                        <a:miter/>
                      </a:ln>
                    </p:spPr>
                    <p:style>
                      <a:lnRef idx="0"/>
                      <a:fillRef idx="0"/>
                      <a:effectRef idx="0"/>
                      <a:fontRef idx="minor"/>
                    </p:style>
                    <p:txBody>
                      <a:bodyPr lIns="90000" rIns="90000" tIns="-36720" bIns="-36720" anchor="t">
                        <a:noAutofit/>
                      </a:bodyPr>
                      <a:p>
                        <a:endParaRPr b="0" lang="en-US" sz="2400" spc="-1" strike="noStrike">
                          <a:solidFill>
                            <a:srgbClr val="000000"/>
                          </a:solidFill>
                          <a:latin typeface="Arial"/>
                        </a:endParaRPr>
                      </a:p>
                    </p:txBody>
                  </p:sp>
                  <p:sp>
                    <p:nvSpPr>
                      <p:cNvPr id="100" name="Line 60"/>
                      <p:cNvSpPr/>
                      <p:nvPr/>
                    </p:nvSpPr>
                    <p:spPr>
                      <a:xfrm>
                        <a:off x="8044560" y="2004480"/>
                        <a:ext cx="720" cy="10080"/>
                      </a:xfrm>
                      <a:prstGeom prst="line">
                        <a:avLst/>
                      </a:prstGeom>
                      <a:ln w="7920">
                        <a:solidFill>
                          <a:srgbClr val="000000"/>
                        </a:solidFill>
                        <a:miter/>
                      </a:ln>
                    </p:spPr>
                    <p:style>
                      <a:lnRef idx="0"/>
                      <a:fillRef idx="0"/>
                      <a:effectRef idx="0"/>
                      <a:fontRef idx="minor"/>
                    </p:style>
                    <p:txBody>
                      <a:bodyPr lIns="90000" rIns="90000" tIns="-36720" bIns="-36720" anchor="t">
                        <a:noAutofit/>
                      </a:bodyPr>
                      <a:p>
                        <a:endParaRPr b="0" lang="en-US" sz="2400" spc="-1" strike="noStrike">
                          <a:solidFill>
                            <a:srgbClr val="000000"/>
                          </a:solidFill>
                          <a:latin typeface="Arial"/>
                        </a:endParaRPr>
                      </a:p>
                    </p:txBody>
                  </p:sp>
                  <p:sp>
                    <p:nvSpPr>
                      <p:cNvPr id="101" name="Line 61"/>
                      <p:cNvSpPr/>
                      <p:nvPr/>
                    </p:nvSpPr>
                    <p:spPr>
                      <a:xfrm>
                        <a:off x="8077680" y="2004480"/>
                        <a:ext cx="720" cy="21240"/>
                      </a:xfrm>
                      <a:prstGeom prst="line">
                        <a:avLst/>
                      </a:prstGeom>
                      <a:ln w="7920">
                        <a:solidFill>
                          <a:srgbClr val="000000"/>
                        </a:solidFill>
                        <a:miter/>
                      </a:ln>
                    </p:spPr>
                    <p:style>
                      <a:lnRef idx="0"/>
                      <a:fillRef idx="0"/>
                      <a:effectRef idx="0"/>
                      <a:fontRef idx="minor"/>
                    </p:style>
                    <p:txBody>
                      <a:bodyPr lIns="90000" rIns="90000" tIns="-25560" bIns="-25560" anchor="t">
                        <a:noAutofit/>
                      </a:bodyPr>
                      <a:p>
                        <a:endParaRPr b="0" lang="en-US" sz="2400" spc="-1" strike="noStrike">
                          <a:solidFill>
                            <a:srgbClr val="000000"/>
                          </a:solidFill>
                          <a:latin typeface="Arial"/>
                        </a:endParaRPr>
                      </a:p>
                    </p:txBody>
                  </p:sp>
                  <p:sp>
                    <p:nvSpPr>
                      <p:cNvPr id="102" name="Line 62"/>
                      <p:cNvSpPr/>
                      <p:nvPr/>
                    </p:nvSpPr>
                    <p:spPr>
                      <a:xfrm>
                        <a:off x="8104680" y="2004480"/>
                        <a:ext cx="1080" cy="10080"/>
                      </a:xfrm>
                      <a:prstGeom prst="line">
                        <a:avLst/>
                      </a:prstGeom>
                      <a:ln w="7920">
                        <a:solidFill>
                          <a:srgbClr val="000000"/>
                        </a:solidFill>
                        <a:miter/>
                      </a:ln>
                    </p:spPr>
                    <p:style>
                      <a:lnRef idx="0"/>
                      <a:fillRef idx="0"/>
                      <a:effectRef idx="0"/>
                      <a:fontRef idx="minor"/>
                    </p:style>
                    <p:txBody>
                      <a:bodyPr lIns="90000" rIns="90000" tIns="-36720" bIns="-36720" anchor="t">
                        <a:noAutofit/>
                      </a:bodyPr>
                      <a:p>
                        <a:endParaRPr b="0" lang="en-US" sz="2400" spc="-1" strike="noStrike">
                          <a:solidFill>
                            <a:srgbClr val="000000"/>
                          </a:solidFill>
                          <a:latin typeface="Arial"/>
                        </a:endParaRPr>
                      </a:p>
                    </p:txBody>
                  </p:sp>
                  <p:sp>
                    <p:nvSpPr>
                      <p:cNvPr id="103" name="Line 63"/>
                      <p:cNvSpPr/>
                      <p:nvPr/>
                    </p:nvSpPr>
                    <p:spPr>
                      <a:xfrm>
                        <a:off x="8132040" y="2004480"/>
                        <a:ext cx="1080" cy="10080"/>
                      </a:xfrm>
                      <a:prstGeom prst="line">
                        <a:avLst/>
                      </a:prstGeom>
                      <a:ln w="7920">
                        <a:solidFill>
                          <a:srgbClr val="000000"/>
                        </a:solidFill>
                        <a:miter/>
                      </a:ln>
                    </p:spPr>
                    <p:style>
                      <a:lnRef idx="0"/>
                      <a:fillRef idx="0"/>
                      <a:effectRef idx="0"/>
                      <a:fontRef idx="minor"/>
                    </p:style>
                    <p:txBody>
                      <a:bodyPr lIns="90000" rIns="90000" tIns="-36720" bIns="-36720" anchor="t">
                        <a:noAutofit/>
                      </a:bodyPr>
                      <a:p>
                        <a:endParaRPr b="0" lang="en-US" sz="2400" spc="-1" strike="noStrike">
                          <a:solidFill>
                            <a:srgbClr val="000000"/>
                          </a:solidFill>
                          <a:latin typeface="Arial"/>
                        </a:endParaRPr>
                      </a:p>
                    </p:txBody>
                  </p:sp>
                  <p:sp>
                    <p:nvSpPr>
                      <p:cNvPr id="104" name="Line 64"/>
                      <p:cNvSpPr/>
                      <p:nvPr/>
                    </p:nvSpPr>
                    <p:spPr>
                      <a:xfrm>
                        <a:off x="8148240" y="2004480"/>
                        <a:ext cx="720" cy="10080"/>
                      </a:xfrm>
                      <a:prstGeom prst="line">
                        <a:avLst/>
                      </a:prstGeom>
                      <a:ln w="7920">
                        <a:solidFill>
                          <a:srgbClr val="000000"/>
                        </a:solidFill>
                        <a:miter/>
                      </a:ln>
                    </p:spPr>
                    <p:style>
                      <a:lnRef idx="0"/>
                      <a:fillRef idx="0"/>
                      <a:effectRef idx="0"/>
                      <a:fontRef idx="minor"/>
                    </p:style>
                    <p:txBody>
                      <a:bodyPr lIns="90000" rIns="90000" tIns="-36720" bIns="-36720" anchor="t">
                        <a:noAutofit/>
                      </a:bodyPr>
                      <a:p>
                        <a:endParaRPr b="0" lang="en-US" sz="2400" spc="-1" strike="noStrike">
                          <a:solidFill>
                            <a:srgbClr val="000000"/>
                          </a:solidFill>
                          <a:latin typeface="Arial"/>
                        </a:endParaRPr>
                      </a:p>
                    </p:txBody>
                  </p:sp>
                  <p:sp>
                    <p:nvSpPr>
                      <p:cNvPr id="105" name="Line 65"/>
                      <p:cNvSpPr/>
                      <p:nvPr/>
                    </p:nvSpPr>
                    <p:spPr>
                      <a:xfrm>
                        <a:off x="8169840" y="2004480"/>
                        <a:ext cx="720" cy="10080"/>
                      </a:xfrm>
                      <a:prstGeom prst="line">
                        <a:avLst/>
                      </a:prstGeom>
                      <a:ln w="7920">
                        <a:solidFill>
                          <a:srgbClr val="000000"/>
                        </a:solidFill>
                        <a:miter/>
                      </a:ln>
                    </p:spPr>
                    <p:style>
                      <a:lnRef idx="0"/>
                      <a:fillRef idx="0"/>
                      <a:effectRef idx="0"/>
                      <a:fontRef idx="minor"/>
                    </p:style>
                    <p:txBody>
                      <a:bodyPr lIns="90000" rIns="90000" tIns="-36720" bIns="-36720" anchor="t">
                        <a:noAutofit/>
                      </a:bodyPr>
                      <a:p>
                        <a:endParaRPr b="0" lang="en-US" sz="2400" spc="-1" strike="noStrike">
                          <a:solidFill>
                            <a:srgbClr val="000000"/>
                          </a:solidFill>
                          <a:latin typeface="Arial"/>
                        </a:endParaRPr>
                      </a:p>
                    </p:txBody>
                  </p:sp>
                  <p:sp>
                    <p:nvSpPr>
                      <p:cNvPr id="106" name="Line 66"/>
                      <p:cNvSpPr/>
                      <p:nvPr/>
                    </p:nvSpPr>
                    <p:spPr>
                      <a:xfrm>
                        <a:off x="8187120" y="2004480"/>
                        <a:ext cx="720" cy="31320"/>
                      </a:xfrm>
                      <a:prstGeom prst="line">
                        <a:avLst/>
                      </a:prstGeom>
                      <a:ln w="7920">
                        <a:solidFill>
                          <a:srgbClr val="000000"/>
                        </a:solidFill>
                        <a:miter/>
                      </a:ln>
                    </p:spPr>
                    <p:style>
                      <a:lnRef idx="0"/>
                      <a:fillRef idx="0"/>
                      <a:effectRef idx="0"/>
                      <a:fontRef idx="minor"/>
                    </p:style>
                    <p:txBody>
                      <a:bodyPr lIns="90000" rIns="90000" tIns="-15480" bIns="-15480" anchor="t">
                        <a:noAutofit/>
                      </a:bodyPr>
                      <a:p>
                        <a:endParaRPr b="0" lang="en-US" sz="2400" spc="-1" strike="noStrike">
                          <a:solidFill>
                            <a:srgbClr val="000000"/>
                          </a:solidFill>
                          <a:latin typeface="Arial"/>
                        </a:endParaRPr>
                      </a:p>
                    </p:txBody>
                  </p:sp>
                  <p:sp>
                    <p:nvSpPr>
                      <p:cNvPr id="107" name="Line 67"/>
                      <p:cNvSpPr/>
                      <p:nvPr/>
                    </p:nvSpPr>
                    <p:spPr>
                      <a:xfrm>
                        <a:off x="8290800" y="2004480"/>
                        <a:ext cx="1080" cy="10080"/>
                      </a:xfrm>
                      <a:prstGeom prst="line">
                        <a:avLst/>
                      </a:prstGeom>
                      <a:ln w="7920">
                        <a:solidFill>
                          <a:srgbClr val="000000"/>
                        </a:solidFill>
                        <a:miter/>
                      </a:ln>
                    </p:spPr>
                    <p:style>
                      <a:lnRef idx="0"/>
                      <a:fillRef idx="0"/>
                      <a:effectRef idx="0"/>
                      <a:fontRef idx="minor"/>
                    </p:style>
                    <p:txBody>
                      <a:bodyPr lIns="90000" rIns="90000" tIns="-36720" bIns="-36720" anchor="t">
                        <a:noAutofit/>
                      </a:bodyPr>
                      <a:p>
                        <a:endParaRPr b="0" lang="en-US" sz="2400" spc="-1" strike="noStrike">
                          <a:solidFill>
                            <a:srgbClr val="000000"/>
                          </a:solidFill>
                          <a:latin typeface="Arial"/>
                        </a:endParaRPr>
                      </a:p>
                    </p:txBody>
                  </p:sp>
                  <p:sp>
                    <p:nvSpPr>
                      <p:cNvPr id="108" name="Line 68"/>
                      <p:cNvSpPr/>
                      <p:nvPr/>
                    </p:nvSpPr>
                    <p:spPr>
                      <a:xfrm>
                        <a:off x="8356320" y="2004480"/>
                        <a:ext cx="720" cy="10080"/>
                      </a:xfrm>
                      <a:prstGeom prst="line">
                        <a:avLst/>
                      </a:prstGeom>
                      <a:ln w="7920">
                        <a:solidFill>
                          <a:srgbClr val="000000"/>
                        </a:solidFill>
                        <a:miter/>
                      </a:ln>
                    </p:spPr>
                    <p:style>
                      <a:lnRef idx="0"/>
                      <a:fillRef idx="0"/>
                      <a:effectRef idx="0"/>
                      <a:fontRef idx="minor"/>
                    </p:style>
                    <p:txBody>
                      <a:bodyPr lIns="90000" rIns="90000" tIns="-36720" bIns="-36720" anchor="t">
                        <a:noAutofit/>
                      </a:bodyPr>
                      <a:p>
                        <a:endParaRPr b="0" lang="en-US" sz="2400" spc="-1" strike="noStrike">
                          <a:solidFill>
                            <a:srgbClr val="000000"/>
                          </a:solidFill>
                          <a:latin typeface="Arial"/>
                        </a:endParaRPr>
                      </a:p>
                    </p:txBody>
                  </p:sp>
                  <p:sp>
                    <p:nvSpPr>
                      <p:cNvPr id="109" name="Line 69"/>
                      <p:cNvSpPr/>
                      <p:nvPr/>
                    </p:nvSpPr>
                    <p:spPr>
                      <a:xfrm>
                        <a:off x="8400600" y="2004480"/>
                        <a:ext cx="720" cy="10080"/>
                      </a:xfrm>
                      <a:prstGeom prst="line">
                        <a:avLst/>
                      </a:prstGeom>
                      <a:ln w="7920">
                        <a:solidFill>
                          <a:srgbClr val="000000"/>
                        </a:solidFill>
                        <a:miter/>
                      </a:ln>
                    </p:spPr>
                    <p:style>
                      <a:lnRef idx="0"/>
                      <a:fillRef idx="0"/>
                      <a:effectRef idx="0"/>
                      <a:fontRef idx="minor"/>
                    </p:style>
                    <p:txBody>
                      <a:bodyPr lIns="90000" rIns="90000" tIns="-36720" bIns="-36720" anchor="t">
                        <a:noAutofit/>
                      </a:bodyPr>
                      <a:p>
                        <a:endParaRPr b="0" lang="en-US" sz="2400" spc="-1" strike="noStrike">
                          <a:solidFill>
                            <a:srgbClr val="000000"/>
                          </a:solidFill>
                          <a:latin typeface="Arial"/>
                        </a:endParaRPr>
                      </a:p>
                    </p:txBody>
                  </p:sp>
                  <p:sp>
                    <p:nvSpPr>
                      <p:cNvPr id="110" name="Line 70"/>
                      <p:cNvSpPr/>
                      <p:nvPr/>
                    </p:nvSpPr>
                    <p:spPr>
                      <a:xfrm>
                        <a:off x="8432640" y="2004480"/>
                        <a:ext cx="720" cy="21240"/>
                      </a:xfrm>
                      <a:prstGeom prst="line">
                        <a:avLst/>
                      </a:prstGeom>
                      <a:ln w="7920">
                        <a:solidFill>
                          <a:srgbClr val="000000"/>
                        </a:solidFill>
                        <a:miter/>
                      </a:ln>
                    </p:spPr>
                    <p:style>
                      <a:lnRef idx="0"/>
                      <a:fillRef idx="0"/>
                      <a:effectRef idx="0"/>
                      <a:fontRef idx="minor"/>
                    </p:style>
                    <p:txBody>
                      <a:bodyPr lIns="90000" rIns="90000" tIns="-25560" bIns="-25560" anchor="t">
                        <a:noAutofit/>
                      </a:bodyPr>
                      <a:p>
                        <a:endParaRPr b="0" lang="en-US" sz="2400" spc="-1" strike="noStrike">
                          <a:solidFill>
                            <a:srgbClr val="000000"/>
                          </a:solidFill>
                          <a:latin typeface="Arial"/>
                        </a:endParaRPr>
                      </a:p>
                    </p:txBody>
                  </p:sp>
                  <p:sp>
                    <p:nvSpPr>
                      <p:cNvPr id="111" name="Line 71"/>
                      <p:cNvSpPr/>
                      <p:nvPr/>
                    </p:nvSpPr>
                    <p:spPr>
                      <a:xfrm>
                        <a:off x="8460000" y="2004480"/>
                        <a:ext cx="720" cy="10080"/>
                      </a:xfrm>
                      <a:prstGeom prst="line">
                        <a:avLst/>
                      </a:prstGeom>
                      <a:ln w="7920">
                        <a:solidFill>
                          <a:srgbClr val="000000"/>
                        </a:solidFill>
                        <a:miter/>
                      </a:ln>
                    </p:spPr>
                    <p:style>
                      <a:lnRef idx="0"/>
                      <a:fillRef idx="0"/>
                      <a:effectRef idx="0"/>
                      <a:fontRef idx="minor"/>
                    </p:style>
                    <p:txBody>
                      <a:bodyPr lIns="90000" rIns="90000" tIns="-36720" bIns="-36720" anchor="t">
                        <a:noAutofit/>
                      </a:bodyPr>
                      <a:p>
                        <a:endParaRPr b="0" lang="en-US" sz="2400" spc="-1" strike="noStrike">
                          <a:solidFill>
                            <a:srgbClr val="000000"/>
                          </a:solidFill>
                          <a:latin typeface="Arial"/>
                        </a:endParaRPr>
                      </a:p>
                    </p:txBody>
                  </p:sp>
                  <p:sp>
                    <p:nvSpPr>
                      <p:cNvPr id="112" name="Line 72"/>
                      <p:cNvSpPr/>
                      <p:nvPr/>
                    </p:nvSpPr>
                    <p:spPr>
                      <a:xfrm>
                        <a:off x="8482680" y="2004480"/>
                        <a:ext cx="1080" cy="10080"/>
                      </a:xfrm>
                      <a:prstGeom prst="line">
                        <a:avLst/>
                      </a:prstGeom>
                      <a:ln w="7920">
                        <a:solidFill>
                          <a:srgbClr val="000000"/>
                        </a:solidFill>
                        <a:miter/>
                      </a:ln>
                    </p:spPr>
                    <p:style>
                      <a:lnRef idx="0"/>
                      <a:fillRef idx="0"/>
                      <a:effectRef idx="0"/>
                      <a:fontRef idx="minor"/>
                    </p:style>
                    <p:txBody>
                      <a:bodyPr lIns="90000" rIns="90000" tIns="-36720" bIns="-36720" anchor="t">
                        <a:noAutofit/>
                      </a:bodyPr>
                      <a:p>
                        <a:endParaRPr b="0" lang="en-US" sz="2400" spc="-1" strike="noStrike">
                          <a:solidFill>
                            <a:srgbClr val="000000"/>
                          </a:solidFill>
                          <a:latin typeface="Arial"/>
                        </a:endParaRPr>
                      </a:p>
                    </p:txBody>
                  </p:sp>
                  <p:sp>
                    <p:nvSpPr>
                      <p:cNvPr id="113" name="Line 73"/>
                      <p:cNvSpPr/>
                      <p:nvPr/>
                    </p:nvSpPr>
                    <p:spPr>
                      <a:xfrm>
                        <a:off x="8504640" y="2004480"/>
                        <a:ext cx="720" cy="10080"/>
                      </a:xfrm>
                      <a:prstGeom prst="line">
                        <a:avLst/>
                      </a:prstGeom>
                      <a:ln w="7920">
                        <a:solidFill>
                          <a:srgbClr val="000000"/>
                        </a:solidFill>
                        <a:miter/>
                      </a:ln>
                    </p:spPr>
                    <p:style>
                      <a:lnRef idx="0"/>
                      <a:fillRef idx="0"/>
                      <a:effectRef idx="0"/>
                      <a:fontRef idx="minor"/>
                    </p:style>
                    <p:txBody>
                      <a:bodyPr lIns="90000" rIns="90000" tIns="-36720" bIns="-36720" anchor="t">
                        <a:noAutofit/>
                      </a:bodyPr>
                      <a:p>
                        <a:endParaRPr b="0" lang="en-US" sz="2400" spc="-1" strike="noStrike">
                          <a:solidFill>
                            <a:srgbClr val="000000"/>
                          </a:solidFill>
                          <a:latin typeface="Arial"/>
                        </a:endParaRPr>
                      </a:p>
                    </p:txBody>
                  </p:sp>
                  <p:sp>
                    <p:nvSpPr>
                      <p:cNvPr id="114" name="Line 74"/>
                      <p:cNvSpPr/>
                      <p:nvPr/>
                    </p:nvSpPr>
                    <p:spPr>
                      <a:xfrm>
                        <a:off x="8520480" y="2004480"/>
                        <a:ext cx="720" cy="10080"/>
                      </a:xfrm>
                      <a:prstGeom prst="line">
                        <a:avLst/>
                      </a:prstGeom>
                      <a:ln w="7920">
                        <a:solidFill>
                          <a:srgbClr val="000000"/>
                        </a:solidFill>
                        <a:miter/>
                      </a:ln>
                    </p:spPr>
                    <p:style>
                      <a:lnRef idx="0"/>
                      <a:fillRef idx="0"/>
                      <a:effectRef idx="0"/>
                      <a:fontRef idx="minor"/>
                    </p:style>
                    <p:txBody>
                      <a:bodyPr lIns="90000" rIns="90000" tIns="-36720" bIns="-36720" anchor="t">
                        <a:noAutofit/>
                      </a:bodyPr>
                      <a:p>
                        <a:endParaRPr b="0" lang="en-US" sz="2400" spc="-1" strike="noStrike">
                          <a:solidFill>
                            <a:srgbClr val="000000"/>
                          </a:solidFill>
                          <a:latin typeface="Arial"/>
                        </a:endParaRPr>
                      </a:p>
                    </p:txBody>
                  </p:sp>
                  <p:sp>
                    <p:nvSpPr>
                      <p:cNvPr id="115" name="Line 75"/>
                      <p:cNvSpPr/>
                      <p:nvPr/>
                    </p:nvSpPr>
                    <p:spPr>
                      <a:xfrm>
                        <a:off x="8536320" y="2004480"/>
                        <a:ext cx="1080" cy="31320"/>
                      </a:xfrm>
                      <a:prstGeom prst="line">
                        <a:avLst/>
                      </a:prstGeom>
                      <a:ln w="7920">
                        <a:solidFill>
                          <a:srgbClr val="000000"/>
                        </a:solidFill>
                        <a:miter/>
                      </a:ln>
                    </p:spPr>
                    <p:style>
                      <a:lnRef idx="0"/>
                      <a:fillRef idx="0"/>
                      <a:effectRef idx="0"/>
                      <a:fontRef idx="minor"/>
                    </p:style>
                    <p:txBody>
                      <a:bodyPr lIns="90000" rIns="90000" tIns="-15480" bIns="-15480" anchor="t">
                        <a:noAutofit/>
                      </a:bodyPr>
                      <a:p>
                        <a:endParaRPr b="0" lang="en-US" sz="2400" spc="-1" strike="noStrike">
                          <a:solidFill>
                            <a:srgbClr val="000000"/>
                          </a:solidFill>
                          <a:latin typeface="Arial"/>
                        </a:endParaRPr>
                      </a:p>
                    </p:txBody>
                  </p:sp>
                </p:grpSp>
                <p:grpSp>
                  <p:nvGrpSpPr>
                    <p:cNvPr id="116" name="Group 297"/>
                    <p:cNvGrpSpPr/>
                    <p:nvPr/>
                  </p:nvGrpSpPr>
                  <p:grpSpPr>
                    <a:xfrm>
                      <a:off x="7075440" y="2077560"/>
                      <a:ext cx="1594080" cy="152640"/>
                      <a:chOff x="7075440" y="2077560"/>
                      <a:chExt cx="1594080" cy="152640"/>
                    </a:xfrm>
                  </p:grpSpPr>
                  <p:sp>
                    <p:nvSpPr>
                      <p:cNvPr id="117" name="Rectangle 77"/>
                      <p:cNvSpPr/>
                      <p:nvPr/>
                    </p:nvSpPr>
                    <p:spPr>
                      <a:xfrm>
                        <a:off x="7075440" y="2077560"/>
                        <a:ext cx="181800" cy="152640"/>
                      </a:xfrm>
                      <a:prstGeom prst="rect">
                        <a:avLst/>
                      </a:prstGeom>
                      <a:noFill/>
                      <a:ln w="0">
                        <a:noFill/>
                      </a:ln>
                    </p:spPr>
                    <p:style>
                      <a:lnRef idx="0"/>
                      <a:fillRef idx="0"/>
                      <a:effectRef idx="0"/>
                      <a:fontRef idx="minor"/>
                    </p:style>
                    <p:txBody>
                      <a:bodyPr wrap="none" lIns="0" rIns="0" tIns="0" bIns="0" anchor="t">
                        <a:spAutoFit/>
                      </a:bodyPr>
                      <a:p>
                        <a:pPr>
                          <a:tabLst>
                            <a:tab algn="l" pos="0"/>
                            <a:tab algn="l" pos="457200"/>
                            <a:tab algn="l" pos="914400"/>
                            <a:tab algn="l" pos="1371600"/>
                            <a:tab algn="l" pos="1828800"/>
                            <a:tab algn="l" pos="2286000"/>
                            <a:tab algn="l" pos="2743200"/>
                            <a:tab algn="l" pos="3200400"/>
                            <a:tab algn="l" pos="3657600"/>
                            <a:tab algn="l" pos="4114800"/>
                            <a:tab algn="l" pos="4572000"/>
                            <a:tab algn="l" pos="5029200"/>
                            <a:tab algn="l" pos="5486400"/>
                            <a:tab algn="l" pos="5943600"/>
                            <a:tab algn="l" pos="6400800"/>
                            <a:tab algn="l" pos="6858000"/>
                            <a:tab algn="l" pos="7315200"/>
                            <a:tab algn="l" pos="7772400"/>
                            <a:tab algn="l" pos="8229600"/>
                            <a:tab algn="l" pos="8686800"/>
                            <a:tab algn="l" pos="9144000"/>
                          </a:tabLst>
                        </a:pPr>
                        <a:r>
                          <a:rPr b="1" lang="en-US" sz="1000" spc="-1" strike="noStrike">
                            <a:solidFill>
                              <a:srgbClr val="000000"/>
                            </a:solidFill>
                            <a:latin typeface="Arial"/>
                          </a:rPr>
                          <a:t>10</a:t>
                        </a:r>
                        <a:r>
                          <a:rPr b="1" lang="en-US" sz="1000" spc="-1" strike="noStrike" baseline="30000">
                            <a:solidFill>
                              <a:srgbClr val="000000"/>
                            </a:solidFill>
                            <a:latin typeface="Arial"/>
                          </a:rPr>
                          <a:t>0</a:t>
                        </a:r>
                        <a:endParaRPr b="0" lang="en-US" sz="1000" spc="-1" strike="noStrike">
                          <a:solidFill>
                            <a:srgbClr val="000000"/>
                          </a:solidFill>
                          <a:latin typeface="Arial"/>
                        </a:endParaRPr>
                      </a:p>
                    </p:txBody>
                  </p:sp>
                  <p:sp>
                    <p:nvSpPr>
                      <p:cNvPr id="118" name="Rectangle 79"/>
                      <p:cNvSpPr/>
                      <p:nvPr/>
                    </p:nvSpPr>
                    <p:spPr>
                      <a:xfrm>
                        <a:off x="7426440" y="2077560"/>
                        <a:ext cx="181800" cy="152640"/>
                      </a:xfrm>
                      <a:prstGeom prst="rect">
                        <a:avLst/>
                      </a:prstGeom>
                      <a:noFill/>
                      <a:ln w="0">
                        <a:noFill/>
                      </a:ln>
                    </p:spPr>
                    <p:style>
                      <a:lnRef idx="0"/>
                      <a:fillRef idx="0"/>
                      <a:effectRef idx="0"/>
                      <a:fontRef idx="minor"/>
                    </p:style>
                    <p:txBody>
                      <a:bodyPr wrap="none" lIns="0" rIns="0" tIns="0" bIns="0" anchor="t">
                        <a:spAutoFit/>
                      </a:bodyPr>
                      <a:p>
                        <a:pPr>
                          <a:tabLst>
                            <a:tab algn="l" pos="0"/>
                            <a:tab algn="l" pos="457200"/>
                            <a:tab algn="l" pos="914400"/>
                            <a:tab algn="l" pos="1371600"/>
                            <a:tab algn="l" pos="1828800"/>
                            <a:tab algn="l" pos="2286000"/>
                            <a:tab algn="l" pos="2743200"/>
                            <a:tab algn="l" pos="3200400"/>
                            <a:tab algn="l" pos="3657600"/>
                            <a:tab algn="l" pos="4114800"/>
                            <a:tab algn="l" pos="4572000"/>
                            <a:tab algn="l" pos="5029200"/>
                            <a:tab algn="l" pos="5486400"/>
                            <a:tab algn="l" pos="5943600"/>
                            <a:tab algn="l" pos="6400800"/>
                            <a:tab algn="l" pos="6858000"/>
                            <a:tab algn="l" pos="7315200"/>
                            <a:tab algn="l" pos="7772400"/>
                            <a:tab algn="l" pos="8229600"/>
                            <a:tab algn="l" pos="8686800"/>
                            <a:tab algn="l" pos="9144000"/>
                          </a:tabLst>
                        </a:pPr>
                        <a:r>
                          <a:rPr b="1" lang="en-US" sz="1000" spc="-1" strike="noStrike">
                            <a:solidFill>
                              <a:srgbClr val="000000"/>
                            </a:solidFill>
                            <a:latin typeface="Arial"/>
                          </a:rPr>
                          <a:t>10</a:t>
                        </a:r>
                        <a:r>
                          <a:rPr b="1" lang="en-US" sz="1000" spc="-1" strike="noStrike" baseline="30000">
                            <a:solidFill>
                              <a:srgbClr val="000000"/>
                            </a:solidFill>
                            <a:latin typeface="Arial"/>
                          </a:rPr>
                          <a:t>1</a:t>
                        </a:r>
                        <a:endParaRPr b="0" lang="en-US" sz="1000" spc="-1" strike="noStrike">
                          <a:solidFill>
                            <a:srgbClr val="000000"/>
                          </a:solidFill>
                          <a:latin typeface="Arial"/>
                        </a:endParaRPr>
                      </a:p>
                    </p:txBody>
                  </p:sp>
                  <p:sp>
                    <p:nvSpPr>
                      <p:cNvPr id="119" name="Rectangle 81"/>
                      <p:cNvSpPr/>
                      <p:nvPr/>
                    </p:nvSpPr>
                    <p:spPr>
                      <a:xfrm>
                        <a:off x="7783920" y="2077560"/>
                        <a:ext cx="181800" cy="152640"/>
                      </a:xfrm>
                      <a:prstGeom prst="rect">
                        <a:avLst/>
                      </a:prstGeom>
                      <a:noFill/>
                      <a:ln w="0">
                        <a:noFill/>
                      </a:ln>
                    </p:spPr>
                    <p:style>
                      <a:lnRef idx="0"/>
                      <a:fillRef idx="0"/>
                      <a:effectRef idx="0"/>
                      <a:fontRef idx="minor"/>
                    </p:style>
                    <p:txBody>
                      <a:bodyPr wrap="none" lIns="0" rIns="0" tIns="0" bIns="0" anchor="t">
                        <a:spAutoFit/>
                      </a:bodyPr>
                      <a:p>
                        <a:pPr>
                          <a:tabLst>
                            <a:tab algn="l" pos="0"/>
                            <a:tab algn="l" pos="457200"/>
                            <a:tab algn="l" pos="914400"/>
                            <a:tab algn="l" pos="1371600"/>
                            <a:tab algn="l" pos="1828800"/>
                            <a:tab algn="l" pos="2286000"/>
                            <a:tab algn="l" pos="2743200"/>
                            <a:tab algn="l" pos="3200400"/>
                            <a:tab algn="l" pos="3657600"/>
                            <a:tab algn="l" pos="4114800"/>
                            <a:tab algn="l" pos="4572000"/>
                            <a:tab algn="l" pos="5029200"/>
                            <a:tab algn="l" pos="5486400"/>
                            <a:tab algn="l" pos="5943600"/>
                            <a:tab algn="l" pos="6400800"/>
                            <a:tab algn="l" pos="6858000"/>
                            <a:tab algn="l" pos="7315200"/>
                            <a:tab algn="l" pos="7772400"/>
                            <a:tab algn="l" pos="8229600"/>
                            <a:tab algn="l" pos="8686800"/>
                            <a:tab algn="l" pos="9144000"/>
                          </a:tabLst>
                        </a:pPr>
                        <a:r>
                          <a:rPr b="1" lang="en-US" sz="1000" spc="-1" strike="noStrike">
                            <a:solidFill>
                              <a:srgbClr val="000000"/>
                            </a:solidFill>
                            <a:latin typeface="Arial"/>
                          </a:rPr>
                          <a:t>10</a:t>
                        </a:r>
                        <a:r>
                          <a:rPr b="1" lang="en-US" sz="1000" spc="-1" strike="noStrike" baseline="30000">
                            <a:solidFill>
                              <a:srgbClr val="000000"/>
                            </a:solidFill>
                            <a:latin typeface="Arial"/>
                          </a:rPr>
                          <a:t>2</a:t>
                        </a:r>
                        <a:endParaRPr b="0" lang="en-US" sz="1000" spc="-1" strike="noStrike">
                          <a:solidFill>
                            <a:srgbClr val="000000"/>
                          </a:solidFill>
                          <a:latin typeface="Arial"/>
                        </a:endParaRPr>
                      </a:p>
                    </p:txBody>
                  </p:sp>
                  <p:sp>
                    <p:nvSpPr>
                      <p:cNvPr id="120" name="Rectangle 83"/>
                      <p:cNvSpPr/>
                      <p:nvPr/>
                    </p:nvSpPr>
                    <p:spPr>
                      <a:xfrm>
                        <a:off x="8139240" y="2077560"/>
                        <a:ext cx="181800" cy="152640"/>
                      </a:xfrm>
                      <a:prstGeom prst="rect">
                        <a:avLst/>
                      </a:prstGeom>
                      <a:noFill/>
                      <a:ln w="0">
                        <a:noFill/>
                      </a:ln>
                    </p:spPr>
                    <p:style>
                      <a:lnRef idx="0"/>
                      <a:fillRef idx="0"/>
                      <a:effectRef idx="0"/>
                      <a:fontRef idx="minor"/>
                    </p:style>
                    <p:txBody>
                      <a:bodyPr wrap="none" lIns="0" rIns="0" tIns="0" bIns="0" anchor="t">
                        <a:spAutoFit/>
                      </a:bodyPr>
                      <a:p>
                        <a:pPr>
                          <a:tabLst>
                            <a:tab algn="l" pos="0"/>
                            <a:tab algn="l" pos="457200"/>
                            <a:tab algn="l" pos="914400"/>
                            <a:tab algn="l" pos="1371600"/>
                            <a:tab algn="l" pos="1828800"/>
                            <a:tab algn="l" pos="2286000"/>
                            <a:tab algn="l" pos="2743200"/>
                            <a:tab algn="l" pos="3200400"/>
                            <a:tab algn="l" pos="3657600"/>
                            <a:tab algn="l" pos="4114800"/>
                            <a:tab algn="l" pos="4572000"/>
                            <a:tab algn="l" pos="5029200"/>
                            <a:tab algn="l" pos="5486400"/>
                            <a:tab algn="l" pos="5943600"/>
                            <a:tab algn="l" pos="6400800"/>
                            <a:tab algn="l" pos="6858000"/>
                            <a:tab algn="l" pos="7315200"/>
                            <a:tab algn="l" pos="7772400"/>
                            <a:tab algn="l" pos="8229600"/>
                            <a:tab algn="l" pos="8686800"/>
                            <a:tab algn="l" pos="9144000"/>
                          </a:tabLst>
                        </a:pPr>
                        <a:r>
                          <a:rPr b="1" lang="en-US" sz="1000" spc="-1" strike="noStrike">
                            <a:solidFill>
                              <a:srgbClr val="000000"/>
                            </a:solidFill>
                            <a:latin typeface="Arial"/>
                          </a:rPr>
                          <a:t>10</a:t>
                        </a:r>
                        <a:r>
                          <a:rPr b="1" lang="en-US" sz="1000" spc="-1" strike="noStrike" baseline="30000">
                            <a:solidFill>
                              <a:srgbClr val="000000"/>
                            </a:solidFill>
                            <a:latin typeface="Arial"/>
                          </a:rPr>
                          <a:t>3</a:t>
                        </a:r>
                        <a:endParaRPr b="0" lang="en-US" sz="1000" spc="-1" strike="noStrike">
                          <a:solidFill>
                            <a:srgbClr val="000000"/>
                          </a:solidFill>
                          <a:latin typeface="Arial"/>
                        </a:endParaRPr>
                      </a:p>
                    </p:txBody>
                  </p:sp>
                  <p:sp>
                    <p:nvSpPr>
                      <p:cNvPr id="121" name="Rectangle 85"/>
                      <p:cNvSpPr/>
                      <p:nvPr/>
                    </p:nvSpPr>
                    <p:spPr>
                      <a:xfrm>
                        <a:off x="8487720" y="2077560"/>
                        <a:ext cx="181800" cy="152640"/>
                      </a:xfrm>
                      <a:prstGeom prst="rect">
                        <a:avLst/>
                      </a:prstGeom>
                      <a:noFill/>
                      <a:ln w="0">
                        <a:noFill/>
                      </a:ln>
                    </p:spPr>
                    <p:style>
                      <a:lnRef idx="0"/>
                      <a:fillRef idx="0"/>
                      <a:effectRef idx="0"/>
                      <a:fontRef idx="minor"/>
                    </p:style>
                    <p:txBody>
                      <a:bodyPr wrap="none" lIns="0" rIns="0" tIns="0" bIns="0" anchor="t">
                        <a:spAutoFit/>
                      </a:bodyPr>
                      <a:p>
                        <a:pPr>
                          <a:tabLst>
                            <a:tab algn="l" pos="0"/>
                            <a:tab algn="l" pos="457200"/>
                            <a:tab algn="l" pos="914400"/>
                            <a:tab algn="l" pos="1371600"/>
                            <a:tab algn="l" pos="1828800"/>
                            <a:tab algn="l" pos="2286000"/>
                            <a:tab algn="l" pos="2743200"/>
                            <a:tab algn="l" pos="3200400"/>
                            <a:tab algn="l" pos="3657600"/>
                            <a:tab algn="l" pos="4114800"/>
                            <a:tab algn="l" pos="4572000"/>
                            <a:tab algn="l" pos="5029200"/>
                            <a:tab algn="l" pos="5486400"/>
                            <a:tab algn="l" pos="5943600"/>
                            <a:tab algn="l" pos="6400800"/>
                            <a:tab algn="l" pos="6858000"/>
                            <a:tab algn="l" pos="7315200"/>
                            <a:tab algn="l" pos="7772400"/>
                            <a:tab algn="l" pos="8229600"/>
                            <a:tab algn="l" pos="8686800"/>
                            <a:tab algn="l" pos="9144000"/>
                          </a:tabLst>
                        </a:pPr>
                        <a:r>
                          <a:rPr b="1" lang="en-US" sz="1000" spc="-1" strike="noStrike">
                            <a:solidFill>
                              <a:srgbClr val="000000"/>
                            </a:solidFill>
                            <a:latin typeface="Arial"/>
                          </a:rPr>
                          <a:t>10</a:t>
                        </a:r>
                        <a:r>
                          <a:rPr b="1" lang="en-US" sz="1000" spc="-1" strike="noStrike" baseline="30000">
                            <a:solidFill>
                              <a:srgbClr val="000000"/>
                            </a:solidFill>
                            <a:latin typeface="Arial"/>
                          </a:rPr>
                          <a:t>4</a:t>
                        </a:r>
                        <a:endParaRPr b="0" lang="en-US" sz="1000" spc="-1" strike="noStrike">
                          <a:solidFill>
                            <a:srgbClr val="000000"/>
                          </a:solidFill>
                          <a:latin typeface="Arial"/>
                        </a:endParaRPr>
                      </a:p>
                    </p:txBody>
                  </p:sp>
                </p:grpSp>
                <p:sp>
                  <p:nvSpPr>
                    <p:cNvPr id="122" name="Line 88"/>
                    <p:cNvSpPr/>
                    <p:nvPr/>
                  </p:nvSpPr>
                  <p:spPr>
                    <a:xfrm flipV="1">
                      <a:off x="7123680" y="584640"/>
                      <a:ext cx="1080" cy="1413720"/>
                    </a:xfrm>
                    <a:prstGeom prst="line">
                      <a:avLst/>
                    </a:prstGeom>
                    <a:ln w="792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grpSp>
                  <p:nvGrpSpPr>
                    <p:cNvPr id="123" name="Group 89"/>
                    <p:cNvGrpSpPr/>
                    <p:nvPr/>
                  </p:nvGrpSpPr>
                  <p:grpSpPr>
                    <a:xfrm>
                      <a:off x="6833520" y="563040"/>
                      <a:ext cx="227160" cy="1500480"/>
                      <a:chOff x="6833520" y="563040"/>
                      <a:chExt cx="227160" cy="1500480"/>
                    </a:xfrm>
                  </p:grpSpPr>
                  <p:sp>
                    <p:nvSpPr>
                      <p:cNvPr id="124" name="Rectangle 90"/>
                      <p:cNvSpPr/>
                      <p:nvPr/>
                    </p:nvSpPr>
                    <p:spPr>
                      <a:xfrm>
                        <a:off x="6989760" y="1910880"/>
                        <a:ext cx="70920" cy="152640"/>
                      </a:xfrm>
                      <a:prstGeom prst="rect">
                        <a:avLst/>
                      </a:prstGeom>
                      <a:noFill/>
                      <a:ln w="0">
                        <a:noFill/>
                      </a:ln>
                    </p:spPr>
                    <p:style>
                      <a:lnRef idx="0"/>
                      <a:fillRef idx="0"/>
                      <a:effectRef idx="0"/>
                      <a:fontRef idx="minor"/>
                    </p:style>
                    <p:txBody>
                      <a:bodyPr wrap="none" lIns="0" rIns="0" tIns="0" bIns="0" anchor="t">
                        <a:spAutoFit/>
                      </a:bodyPr>
                      <a:p>
                        <a:pPr>
                          <a:tabLst>
                            <a:tab algn="l" pos="0"/>
                            <a:tab algn="l" pos="457200"/>
                            <a:tab algn="l" pos="914400"/>
                            <a:tab algn="l" pos="1371600"/>
                            <a:tab algn="l" pos="1828800"/>
                            <a:tab algn="l" pos="2286000"/>
                            <a:tab algn="l" pos="2743200"/>
                            <a:tab algn="l" pos="3200400"/>
                            <a:tab algn="l" pos="3657600"/>
                            <a:tab algn="l" pos="4114800"/>
                            <a:tab algn="l" pos="4572000"/>
                            <a:tab algn="l" pos="5029200"/>
                            <a:tab algn="l" pos="5486400"/>
                            <a:tab algn="l" pos="5943600"/>
                            <a:tab algn="l" pos="6400800"/>
                            <a:tab algn="l" pos="6858000"/>
                            <a:tab algn="l" pos="7315200"/>
                            <a:tab algn="l" pos="7772400"/>
                            <a:tab algn="l" pos="8229600"/>
                            <a:tab algn="l" pos="8686800"/>
                            <a:tab algn="l" pos="9144000"/>
                          </a:tabLst>
                        </a:pPr>
                        <a:r>
                          <a:rPr b="1" lang="en-US" sz="1000" spc="-1" strike="noStrike">
                            <a:solidFill>
                              <a:srgbClr val="000000"/>
                            </a:solidFill>
                            <a:latin typeface="Arial"/>
                          </a:rPr>
                          <a:t>0</a:t>
                        </a:r>
                        <a:endParaRPr b="0" lang="en-US" sz="1000" spc="-1" strike="noStrike">
                          <a:solidFill>
                            <a:srgbClr val="000000"/>
                          </a:solidFill>
                          <a:latin typeface="Arial"/>
                        </a:endParaRPr>
                      </a:p>
                    </p:txBody>
                  </p:sp>
                  <p:sp>
                    <p:nvSpPr>
                      <p:cNvPr id="125" name="Rectangle 91"/>
                      <p:cNvSpPr/>
                      <p:nvPr/>
                    </p:nvSpPr>
                    <p:spPr>
                      <a:xfrm>
                        <a:off x="6911640" y="1643760"/>
                        <a:ext cx="140760" cy="152640"/>
                      </a:xfrm>
                      <a:prstGeom prst="rect">
                        <a:avLst/>
                      </a:prstGeom>
                      <a:noFill/>
                      <a:ln w="0">
                        <a:noFill/>
                      </a:ln>
                    </p:spPr>
                    <p:style>
                      <a:lnRef idx="0"/>
                      <a:fillRef idx="0"/>
                      <a:effectRef idx="0"/>
                      <a:fontRef idx="minor"/>
                    </p:style>
                    <p:txBody>
                      <a:bodyPr wrap="none" lIns="0" rIns="0" tIns="0" bIns="0" anchor="t">
                        <a:spAutoFit/>
                      </a:bodyPr>
                      <a:p>
                        <a:pPr>
                          <a:tabLst>
                            <a:tab algn="l" pos="0"/>
                            <a:tab algn="l" pos="457200"/>
                            <a:tab algn="l" pos="914400"/>
                            <a:tab algn="l" pos="1371600"/>
                            <a:tab algn="l" pos="1828800"/>
                            <a:tab algn="l" pos="2286000"/>
                            <a:tab algn="l" pos="2743200"/>
                            <a:tab algn="l" pos="3200400"/>
                            <a:tab algn="l" pos="3657600"/>
                            <a:tab algn="l" pos="4114800"/>
                            <a:tab algn="l" pos="4572000"/>
                            <a:tab algn="l" pos="5029200"/>
                            <a:tab algn="l" pos="5486400"/>
                            <a:tab algn="l" pos="5943600"/>
                            <a:tab algn="l" pos="6400800"/>
                            <a:tab algn="l" pos="6858000"/>
                            <a:tab algn="l" pos="7315200"/>
                            <a:tab algn="l" pos="7772400"/>
                            <a:tab algn="l" pos="8229600"/>
                            <a:tab algn="l" pos="8686800"/>
                            <a:tab algn="l" pos="9144000"/>
                          </a:tabLst>
                        </a:pPr>
                        <a:r>
                          <a:rPr b="1" lang="en-US" sz="1000" spc="-1" strike="noStrike">
                            <a:solidFill>
                              <a:srgbClr val="000000"/>
                            </a:solidFill>
                            <a:latin typeface="Arial"/>
                          </a:rPr>
                          <a:t>20</a:t>
                        </a:r>
                        <a:endParaRPr b="0" lang="en-US" sz="1000" spc="-1" strike="noStrike">
                          <a:solidFill>
                            <a:srgbClr val="000000"/>
                          </a:solidFill>
                          <a:latin typeface="Arial"/>
                        </a:endParaRPr>
                      </a:p>
                    </p:txBody>
                  </p:sp>
                  <p:sp>
                    <p:nvSpPr>
                      <p:cNvPr id="126" name="Rectangle 92"/>
                      <p:cNvSpPr/>
                      <p:nvPr/>
                    </p:nvSpPr>
                    <p:spPr>
                      <a:xfrm>
                        <a:off x="6911640" y="1374120"/>
                        <a:ext cx="140760" cy="152640"/>
                      </a:xfrm>
                      <a:prstGeom prst="rect">
                        <a:avLst/>
                      </a:prstGeom>
                      <a:noFill/>
                      <a:ln w="0">
                        <a:noFill/>
                      </a:ln>
                    </p:spPr>
                    <p:style>
                      <a:lnRef idx="0"/>
                      <a:fillRef idx="0"/>
                      <a:effectRef idx="0"/>
                      <a:fontRef idx="minor"/>
                    </p:style>
                    <p:txBody>
                      <a:bodyPr wrap="none" lIns="0" rIns="0" tIns="0" bIns="0" anchor="t">
                        <a:spAutoFit/>
                      </a:bodyPr>
                      <a:p>
                        <a:pPr>
                          <a:tabLst>
                            <a:tab algn="l" pos="0"/>
                            <a:tab algn="l" pos="457200"/>
                            <a:tab algn="l" pos="914400"/>
                            <a:tab algn="l" pos="1371600"/>
                            <a:tab algn="l" pos="1828800"/>
                            <a:tab algn="l" pos="2286000"/>
                            <a:tab algn="l" pos="2743200"/>
                            <a:tab algn="l" pos="3200400"/>
                            <a:tab algn="l" pos="3657600"/>
                            <a:tab algn="l" pos="4114800"/>
                            <a:tab algn="l" pos="4572000"/>
                            <a:tab algn="l" pos="5029200"/>
                            <a:tab algn="l" pos="5486400"/>
                            <a:tab algn="l" pos="5943600"/>
                            <a:tab algn="l" pos="6400800"/>
                            <a:tab algn="l" pos="6858000"/>
                            <a:tab algn="l" pos="7315200"/>
                            <a:tab algn="l" pos="7772400"/>
                            <a:tab algn="l" pos="8229600"/>
                            <a:tab algn="l" pos="8686800"/>
                            <a:tab algn="l" pos="9144000"/>
                          </a:tabLst>
                        </a:pPr>
                        <a:r>
                          <a:rPr b="1" lang="en-US" sz="1000" spc="-1" strike="noStrike">
                            <a:solidFill>
                              <a:srgbClr val="000000"/>
                            </a:solidFill>
                            <a:latin typeface="Arial"/>
                          </a:rPr>
                          <a:t>40</a:t>
                        </a:r>
                        <a:endParaRPr b="0" lang="en-US" sz="1000" spc="-1" strike="noStrike">
                          <a:solidFill>
                            <a:srgbClr val="000000"/>
                          </a:solidFill>
                          <a:latin typeface="Arial"/>
                        </a:endParaRPr>
                      </a:p>
                    </p:txBody>
                  </p:sp>
                  <p:sp>
                    <p:nvSpPr>
                      <p:cNvPr id="127" name="Rectangle 93"/>
                      <p:cNvSpPr/>
                      <p:nvPr/>
                    </p:nvSpPr>
                    <p:spPr>
                      <a:xfrm>
                        <a:off x="6911640" y="1099800"/>
                        <a:ext cx="140760" cy="152640"/>
                      </a:xfrm>
                      <a:prstGeom prst="rect">
                        <a:avLst/>
                      </a:prstGeom>
                      <a:noFill/>
                      <a:ln w="0">
                        <a:noFill/>
                      </a:ln>
                    </p:spPr>
                    <p:style>
                      <a:lnRef idx="0"/>
                      <a:fillRef idx="0"/>
                      <a:effectRef idx="0"/>
                      <a:fontRef idx="minor"/>
                    </p:style>
                    <p:txBody>
                      <a:bodyPr wrap="none" lIns="0" rIns="0" tIns="0" bIns="0" anchor="t">
                        <a:spAutoFit/>
                      </a:bodyPr>
                      <a:p>
                        <a:pPr>
                          <a:tabLst>
                            <a:tab algn="l" pos="0"/>
                            <a:tab algn="l" pos="457200"/>
                            <a:tab algn="l" pos="914400"/>
                            <a:tab algn="l" pos="1371600"/>
                            <a:tab algn="l" pos="1828800"/>
                            <a:tab algn="l" pos="2286000"/>
                            <a:tab algn="l" pos="2743200"/>
                            <a:tab algn="l" pos="3200400"/>
                            <a:tab algn="l" pos="3657600"/>
                            <a:tab algn="l" pos="4114800"/>
                            <a:tab algn="l" pos="4572000"/>
                            <a:tab algn="l" pos="5029200"/>
                            <a:tab algn="l" pos="5486400"/>
                            <a:tab algn="l" pos="5943600"/>
                            <a:tab algn="l" pos="6400800"/>
                            <a:tab algn="l" pos="6858000"/>
                            <a:tab algn="l" pos="7315200"/>
                            <a:tab algn="l" pos="7772400"/>
                            <a:tab algn="l" pos="8229600"/>
                            <a:tab algn="l" pos="8686800"/>
                            <a:tab algn="l" pos="9144000"/>
                          </a:tabLst>
                        </a:pPr>
                        <a:r>
                          <a:rPr b="1" lang="en-US" sz="1000" spc="-1" strike="noStrike">
                            <a:solidFill>
                              <a:srgbClr val="000000"/>
                            </a:solidFill>
                            <a:latin typeface="Arial"/>
                          </a:rPr>
                          <a:t>60</a:t>
                        </a:r>
                        <a:endParaRPr b="0" lang="en-US" sz="1000" spc="-1" strike="noStrike">
                          <a:solidFill>
                            <a:srgbClr val="000000"/>
                          </a:solidFill>
                          <a:latin typeface="Arial"/>
                        </a:endParaRPr>
                      </a:p>
                    </p:txBody>
                  </p:sp>
                  <p:sp>
                    <p:nvSpPr>
                      <p:cNvPr id="128" name="Rectangle 94"/>
                      <p:cNvSpPr/>
                      <p:nvPr/>
                    </p:nvSpPr>
                    <p:spPr>
                      <a:xfrm>
                        <a:off x="6911640" y="831240"/>
                        <a:ext cx="140760" cy="152640"/>
                      </a:xfrm>
                      <a:prstGeom prst="rect">
                        <a:avLst/>
                      </a:prstGeom>
                      <a:noFill/>
                      <a:ln w="0">
                        <a:noFill/>
                      </a:ln>
                    </p:spPr>
                    <p:style>
                      <a:lnRef idx="0"/>
                      <a:fillRef idx="0"/>
                      <a:effectRef idx="0"/>
                      <a:fontRef idx="minor"/>
                    </p:style>
                    <p:txBody>
                      <a:bodyPr wrap="none" lIns="0" rIns="0" tIns="0" bIns="0" anchor="t">
                        <a:spAutoFit/>
                      </a:bodyPr>
                      <a:p>
                        <a:pPr>
                          <a:tabLst>
                            <a:tab algn="l" pos="0"/>
                            <a:tab algn="l" pos="457200"/>
                            <a:tab algn="l" pos="914400"/>
                            <a:tab algn="l" pos="1371600"/>
                            <a:tab algn="l" pos="1828800"/>
                            <a:tab algn="l" pos="2286000"/>
                            <a:tab algn="l" pos="2743200"/>
                            <a:tab algn="l" pos="3200400"/>
                            <a:tab algn="l" pos="3657600"/>
                            <a:tab algn="l" pos="4114800"/>
                            <a:tab algn="l" pos="4572000"/>
                            <a:tab algn="l" pos="5029200"/>
                            <a:tab algn="l" pos="5486400"/>
                            <a:tab algn="l" pos="5943600"/>
                            <a:tab algn="l" pos="6400800"/>
                            <a:tab algn="l" pos="6858000"/>
                            <a:tab algn="l" pos="7315200"/>
                            <a:tab algn="l" pos="7772400"/>
                            <a:tab algn="l" pos="8229600"/>
                            <a:tab algn="l" pos="8686800"/>
                            <a:tab algn="l" pos="9144000"/>
                          </a:tabLst>
                        </a:pPr>
                        <a:r>
                          <a:rPr b="1" lang="en-US" sz="1000" spc="-1" strike="noStrike">
                            <a:solidFill>
                              <a:srgbClr val="000000"/>
                            </a:solidFill>
                            <a:latin typeface="Arial"/>
                          </a:rPr>
                          <a:t>80</a:t>
                        </a:r>
                        <a:endParaRPr b="0" lang="en-US" sz="1000" spc="-1" strike="noStrike">
                          <a:solidFill>
                            <a:srgbClr val="000000"/>
                          </a:solidFill>
                          <a:latin typeface="Arial"/>
                        </a:endParaRPr>
                      </a:p>
                    </p:txBody>
                  </p:sp>
                  <p:sp>
                    <p:nvSpPr>
                      <p:cNvPr id="129" name="Rectangle 95"/>
                      <p:cNvSpPr/>
                      <p:nvPr/>
                    </p:nvSpPr>
                    <p:spPr>
                      <a:xfrm>
                        <a:off x="6833520" y="563040"/>
                        <a:ext cx="210960" cy="152640"/>
                      </a:xfrm>
                      <a:prstGeom prst="rect">
                        <a:avLst/>
                      </a:prstGeom>
                      <a:noFill/>
                      <a:ln w="0">
                        <a:noFill/>
                      </a:ln>
                    </p:spPr>
                    <p:style>
                      <a:lnRef idx="0"/>
                      <a:fillRef idx="0"/>
                      <a:effectRef idx="0"/>
                      <a:fontRef idx="minor"/>
                    </p:style>
                    <p:txBody>
                      <a:bodyPr wrap="none" lIns="0" rIns="0" tIns="0" bIns="0" anchor="t">
                        <a:spAutoFit/>
                      </a:bodyPr>
                      <a:p>
                        <a:pPr>
                          <a:tabLst>
                            <a:tab algn="l" pos="0"/>
                            <a:tab algn="l" pos="457200"/>
                            <a:tab algn="l" pos="914400"/>
                            <a:tab algn="l" pos="1371600"/>
                            <a:tab algn="l" pos="1828800"/>
                            <a:tab algn="l" pos="2286000"/>
                            <a:tab algn="l" pos="2743200"/>
                            <a:tab algn="l" pos="3200400"/>
                            <a:tab algn="l" pos="3657600"/>
                            <a:tab algn="l" pos="4114800"/>
                            <a:tab algn="l" pos="4572000"/>
                            <a:tab algn="l" pos="5029200"/>
                            <a:tab algn="l" pos="5486400"/>
                            <a:tab algn="l" pos="5943600"/>
                            <a:tab algn="l" pos="6400800"/>
                            <a:tab algn="l" pos="6858000"/>
                            <a:tab algn="l" pos="7315200"/>
                            <a:tab algn="l" pos="7772400"/>
                            <a:tab algn="l" pos="8229600"/>
                            <a:tab algn="l" pos="8686800"/>
                            <a:tab algn="l" pos="9144000"/>
                          </a:tabLst>
                        </a:pPr>
                        <a:r>
                          <a:rPr b="1" lang="en-US" sz="1000" spc="-1" strike="noStrike">
                            <a:solidFill>
                              <a:srgbClr val="000000"/>
                            </a:solidFill>
                            <a:latin typeface="Arial"/>
                          </a:rPr>
                          <a:t>100</a:t>
                        </a:r>
                        <a:endParaRPr b="0" lang="en-US" sz="1000" spc="-1" strike="noStrike">
                          <a:solidFill>
                            <a:srgbClr val="000000"/>
                          </a:solidFill>
                          <a:latin typeface="Arial"/>
                        </a:endParaRPr>
                      </a:p>
                    </p:txBody>
                  </p:sp>
                </p:grpSp>
                <p:grpSp>
                  <p:nvGrpSpPr>
                    <p:cNvPr id="130" name="Group 96"/>
                    <p:cNvGrpSpPr/>
                    <p:nvPr/>
                  </p:nvGrpSpPr>
                  <p:grpSpPr>
                    <a:xfrm>
                      <a:off x="7091640" y="650880"/>
                      <a:ext cx="31680" cy="1347840"/>
                      <a:chOff x="7091640" y="650880"/>
                      <a:chExt cx="31680" cy="1347840"/>
                    </a:xfrm>
                  </p:grpSpPr>
                  <p:sp>
                    <p:nvSpPr>
                      <p:cNvPr id="131" name="Line 97"/>
                      <p:cNvSpPr/>
                      <p:nvPr/>
                    </p:nvSpPr>
                    <p:spPr>
                      <a:xfrm flipH="1">
                        <a:off x="7091640" y="1998000"/>
                        <a:ext cx="31320" cy="720"/>
                      </a:xfrm>
                      <a:prstGeom prst="line">
                        <a:avLst/>
                      </a:prstGeom>
                      <a:ln w="7920">
                        <a:solidFill>
                          <a:srgbClr val="000000"/>
                        </a:solidFill>
                        <a:miter/>
                      </a:ln>
                    </p:spPr>
                    <p:style>
                      <a:lnRef idx="0"/>
                      <a:fillRef idx="0"/>
                      <a:effectRef idx="0"/>
                      <a:fontRef idx="minor"/>
                    </p:style>
                    <p:txBody>
                      <a:bodyPr lIns="90000" rIns="90000" tIns="-46080" bIns="-46080" anchor="t">
                        <a:noAutofit/>
                      </a:bodyPr>
                      <a:p>
                        <a:endParaRPr b="0" lang="en-US" sz="2400" spc="-1" strike="noStrike">
                          <a:solidFill>
                            <a:srgbClr val="000000"/>
                          </a:solidFill>
                          <a:latin typeface="Arial"/>
                        </a:endParaRPr>
                      </a:p>
                    </p:txBody>
                  </p:sp>
                  <p:sp>
                    <p:nvSpPr>
                      <p:cNvPr id="132" name="Line 98"/>
                      <p:cNvSpPr/>
                      <p:nvPr/>
                    </p:nvSpPr>
                    <p:spPr>
                      <a:xfrm flipH="1">
                        <a:off x="7113240" y="1931760"/>
                        <a:ext cx="10080" cy="720"/>
                      </a:xfrm>
                      <a:prstGeom prst="line">
                        <a:avLst/>
                      </a:prstGeom>
                      <a:ln w="7920">
                        <a:solidFill>
                          <a:srgbClr val="000000"/>
                        </a:solidFill>
                        <a:miter/>
                      </a:ln>
                    </p:spPr>
                    <p:style>
                      <a:lnRef idx="0"/>
                      <a:fillRef idx="0"/>
                      <a:effectRef idx="0"/>
                      <a:fontRef idx="minor"/>
                    </p:style>
                    <p:txBody>
                      <a:bodyPr lIns="90000" rIns="90000" tIns="-46080" bIns="-46080" anchor="t">
                        <a:noAutofit/>
                      </a:bodyPr>
                      <a:p>
                        <a:endParaRPr b="0" lang="en-US" sz="2400" spc="-1" strike="noStrike">
                          <a:solidFill>
                            <a:srgbClr val="000000"/>
                          </a:solidFill>
                          <a:latin typeface="Arial"/>
                        </a:endParaRPr>
                      </a:p>
                    </p:txBody>
                  </p:sp>
                  <p:sp>
                    <p:nvSpPr>
                      <p:cNvPr id="133" name="Line 99"/>
                      <p:cNvSpPr/>
                      <p:nvPr/>
                    </p:nvSpPr>
                    <p:spPr>
                      <a:xfrm flipH="1">
                        <a:off x="7113240" y="1866600"/>
                        <a:ext cx="10080" cy="720"/>
                      </a:xfrm>
                      <a:prstGeom prst="line">
                        <a:avLst/>
                      </a:prstGeom>
                      <a:ln w="7920">
                        <a:solidFill>
                          <a:srgbClr val="000000"/>
                        </a:solidFill>
                        <a:miter/>
                      </a:ln>
                    </p:spPr>
                    <p:style>
                      <a:lnRef idx="0"/>
                      <a:fillRef idx="0"/>
                      <a:effectRef idx="0"/>
                      <a:fontRef idx="minor"/>
                    </p:style>
                    <p:txBody>
                      <a:bodyPr lIns="90000" rIns="90000" tIns="-46080" bIns="-46080" anchor="t">
                        <a:noAutofit/>
                      </a:bodyPr>
                      <a:p>
                        <a:endParaRPr b="0" lang="en-US" sz="2400" spc="-1" strike="noStrike">
                          <a:solidFill>
                            <a:srgbClr val="000000"/>
                          </a:solidFill>
                          <a:latin typeface="Arial"/>
                        </a:endParaRPr>
                      </a:p>
                    </p:txBody>
                  </p:sp>
                  <p:sp>
                    <p:nvSpPr>
                      <p:cNvPr id="134" name="Line 100"/>
                      <p:cNvSpPr/>
                      <p:nvPr/>
                    </p:nvSpPr>
                    <p:spPr>
                      <a:xfrm flipH="1">
                        <a:off x="7113240" y="1794600"/>
                        <a:ext cx="10080" cy="720"/>
                      </a:xfrm>
                      <a:prstGeom prst="line">
                        <a:avLst/>
                      </a:prstGeom>
                      <a:ln w="7920">
                        <a:solidFill>
                          <a:srgbClr val="000000"/>
                        </a:solidFill>
                        <a:miter/>
                      </a:ln>
                    </p:spPr>
                    <p:style>
                      <a:lnRef idx="0"/>
                      <a:fillRef idx="0"/>
                      <a:effectRef idx="0"/>
                      <a:fontRef idx="minor"/>
                    </p:style>
                    <p:txBody>
                      <a:bodyPr lIns="90000" rIns="90000" tIns="-46080" bIns="-46080" anchor="t">
                        <a:noAutofit/>
                      </a:bodyPr>
                      <a:p>
                        <a:endParaRPr b="0" lang="en-US" sz="2400" spc="-1" strike="noStrike">
                          <a:solidFill>
                            <a:srgbClr val="000000"/>
                          </a:solidFill>
                          <a:latin typeface="Arial"/>
                        </a:endParaRPr>
                      </a:p>
                    </p:txBody>
                  </p:sp>
                  <p:sp>
                    <p:nvSpPr>
                      <p:cNvPr id="135" name="Line 101"/>
                      <p:cNvSpPr/>
                      <p:nvPr/>
                    </p:nvSpPr>
                    <p:spPr>
                      <a:xfrm flipH="1">
                        <a:off x="7091640" y="1729440"/>
                        <a:ext cx="31320" cy="720"/>
                      </a:xfrm>
                      <a:prstGeom prst="line">
                        <a:avLst/>
                      </a:prstGeom>
                      <a:ln w="7920">
                        <a:solidFill>
                          <a:srgbClr val="000000"/>
                        </a:solidFill>
                        <a:miter/>
                      </a:ln>
                    </p:spPr>
                    <p:style>
                      <a:lnRef idx="0"/>
                      <a:fillRef idx="0"/>
                      <a:effectRef idx="0"/>
                      <a:fontRef idx="minor"/>
                    </p:style>
                    <p:txBody>
                      <a:bodyPr lIns="90000" rIns="90000" tIns="-46080" bIns="-46080" anchor="t">
                        <a:noAutofit/>
                      </a:bodyPr>
                      <a:p>
                        <a:endParaRPr b="0" lang="en-US" sz="2400" spc="-1" strike="noStrike">
                          <a:solidFill>
                            <a:srgbClr val="000000"/>
                          </a:solidFill>
                          <a:latin typeface="Arial"/>
                        </a:endParaRPr>
                      </a:p>
                    </p:txBody>
                  </p:sp>
                  <p:sp>
                    <p:nvSpPr>
                      <p:cNvPr id="136" name="Line 102"/>
                      <p:cNvSpPr/>
                      <p:nvPr/>
                    </p:nvSpPr>
                    <p:spPr>
                      <a:xfrm flipH="1">
                        <a:off x="7113240" y="1663200"/>
                        <a:ext cx="10080" cy="720"/>
                      </a:xfrm>
                      <a:prstGeom prst="line">
                        <a:avLst/>
                      </a:prstGeom>
                      <a:ln w="7920">
                        <a:solidFill>
                          <a:srgbClr val="000000"/>
                        </a:solidFill>
                        <a:miter/>
                      </a:ln>
                    </p:spPr>
                    <p:style>
                      <a:lnRef idx="0"/>
                      <a:fillRef idx="0"/>
                      <a:effectRef idx="0"/>
                      <a:fontRef idx="minor"/>
                    </p:style>
                    <p:txBody>
                      <a:bodyPr lIns="90000" rIns="90000" tIns="-46080" bIns="-46080" anchor="t">
                        <a:noAutofit/>
                      </a:bodyPr>
                      <a:p>
                        <a:endParaRPr b="0" lang="en-US" sz="2400" spc="-1" strike="noStrike">
                          <a:solidFill>
                            <a:srgbClr val="000000"/>
                          </a:solidFill>
                          <a:latin typeface="Arial"/>
                        </a:endParaRPr>
                      </a:p>
                    </p:txBody>
                  </p:sp>
                  <p:sp>
                    <p:nvSpPr>
                      <p:cNvPr id="137" name="Line 103"/>
                      <p:cNvSpPr/>
                      <p:nvPr/>
                    </p:nvSpPr>
                    <p:spPr>
                      <a:xfrm flipH="1">
                        <a:off x="7113240" y="1592280"/>
                        <a:ext cx="10080" cy="1080"/>
                      </a:xfrm>
                      <a:prstGeom prst="line">
                        <a:avLst/>
                      </a:prstGeom>
                      <a:ln w="7920">
                        <a:solidFill>
                          <a:srgbClr val="000000"/>
                        </a:solidFill>
                        <a:miter/>
                      </a:ln>
                    </p:spPr>
                    <p:style>
                      <a:lnRef idx="0"/>
                      <a:fillRef idx="0"/>
                      <a:effectRef idx="0"/>
                      <a:fontRef idx="minor"/>
                    </p:style>
                    <p:txBody>
                      <a:bodyPr lIns="90000" rIns="90000" tIns="-45720" bIns="-45720" anchor="t">
                        <a:noAutofit/>
                      </a:bodyPr>
                      <a:p>
                        <a:endParaRPr b="0" lang="en-US" sz="2400" spc="-1" strike="noStrike">
                          <a:solidFill>
                            <a:srgbClr val="000000"/>
                          </a:solidFill>
                          <a:latin typeface="Arial"/>
                        </a:endParaRPr>
                      </a:p>
                    </p:txBody>
                  </p:sp>
                  <p:sp>
                    <p:nvSpPr>
                      <p:cNvPr id="138" name="Line 104"/>
                      <p:cNvSpPr/>
                      <p:nvPr/>
                    </p:nvSpPr>
                    <p:spPr>
                      <a:xfrm flipH="1">
                        <a:off x="7113240" y="1527120"/>
                        <a:ext cx="10080" cy="720"/>
                      </a:xfrm>
                      <a:prstGeom prst="line">
                        <a:avLst/>
                      </a:prstGeom>
                      <a:ln w="7920">
                        <a:solidFill>
                          <a:srgbClr val="000000"/>
                        </a:solidFill>
                        <a:miter/>
                      </a:ln>
                    </p:spPr>
                    <p:style>
                      <a:lnRef idx="0"/>
                      <a:fillRef idx="0"/>
                      <a:effectRef idx="0"/>
                      <a:fontRef idx="minor"/>
                    </p:style>
                    <p:txBody>
                      <a:bodyPr lIns="90000" rIns="90000" tIns="-46080" bIns="-46080" anchor="t">
                        <a:noAutofit/>
                      </a:bodyPr>
                      <a:p>
                        <a:endParaRPr b="0" lang="en-US" sz="2400" spc="-1" strike="noStrike">
                          <a:solidFill>
                            <a:srgbClr val="000000"/>
                          </a:solidFill>
                          <a:latin typeface="Arial"/>
                        </a:endParaRPr>
                      </a:p>
                    </p:txBody>
                  </p:sp>
                  <p:sp>
                    <p:nvSpPr>
                      <p:cNvPr id="139" name="Line 105"/>
                      <p:cNvSpPr/>
                      <p:nvPr/>
                    </p:nvSpPr>
                    <p:spPr>
                      <a:xfrm flipH="1">
                        <a:off x="7091640" y="1460880"/>
                        <a:ext cx="31320" cy="1080"/>
                      </a:xfrm>
                      <a:prstGeom prst="line">
                        <a:avLst/>
                      </a:prstGeom>
                      <a:ln w="7920">
                        <a:solidFill>
                          <a:srgbClr val="000000"/>
                        </a:solidFill>
                        <a:miter/>
                      </a:ln>
                    </p:spPr>
                    <p:style>
                      <a:lnRef idx="0"/>
                      <a:fillRef idx="0"/>
                      <a:effectRef idx="0"/>
                      <a:fontRef idx="minor"/>
                    </p:style>
                    <p:txBody>
                      <a:bodyPr lIns="90000" rIns="90000" tIns="-45720" bIns="-45720" anchor="t">
                        <a:noAutofit/>
                      </a:bodyPr>
                      <a:p>
                        <a:endParaRPr b="0" lang="en-US" sz="2400" spc="-1" strike="noStrike">
                          <a:solidFill>
                            <a:srgbClr val="000000"/>
                          </a:solidFill>
                          <a:latin typeface="Arial"/>
                        </a:endParaRPr>
                      </a:p>
                    </p:txBody>
                  </p:sp>
                  <p:sp>
                    <p:nvSpPr>
                      <p:cNvPr id="140" name="Line 106"/>
                      <p:cNvSpPr/>
                      <p:nvPr/>
                    </p:nvSpPr>
                    <p:spPr>
                      <a:xfrm flipH="1">
                        <a:off x="7113240" y="1389960"/>
                        <a:ext cx="10080" cy="720"/>
                      </a:xfrm>
                      <a:prstGeom prst="line">
                        <a:avLst/>
                      </a:prstGeom>
                      <a:ln w="7920">
                        <a:solidFill>
                          <a:srgbClr val="000000"/>
                        </a:solidFill>
                        <a:miter/>
                      </a:ln>
                    </p:spPr>
                    <p:style>
                      <a:lnRef idx="0"/>
                      <a:fillRef idx="0"/>
                      <a:effectRef idx="0"/>
                      <a:fontRef idx="minor"/>
                    </p:style>
                    <p:txBody>
                      <a:bodyPr lIns="90000" rIns="90000" tIns="-46080" bIns="-46080" anchor="t">
                        <a:noAutofit/>
                      </a:bodyPr>
                      <a:p>
                        <a:endParaRPr b="0" lang="en-US" sz="2400" spc="-1" strike="noStrike">
                          <a:solidFill>
                            <a:srgbClr val="000000"/>
                          </a:solidFill>
                          <a:latin typeface="Arial"/>
                        </a:endParaRPr>
                      </a:p>
                    </p:txBody>
                  </p:sp>
                  <p:sp>
                    <p:nvSpPr>
                      <p:cNvPr id="141" name="Line 107"/>
                      <p:cNvSpPr/>
                      <p:nvPr/>
                    </p:nvSpPr>
                    <p:spPr>
                      <a:xfrm flipH="1">
                        <a:off x="7113240" y="1323720"/>
                        <a:ext cx="10080" cy="1080"/>
                      </a:xfrm>
                      <a:prstGeom prst="line">
                        <a:avLst/>
                      </a:prstGeom>
                      <a:ln w="7920">
                        <a:solidFill>
                          <a:srgbClr val="000000"/>
                        </a:solidFill>
                        <a:miter/>
                      </a:ln>
                    </p:spPr>
                    <p:style>
                      <a:lnRef idx="0"/>
                      <a:fillRef idx="0"/>
                      <a:effectRef idx="0"/>
                      <a:fontRef idx="minor"/>
                    </p:style>
                    <p:txBody>
                      <a:bodyPr lIns="90000" rIns="90000" tIns="-45720" bIns="-45720" anchor="t">
                        <a:noAutofit/>
                      </a:bodyPr>
                      <a:p>
                        <a:endParaRPr b="0" lang="en-US" sz="2400" spc="-1" strike="noStrike">
                          <a:solidFill>
                            <a:srgbClr val="000000"/>
                          </a:solidFill>
                          <a:latin typeface="Arial"/>
                        </a:endParaRPr>
                      </a:p>
                    </p:txBody>
                  </p:sp>
                  <p:sp>
                    <p:nvSpPr>
                      <p:cNvPr id="142" name="Line 108"/>
                      <p:cNvSpPr/>
                      <p:nvPr/>
                    </p:nvSpPr>
                    <p:spPr>
                      <a:xfrm flipH="1">
                        <a:off x="7113240" y="1258560"/>
                        <a:ext cx="10080" cy="720"/>
                      </a:xfrm>
                      <a:prstGeom prst="line">
                        <a:avLst/>
                      </a:prstGeom>
                      <a:ln w="7920">
                        <a:solidFill>
                          <a:srgbClr val="000000"/>
                        </a:solidFill>
                        <a:miter/>
                      </a:ln>
                    </p:spPr>
                    <p:style>
                      <a:lnRef idx="0"/>
                      <a:fillRef idx="0"/>
                      <a:effectRef idx="0"/>
                      <a:fontRef idx="minor"/>
                    </p:style>
                    <p:txBody>
                      <a:bodyPr lIns="90000" rIns="90000" tIns="-46080" bIns="-46080" anchor="t">
                        <a:noAutofit/>
                      </a:bodyPr>
                      <a:p>
                        <a:endParaRPr b="0" lang="en-US" sz="2400" spc="-1" strike="noStrike">
                          <a:solidFill>
                            <a:srgbClr val="000000"/>
                          </a:solidFill>
                          <a:latin typeface="Arial"/>
                        </a:endParaRPr>
                      </a:p>
                    </p:txBody>
                  </p:sp>
                  <p:sp>
                    <p:nvSpPr>
                      <p:cNvPr id="143" name="Line 109"/>
                      <p:cNvSpPr/>
                      <p:nvPr/>
                    </p:nvSpPr>
                    <p:spPr>
                      <a:xfrm flipH="1">
                        <a:off x="7091640" y="1186560"/>
                        <a:ext cx="31320" cy="720"/>
                      </a:xfrm>
                      <a:prstGeom prst="line">
                        <a:avLst/>
                      </a:prstGeom>
                      <a:ln w="7920">
                        <a:solidFill>
                          <a:srgbClr val="000000"/>
                        </a:solidFill>
                        <a:miter/>
                      </a:ln>
                    </p:spPr>
                    <p:style>
                      <a:lnRef idx="0"/>
                      <a:fillRef idx="0"/>
                      <a:effectRef idx="0"/>
                      <a:fontRef idx="minor"/>
                    </p:style>
                    <p:txBody>
                      <a:bodyPr lIns="90000" rIns="90000" tIns="-46080" bIns="-46080" anchor="t">
                        <a:noAutofit/>
                      </a:bodyPr>
                      <a:p>
                        <a:endParaRPr b="0" lang="en-US" sz="2400" spc="-1" strike="noStrike">
                          <a:solidFill>
                            <a:srgbClr val="000000"/>
                          </a:solidFill>
                          <a:latin typeface="Arial"/>
                        </a:endParaRPr>
                      </a:p>
                    </p:txBody>
                  </p:sp>
                  <p:sp>
                    <p:nvSpPr>
                      <p:cNvPr id="144" name="Line 110"/>
                      <p:cNvSpPr/>
                      <p:nvPr/>
                    </p:nvSpPr>
                    <p:spPr>
                      <a:xfrm flipH="1">
                        <a:off x="7113240" y="1121400"/>
                        <a:ext cx="10080" cy="720"/>
                      </a:xfrm>
                      <a:prstGeom prst="line">
                        <a:avLst/>
                      </a:prstGeom>
                      <a:ln w="7920">
                        <a:solidFill>
                          <a:srgbClr val="000000"/>
                        </a:solidFill>
                        <a:miter/>
                      </a:ln>
                    </p:spPr>
                    <p:style>
                      <a:lnRef idx="0"/>
                      <a:fillRef idx="0"/>
                      <a:effectRef idx="0"/>
                      <a:fontRef idx="minor"/>
                    </p:style>
                    <p:txBody>
                      <a:bodyPr lIns="90000" rIns="90000" tIns="-46080" bIns="-46080" anchor="t">
                        <a:noAutofit/>
                      </a:bodyPr>
                      <a:p>
                        <a:endParaRPr b="0" lang="en-US" sz="2400" spc="-1" strike="noStrike">
                          <a:solidFill>
                            <a:srgbClr val="000000"/>
                          </a:solidFill>
                          <a:latin typeface="Arial"/>
                        </a:endParaRPr>
                      </a:p>
                    </p:txBody>
                  </p:sp>
                  <p:sp>
                    <p:nvSpPr>
                      <p:cNvPr id="145" name="Line 111"/>
                      <p:cNvSpPr/>
                      <p:nvPr/>
                    </p:nvSpPr>
                    <p:spPr>
                      <a:xfrm flipH="1">
                        <a:off x="7113240" y="1055160"/>
                        <a:ext cx="10080" cy="720"/>
                      </a:xfrm>
                      <a:prstGeom prst="line">
                        <a:avLst/>
                      </a:prstGeom>
                      <a:ln w="7920">
                        <a:solidFill>
                          <a:srgbClr val="000000"/>
                        </a:solidFill>
                        <a:miter/>
                      </a:ln>
                    </p:spPr>
                    <p:style>
                      <a:lnRef idx="0"/>
                      <a:fillRef idx="0"/>
                      <a:effectRef idx="0"/>
                      <a:fontRef idx="minor"/>
                    </p:style>
                    <p:txBody>
                      <a:bodyPr lIns="90000" rIns="90000" tIns="-46080" bIns="-46080" anchor="t">
                        <a:noAutofit/>
                      </a:bodyPr>
                      <a:p>
                        <a:endParaRPr b="0" lang="en-US" sz="2400" spc="-1" strike="noStrike">
                          <a:solidFill>
                            <a:srgbClr val="000000"/>
                          </a:solidFill>
                          <a:latin typeface="Arial"/>
                        </a:endParaRPr>
                      </a:p>
                    </p:txBody>
                  </p:sp>
                  <p:sp>
                    <p:nvSpPr>
                      <p:cNvPr id="146" name="Line 112"/>
                      <p:cNvSpPr/>
                      <p:nvPr/>
                    </p:nvSpPr>
                    <p:spPr>
                      <a:xfrm flipH="1">
                        <a:off x="7113240" y="984240"/>
                        <a:ext cx="10080" cy="1080"/>
                      </a:xfrm>
                      <a:prstGeom prst="line">
                        <a:avLst/>
                      </a:prstGeom>
                      <a:ln w="7920">
                        <a:solidFill>
                          <a:srgbClr val="000000"/>
                        </a:solidFill>
                        <a:miter/>
                      </a:ln>
                    </p:spPr>
                    <p:style>
                      <a:lnRef idx="0"/>
                      <a:fillRef idx="0"/>
                      <a:effectRef idx="0"/>
                      <a:fontRef idx="minor"/>
                    </p:style>
                    <p:txBody>
                      <a:bodyPr lIns="90000" rIns="90000" tIns="-45720" bIns="-45720" anchor="t">
                        <a:noAutofit/>
                      </a:bodyPr>
                      <a:p>
                        <a:endParaRPr b="0" lang="en-US" sz="2400" spc="-1" strike="noStrike">
                          <a:solidFill>
                            <a:srgbClr val="000000"/>
                          </a:solidFill>
                          <a:latin typeface="Arial"/>
                        </a:endParaRPr>
                      </a:p>
                    </p:txBody>
                  </p:sp>
                  <p:sp>
                    <p:nvSpPr>
                      <p:cNvPr id="147" name="Line 113"/>
                      <p:cNvSpPr/>
                      <p:nvPr/>
                    </p:nvSpPr>
                    <p:spPr>
                      <a:xfrm flipH="1">
                        <a:off x="7091640" y="918000"/>
                        <a:ext cx="31320" cy="720"/>
                      </a:xfrm>
                      <a:prstGeom prst="line">
                        <a:avLst/>
                      </a:prstGeom>
                      <a:ln w="7920">
                        <a:solidFill>
                          <a:srgbClr val="000000"/>
                        </a:solidFill>
                        <a:miter/>
                      </a:ln>
                    </p:spPr>
                    <p:style>
                      <a:lnRef idx="0"/>
                      <a:fillRef idx="0"/>
                      <a:effectRef idx="0"/>
                      <a:fontRef idx="minor"/>
                    </p:style>
                    <p:txBody>
                      <a:bodyPr lIns="90000" rIns="90000" tIns="-46080" bIns="-46080" anchor="t">
                        <a:noAutofit/>
                      </a:bodyPr>
                      <a:p>
                        <a:endParaRPr b="0" lang="en-US" sz="2400" spc="-1" strike="noStrike">
                          <a:solidFill>
                            <a:srgbClr val="000000"/>
                          </a:solidFill>
                          <a:latin typeface="Arial"/>
                        </a:endParaRPr>
                      </a:p>
                    </p:txBody>
                  </p:sp>
                  <p:sp>
                    <p:nvSpPr>
                      <p:cNvPr id="148" name="Line 114"/>
                      <p:cNvSpPr/>
                      <p:nvPr/>
                    </p:nvSpPr>
                    <p:spPr>
                      <a:xfrm flipH="1">
                        <a:off x="7113240" y="852840"/>
                        <a:ext cx="10080" cy="1080"/>
                      </a:xfrm>
                      <a:prstGeom prst="line">
                        <a:avLst/>
                      </a:prstGeom>
                      <a:ln w="7920">
                        <a:solidFill>
                          <a:srgbClr val="000000"/>
                        </a:solidFill>
                        <a:miter/>
                      </a:ln>
                    </p:spPr>
                    <p:style>
                      <a:lnRef idx="0"/>
                      <a:fillRef idx="0"/>
                      <a:effectRef idx="0"/>
                      <a:fontRef idx="minor"/>
                    </p:style>
                    <p:txBody>
                      <a:bodyPr lIns="90000" rIns="90000" tIns="-45720" bIns="-45720" anchor="t">
                        <a:noAutofit/>
                      </a:bodyPr>
                      <a:p>
                        <a:endParaRPr b="0" lang="en-US" sz="2400" spc="-1" strike="noStrike">
                          <a:solidFill>
                            <a:srgbClr val="000000"/>
                          </a:solidFill>
                          <a:latin typeface="Arial"/>
                        </a:endParaRPr>
                      </a:p>
                    </p:txBody>
                  </p:sp>
                  <p:sp>
                    <p:nvSpPr>
                      <p:cNvPr id="149" name="Line 115"/>
                      <p:cNvSpPr/>
                      <p:nvPr/>
                    </p:nvSpPr>
                    <p:spPr>
                      <a:xfrm flipH="1">
                        <a:off x="7113240" y="781920"/>
                        <a:ext cx="10080" cy="720"/>
                      </a:xfrm>
                      <a:prstGeom prst="line">
                        <a:avLst/>
                      </a:prstGeom>
                      <a:ln w="7920">
                        <a:solidFill>
                          <a:srgbClr val="000000"/>
                        </a:solidFill>
                        <a:miter/>
                      </a:ln>
                    </p:spPr>
                    <p:style>
                      <a:lnRef idx="0"/>
                      <a:fillRef idx="0"/>
                      <a:effectRef idx="0"/>
                      <a:fontRef idx="minor"/>
                    </p:style>
                    <p:txBody>
                      <a:bodyPr lIns="90000" rIns="90000" tIns="-46080" bIns="-46080" anchor="t">
                        <a:noAutofit/>
                      </a:bodyPr>
                      <a:p>
                        <a:endParaRPr b="0" lang="en-US" sz="2400" spc="-1" strike="noStrike">
                          <a:solidFill>
                            <a:srgbClr val="000000"/>
                          </a:solidFill>
                          <a:latin typeface="Arial"/>
                        </a:endParaRPr>
                      </a:p>
                    </p:txBody>
                  </p:sp>
                  <p:sp>
                    <p:nvSpPr>
                      <p:cNvPr id="150" name="Line 116"/>
                      <p:cNvSpPr/>
                      <p:nvPr/>
                    </p:nvSpPr>
                    <p:spPr>
                      <a:xfrm flipH="1">
                        <a:off x="7113240" y="715680"/>
                        <a:ext cx="10080" cy="1080"/>
                      </a:xfrm>
                      <a:prstGeom prst="line">
                        <a:avLst/>
                      </a:prstGeom>
                      <a:ln w="7920">
                        <a:solidFill>
                          <a:srgbClr val="000000"/>
                        </a:solidFill>
                        <a:miter/>
                      </a:ln>
                    </p:spPr>
                    <p:style>
                      <a:lnRef idx="0"/>
                      <a:fillRef idx="0"/>
                      <a:effectRef idx="0"/>
                      <a:fontRef idx="minor"/>
                    </p:style>
                    <p:txBody>
                      <a:bodyPr lIns="90000" rIns="90000" tIns="-45720" bIns="-45720" anchor="t">
                        <a:noAutofit/>
                      </a:bodyPr>
                      <a:p>
                        <a:endParaRPr b="0" lang="en-US" sz="2400" spc="-1" strike="noStrike">
                          <a:solidFill>
                            <a:srgbClr val="000000"/>
                          </a:solidFill>
                          <a:latin typeface="Arial"/>
                        </a:endParaRPr>
                      </a:p>
                    </p:txBody>
                  </p:sp>
                  <p:sp>
                    <p:nvSpPr>
                      <p:cNvPr id="151" name="Line 117"/>
                      <p:cNvSpPr/>
                      <p:nvPr/>
                    </p:nvSpPr>
                    <p:spPr>
                      <a:xfrm flipH="1">
                        <a:off x="7091640" y="650880"/>
                        <a:ext cx="31320" cy="720"/>
                      </a:xfrm>
                      <a:prstGeom prst="line">
                        <a:avLst/>
                      </a:prstGeom>
                      <a:ln w="7920">
                        <a:solidFill>
                          <a:srgbClr val="000000"/>
                        </a:solidFill>
                        <a:miter/>
                      </a:ln>
                    </p:spPr>
                    <p:style>
                      <a:lnRef idx="0"/>
                      <a:fillRef idx="0"/>
                      <a:effectRef idx="0"/>
                      <a:fontRef idx="minor"/>
                    </p:style>
                    <p:txBody>
                      <a:bodyPr lIns="90000" rIns="90000" tIns="-46080" bIns="-46080" anchor="t">
                        <a:noAutofit/>
                      </a:bodyPr>
                      <a:p>
                        <a:endParaRPr b="0" lang="en-US" sz="2400" spc="-1" strike="noStrike">
                          <a:solidFill>
                            <a:srgbClr val="000000"/>
                          </a:solidFill>
                          <a:latin typeface="Arial"/>
                        </a:endParaRPr>
                      </a:p>
                    </p:txBody>
                  </p:sp>
                </p:grpSp>
                <p:sp>
                  <p:nvSpPr>
                    <p:cNvPr id="152" name="Rectangle 118"/>
                    <p:cNvSpPr/>
                    <p:nvPr/>
                  </p:nvSpPr>
                  <p:spPr>
                    <a:xfrm rot="16200000">
                      <a:off x="6423120" y="1223640"/>
                      <a:ext cx="662040" cy="18288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% of Max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53" name="Freeform 119"/>
                    <p:cNvSpPr/>
                    <p:nvPr/>
                  </p:nvSpPr>
                  <p:spPr>
                    <a:xfrm>
                      <a:off x="7136280" y="667800"/>
                      <a:ext cx="1390680" cy="1325160"/>
                    </a:xfrm>
                    <a:prstGeom prst="pie">
                      <a:avLst/>
                    </a:prstGeom>
                    <a:noFill/>
                    <a:ln w="7920">
                      <a:solidFill>
                        <a:srgbClr val="000000"/>
                      </a:solidFill>
                      <a:round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54" name="Freeform 120"/>
                    <p:cNvSpPr/>
                    <p:nvPr/>
                  </p:nvSpPr>
                  <p:spPr>
                    <a:xfrm>
                      <a:off x="7136280" y="667800"/>
                      <a:ext cx="1396080" cy="1325160"/>
                    </a:xfrm>
                    <a:prstGeom prst="pie">
                      <a:avLst/>
                    </a:prstGeom>
                    <a:solidFill>
                      <a:srgbClr val="c0c0c0"/>
                    </a:solidFill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55" name="Freeform 121"/>
                    <p:cNvSpPr/>
                    <p:nvPr/>
                  </p:nvSpPr>
                  <p:spPr>
                    <a:xfrm>
                      <a:off x="7136280" y="667800"/>
                      <a:ext cx="1390680" cy="1325160"/>
                    </a:xfrm>
                    <a:prstGeom prst="pie">
                      <a:avLst/>
                    </a:prstGeom>
                    <a:noFill/>
                    <a:ln w="7920">
                      <a:solidFill>
                        <a:srgbClr val="333333"/>
                      </a:solidFill>
                      <a:round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56" name="Text Box 123"/>
                    <p:cNvSpPr/>
                    <p:nvPr/>
                  </p:nvSpPr>
                  <p:spPr>
                    <a:xfrm>
                      <a:off x="7728840" y="646920"/>
                      <a:ext cx="522000" cy="27648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90000" rIns="90000" tIns="46800" bIns="46800" anchor="t">
                      <a:spAutoFit/>
                    </a:bodyPr>
                    <a:p>
                      <a:pPr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845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</p:grpSp>
              <p:sp>
                <p:nvSpPr>
                  <p:cNvPr id="157" name="Line 308"/>
                  <p:cNvSpPr/>
                  <p:nvPr/>
                </p:nvSpPr>
                <p:spPr>
                  <a:xfrm>
                    <a:off x="7454880" y="2335680"/>
                    <a:ext cx="1054440" cy="0"/>
                  </a:xfrm>
                  <a:prstGeom prst="line">
                    <a:avLst/>
                  </a:prstGeom>
                  <a:ln w="12600">
                    <a:solidFill>
                      <a:srgbClr val="000000"/>
                    </a:solidFill>
                    <a:miter/>
                    <a:tailEnd len="med" type="triangle" w="med"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ctr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sp>
              <p:nvSpPr>
                <p:cNvPr id="158" name="Text Box 126"/>
                <p:cNvSpPr/>
                <p:nvPr/>
              </p:nvSpPr>
              <p:spPr>
                <a:xfrm>
                  <a:off x="6932160" y="4438080"/>
                  <a:ext cx="537480" cy="2613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1" lang="en-US" sz="1100" spc="-1" strike="noStrike">
                      <a:solidFill>
                        <a:srgbClr val="000000"/>
                      </a:solidFill>
                      <a:latin typeface="Arial"/>
                    </a:rPr>
                    <a:t>CD81</a:t>
                  </a:r>
                  <a:endParaRPr b="0" lang="en-US" sz="11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grpSp>
              <p:nvGrpSpPr>
                <p:cNvPr id="159" name="Group 288"/>
                <p:cNvGrpSpPr/>
                <p:nvPr/>
              </p:nvGrpSpPr>
              <p:grpSpPr>
                <a:xfrm>
                  <a:off x="6661080" y="2758320"/>
                  <a:ext cx="2024640" cy="1674720"/>
                  <a:chOff x="6661080" y="2758320"/>
                  <a:chExt cx="2024640" cy="1674720"/>
                </a:xfrm>
              </p:grpSpPr>
              <p:sp>
                <p:nvSpPr>
                  <p:cNvPr id="160" name="Rectangle 127"/>
                  <p:cNvSpPr/>
                  <p:nvPr/>
                </p:nvSpPr>
                <p:spPr>
                  <a:xfrm>
                    <a:off x="7142040" y="2787120"/>
                    <a:ext cx="1416600" cy="1419840"/>
                  </a:xfrm>
                  <a:prstGeom prst="rect">
                    <a:avLst/>
                  </a:prstGeom>
                  <a:solidFill>
                    <a:srgbClr val="ffffff"/>
                  </a:solidFill>
                  <a:ln w="792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457200"/>
                        <a:tab algn="l" pos="914400"/>
                        <a:tab algn="l" pos="1371600"/>
                        <a:tab algn="l" pos="1828800"/>
                        <a:tab algn="l" pos="2286000"/>
                        <a:tab algn="l" pos="2743200"/>
                        <a:tab algn="l" pos="3200400"/>
                        <a:tab algn="l" pos="3657600"/>
                        <a:tab algn="l" pos="4114800"/>
                        <a:tab algn="l" pos="4572000"/>
                        <a:tab algn="l" pos="5029200"/>
                        <a:tab algn="l" pos="5486400"/>
                        <a:tab algn="l" pos="5943600"/>
                        <a:tab algn="l" pos="6400800"/>
                        <a:tab algn="l" pos="6858000"/>
                        <a:tab algn="l" pos="7315200"/>
                        <a:tab algn="l" pos="7772400"/>
                        <a:tab algn="l" pos="8229600"/>
                        <a:tab algn="l" pos="8686800"/>
                        <a:tab algn="l" pos="9144000"/>
                      </a:tabLst>
                    </a:pPr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61" name="Freeform 128"/>
                  <p:cNvSpPr/>
                  <p:nvPr/>
                </p:nvSpPr>
                <p:spPr>
                  <a:xfrm>
                    <a:off x="7153200" y="2870280"/>
                    <a:ext cx="1389600" cy="1325520"/>
                  </a:xfrm>
                  <a:prstGeom prst="pie">
                    <a:avLst/>
                  </a:prstGeom>
                  <a:noFill/>
                  <a:ln w="792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457200"/>
                        <a:tab algn="l" pos="914400"/>
                        <a:tab algn="l" pos="1371600"/>
                        <a:tab algn="l" pos="1828800"/>
                        <a:tab algn="l" pos="2286000"/>
                        <a:tab algn="l" pos="2743200"/>
                        <a:tab algn="l" pos="3200400"/>
                        <a:tab algn="l" pos="3657600"/>
                        <a:tab algn="l" pos="4114800"/>
                        <a:tab algn="l" pos="4572000"/>
                        <a:tab algn="l" pos="5029200"/>
                        <a:tab algn="l" pos="5486400"/>
                        <a:tab algn="l" pos="5943600"/>
                        <a:tab algn="l" pos="6400800"/>
                        <a:tab algn="l" pos="6858000"/>
                        <a:tab algn="l" pos="7315200"/>
                        <a:tab algn="l" pos="7772400"/>
                        <a:tab algn="l" pos="8229600"/>
                        <a:tab algn="l" pos="8686800"/>
                        <a:tab algn="l" pos="9144000"/>
                      </a:tabLst>
                    </a:pPr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62" name="Line 129"/>
                  <p:cNvSpPr/>
                  <p:nvPr/>
                </p:nvSpPr>
                <p:spPr>
                  <a:xfrm>
                    <a:off x="7142040" y="4201560"/>
                    <a:ext cx="1411200" cy="1080"/>
                  </a:xfrm>
                  <a:prstGeom prst="line">
                    <a:avLst/>
                  </a:prstGeom>
                  <a:ln w="792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720" bIns="-4572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grpSp>
                <p:nvGrpSpPr>
                  <p:cNvPr id="163" name="Group 130"/>
                  <p:cNvGrpSpPr/>
                  <p:nvPr/>
                </p:nvGrpSpPr>
                <p:grpSpPr>
                  <a:xfrm>
                    <a:off x="7141680" y="4207320"/>
                    <a:ext cx="1411920" cy="31320"/>
                    <a:chOff x="7141680" y="4207320"/>
                    <a:chExt cx="1411920" cy="31320"/>
                  </a:xfrm>
                </p:grpSpPr>
                <p:sp>
                  <p:nvSpPr>
                    <p:cNvPr id="164" name="Line 131"/>
                    <p:cNvSpPr/>
                    <p:nvPr/>
                  </p:nvSpPr>
                  <p:spPr>
                    <a:xfrm>
                      <a:off x="7141680" y="4207320"/>
                      <a:ext cx="720" cy="31320"/>
                    </a:xfrm>
                    <a:prstGeom prst="line">
                      <a:avLst/>
                    </a:prstGeom>
                    <a:ln w="792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15480" bIns="-1548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65" name="Line 132"/>
                    <p:cNvSpPr/>
                    <p:nvPr/>
                  </p:nvSpPr>
                  <p:spPr>
                    <a:xfrm>
                      <a:off x="7245360" y="4207320"/>
                      <a:ext cx="1080" cy="10080"/>
                    </a:xfrm>
                    <a:prstGeom prst="line">
                      <a:avLst/>
                    </a:prstGeom>
                    <a:ln w="792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6720" bIns="-3672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66" name="Line 133"/>
                    <p:cNvSpPr/>
                    <p:nvPr/>
                  </p:nvSpPr>
                  <p:spPr>
                    <a:xfrm>
                      <a:off x="7305840" y="4207320"/>
                      <a:ext cx="720" cy="10080"/>
                    </a:xfrm>
                    <a:prstGeom prst="line">
                      <a:avLst/>
                    </a:prstGeom>
                    <a:ln w="792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6720" bIns="-3672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67" name="Line 134"/>
                    <p:cNvSpPr/>
                    <p:nvPr/>
                  </p:nvSpPr>
                  <p:spPr>
                    <a:xfrm>
                      <a:off x="7350120" y="4207320"/>
                      <a:ext cx="720" cy="10080"/>
                    </a:xfrm>
                    <a:prstGeom prst="line">
                      <a:avLst/>
                    </a:prstGeom>
                    <a:ln w="792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6720" bIns="-3672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68" name="Line 135"/>
                    <p:cNvSpPr/>
                    <p:nvPr/>
                  </p:nvSpPr>
                  <p:spPr>
                    <a:xfrm>
                      <a:off x="7387920" y="4207320"/>
                      <a:ext cx="1080" cy="21240"/>
                    </a:xfrm>
                    <a:prstGeom prst="line">
                      <a:avLst/>
                    </a:prstGeom>
                    <a:ln w="792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25560" bIns="-2556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69" name="Line 136"/>
                    <p:cNvSpPr/>
                    <p:nvPr/>
                  </p:nvSpPr>
                  <p:spPr>
                    <a:xfrm>
                      <a:off x="7415280" y="4207320"/>
                      <a:ext cx="1080" cy="10080"/>
                    </a:xfrm>
                    <a:prstGeom prst="line">
                      <a:avLst/>
                    </a:prstGeom>
                    <a:ln w="792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6720" bIns="-3672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70" name="Line 137"/>
                    <p:cNvSpPr/>
                    <p:nvPr/>
                  </p:nvSpPr>
                  <p:spPr>
                    <a:xfrm>
                      <a:off x="7436880" y="4207320"/>
                      <a:ext cx="720" cy="10080"/>
                    </a:xfrm>
                    <a:prstGeom prst="line">
                      <a:avLst/>
                    </a:prstGeom>
                    <a:ln w="792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6720" bIns="-3672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71" name="Line 138"/>
                    <p:cNvSpPr/>
                    <p:nvPr/>
                  </p:nvSpPr>
                  <p:spPr>
                    <a:xfrm>
                      <a:off x="7458840" y="4207320"/>
                      <a:ext cx="720" cy="10080"/>
                    </a:xfrm>
                    <a:prstGeom prst="line">
                      <a:avLst/>
                    </a:prstGeom>
                    <a:ln w="792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6720" bIns="-3672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72" name="Line 139"/>
                    <p:cNvSpPr/>
                    <p:nvPr/>
                  </p:nvSpPr>
                  <p:spPr>
                    <a:xfrm>
                      <a:off x="7475760" y="4207320"/>
                      <a:ext cx="720" cy="10080"/>
                    </a:xfrm>
                    <a:prstGeom prst="line">
                      <a:avLst/>
                    </a:prstGeom>
                    <a:ln w="792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6720" bIns="-3672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73" name="Line 140"/>
                    <p:cNvSpPr/>
                    <p:nvPr/>
                  </p:nvSpPr>
                  <p:spPr>
                    <a:xfrm>
                      <a:off x="7491960" y="4207320"/>
                      <a:ext cx="720" cy="31320"/>
                    </a:xfrm>
                    <a:prstGeom prst="line">
                      <a:avLst/>
                    </a:prstGeom>
                    <a:ln w="792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15480" bIns="-1548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74" name="Line 141"/>
                    <p:cNvSpPr/>
                    <p:nvPr/>
                  </p:nvSpPr>
                  <p:spPr>
                    <a:xfrm>
                      <a:off x="7601400" y="4207320"/>
                      <a:ext cx="720" cy="10080"/>
                    </a:xfrm>
                    <a:prstGeom prst="line">
                      <a:avLst/>
                    </a:prstGeom>
                    <a:ln w="792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6720" bIns="-3672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75" name="Line 142"/>
                    <p:cNvSpPr/>
                    <p:nvPr/>
                  </p:nvSpPr>
                  <p:spPr>
                    <a:xfrm>
                      <a:off x="7661880" y="4207320"/>
                      <a:ext cx="720" cy="10080"/>
                    </a:xfrm>
                    <a:prstGeom prst="line">
                      <a:avLst/>
                    </a:prstGeom>
                    <a:ln w="792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6720" bIns="-3672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76" name="Line 143"/>
                    <p:cNvSpPr/>
                    <p:nvPr/>
                  </p:nvSpPr>
                  <p:spPr>
                    <a:xfrm>
                      <a:off x="7705080" y="4207320"/>
                      <a:ext cx="1080" cy="10080"/>
                    </a:xfrm>
                    <a:prstGeom prst="line">
                      <a:avLst/>
                    </a:prstGeom>
                    <a:ln w="792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6720" bIns="-3672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77" name="Line 144"/>
                    <p:cNvSpPr/>
                    <p:nvPr/>
                  </p:nvSpPr>
                  <p:spPr>
                    <a:xfrm>
                      <a:off x="7738200" y="4207320"/>
                      <a:ext cx="1080" cy="21240"/>
                    </a:xfrm>
                    <a:prstGeom prst="line">
                      <a:avLst/>
                    </a:prstGeom>
                    <a:ln w="792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25560" bIns="-2556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78" name="Line 145"/>
                    <p:cNvSpPr/>
                    <p:nvPr/>
                  </p:nvSpPr>
                  <p:spPr>
                    <a:xfrm>
                      <a:off x="7771320" y="4207320"/>
                      <a:ext cx="720" cy="10080"/>
                    </a:xfrm>
                    <a:prstGeom prst="line">
                      <a:avLst/>
                    </a:prstGeom>
                    <a:ln w="792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6720" bIns="-3672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79" name="Line 146"/>
                    <p:cNvSpPr/>
                    <p:nvPr/>
                  </p:nvSpPr>
                  <p:spPr>
                    <a:xfrm>
                      <a:off x="7792920" y="4207320"/>
                      <a:ext cx="720" cy="10080"/>
                    </a:xfrm>
                    <a:prstGeom prst="line">
                      <a:avLst/>
                    </a:prstGeom>
                    <a:ln w="792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6720" bIns="-3672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80" name="Line 147"/>
                    <p:cNvSpPr/>
                    <p:nvPr/>
                  </p:nvSpPr>
                  <p:spPr>
                    <a:xfrm>
                      <a:off x="7814880" y="4207320"/>
                      <a:ext cx="720" cy="10080"/>
                    </a:xfrm>
                    <a:prstGeom prst="line">
                      <a:avLst/>
                    </a:prstGeom>
                    <a:ln w="792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6720" bIns="-3672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81" name="Line 148"/>
                    <p:cNvSpPr/>
                    <p:nvPr/>
                  </p:nvSpPr>
                  <p:spPr>
                    <a:xfrm>
                      <a:off x="7831800" y="4207320"/>
                      <a:ext cx="720" cy="10080"/>
                    </a:xfrm>
                    <a:prstGeom prst="line">
                      <a:avLst/>
                    </a:prstGeom>
                    <a:ln w="792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6720" bIns="-3672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82" name="Line 149"/>
                    <p:cNvSpPr/>
                    <p:nvPr/>
                  </p:nvSpPr>
                  <p:spPr>
                    <a:xfrm>
                      <a:off x="7847640" y="4207320"/>
                      <a:ext cx="1080" cy="31320"/>
                    </a:xfrm>
                    <a:prstGeom prst="line">
                      <a:avLst/>
                    </a:prstGeom>
                    <a:ln w="792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15480" bIns="-1548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83" name="Line 150"/>
                    <p:cNvSpPr/>
                    <p:nvPr/>
                  </p:nvSpPr>
                  <p:spPr>
                    <a:xfrm>
                      <a:off x="7951680" y="4207320"/>
                      <a:ext cx="720" cy="10080"/>
                    </a:xfrm>
                    <a:prstGeom prst="line">
                      <a:avLst/>
                    </a:prstGeom>
                    <a:ln w="792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6720" bIns="-3672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84" name="Line 151"/>
                    <p:cNvSpPr/>
                    <p:nvPr/>
                  </p:nvSpPr>
                  <p:spPr>
                    <a:xfrm>
                      <a:off x="8017920" y="4207320"/>
                      <a:ext cx="720" cy="10080"/>
                    </a:xfrm>
                    <a:prstGeom prst="line">
                      <a:avLst/>
                    </a:prstGeom>
                    <a:ln w="792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6720" bIns="-3672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85" name="Line 152"/>
                    <p:cNvSpPr/>
                    <p:nvPr/>
                  </p:nvSpPr>
                  <p:spPr>
                    <a:xfrm>
                      <a:off x="8061120" y="4207320"/>
                      <a:ext cx="1080" cy="10080"/>
                    </a:xfrm>
                    <a:prstGeom prst="line">
                      <a:avLst/>
                    </a:prstGeom>
                    <a:ln w="792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6720" bIns="-3672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86" name="Line 153"/>
                    <p:cNvSpPr/>
                    <p:nvPr/>
                  </p:nvSpPr>
                  <p:spPr>
                    <a:xfrm>
                      <a:off x="8094240" y="4207320"/>
                      <a:ext cx="720" cy="21240"/>
                    </a:xfrm>
                    <a:prstGeom prst="line">
                      <a:avLst/>
                    </a:prstGeom>
                    <a:ln w="792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25560" bIns="-2556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87" name="Line 154"/>
                    <p:cNvSpPr/>
                    <p:nvPr/>
                  </p:nvSpPr>
                  <p:spPr>
                    <a:xfrm>
                      <a:off x="8121600" y="4207320"/>
                      <a:ext cx="720" cy="10080"/>
                    </a:xfrm>
                    <a:prstGeom prst="line">
                      <a:avLst/>
                    </a:prstGeom>
                    <a:ln w="792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6720" bIns="-3672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88" name="Line 155"/>
                    <p:cNvSpPr/>
                    <p:nvPr/>
                  </p:nvSpPr>
                  <p:spPr>
                    <a:xfrm>
                      <a:off x="8148960" y="4207320"/>
                      <a:ext cx="720" cy="10080"/>
                    </a:xfrm>
                    <a:prstGeom prst="line">
                      <a:avLst/>
                    </a:prstGeom>
                    <a:ln w="792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6720" bIns="-3672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89" name="Line 156"/>
                    <p:cNvSpPr/>
                    <p:nvPr/>
                  </p:nvSpPr>
                  <p:spPr>
                    <a:xfrm>
                      <a:off x="8164800" y="4207320"/>
                      <a:ext cx="1080" cy="10080"/>
                    </a:xfrm>
                    <a:prstGeom prst="line">
                      <a:avLst/>
                    </a:prstGeom>
                    <a:ln w="792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6720" bIns="-3672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90" name="Line 157"/>
                    <p:cNvSpPr/>
                    <p:nvPr/>
                  </p:nvSpPr>
                  <p:spPr>
                    <a:xfrm>
                      <a:off x="8186400" y="4207320"/>
                      <a:ext cx="1080" cy="10080"/>
                    </a:xfrm>
                    <a:prstGeom prst="line">
                      <a:avLst/>
                    </a:prstGeom>
                    <a:ln w="792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6720" bIns="-3672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91" name="Line 158"/>
                    <p:cNvSpPr/>
                    <p:nvPr/>
                  </p:nvSpPr>
                  <p:spPr>
                    <a:xfrm>
                      <a:off x="8203680" y="4207320"/>
                      <a:ext cx="1080" cy="31320"/>
                    </a:xfrm>
                    <a:prstGeom prst="line">
                      <a:avLst/>
                    </a:prstGeom>
                    <a:ln w="792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15480" bIns="-1548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92" name="Line 159"/>
                    <p:cNvSpPr/>
                    <p:nvPr/>
                  </p:nvSpPr>
                  <p:spPr>
                    <a:xfrm>
                      <a:off x="8307720" y="4207320"/>
                      <a:ext cx="720" cy="10080"/>
                    </a:xfrm>
                    <a:prstGeom prst="line">
                      <a:avLst/>
                    </a:prstGeom>
                    <a:ln w="792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6720" bIns="-3672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93" name="Line 160"/>
                    <p:cNvSpPr/>
                    <p:nvPr/>
                  </p:nvSpPr>
                  <p:spPr>
                    <a:xfrm>
                      <a:off x="8372520" y="4207320"/>
                      <a:ext cx="720" cy="10080"/>
                    </a:xfrm>
                    <a:prstGeom prst="line">
                      <a:avLst/>
                    </a:prstGeom>
                    <a:ln w="792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6720" bIns="-3672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94" name="Line 161"/>
                    <p:cNvSpPr/>
                    <p:nvPr/>
                  </p:nvSpPr>
                  <p:spPr>
                    <a:xfrm>
                      <a:off x="8417160" y="4207320"/>
                      <a:ext cx="720" cy="10080"/>
                    </a:xfrm>
                    <a:prstGeom prst="line">
                      <a:avLst/>
                    </a:prstGeom>
                    <a:ln w="792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6720" bIns="-3672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95" name="Line 162"/>
                    <p:cNvSpPr/>
                    <p:nvPr/>
                  </p:nvSpPr>
                  <p:spPr>
                    <a:xfrm>
                      <a:off x="8448840" y="4207320"/>
                      <a:ext cx="1080" cy="21240"/>
                    </a:xfrm>
                    <a:prstGeom prst="line">
                      <a:avLst/>
                    </a:prstGeom>
                    <a:ln w="792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25560" bIns="-2556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96" name="Line 163"/>
                    <p:cNvSpPr/>
                    <p:nvPr/>
                  </p:nvSpPr>
                  <p:spPr>
                    <a:xfrm>
                      <a:off x="8476200" y="4207320"/>
                      <a:ext cx="1080" cy="10080"/>
                    </a:xfrm>
                    <a:prstGeom prst="line">
                      <a:avLst/>
                    </a:prstGeom>
                    <a:ln w="792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6720" bIns="-3672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97" name="Line 164"/>
                    <p:cNvSpPr/>
                    <p:nvPr/>
                  </p:nvSpPr>
                  <p:spPr>
                    <a:xfrm>
                      <a:off x="8498880" y="4207320"/>
                      <a:ext cx="1080" cy="10080"/>
                    </a:xfrm>
                    <a:prstGeom prst="line">
                      <a:avLst/>
                    </a:prstGeom>
                    <a:ln w="792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6720" bIns="-3672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98" name="Line 165"/>
                    <p:cNvSpPr/>
                    <p:nvPr/>
                  </p:nvSpPr>
                  <p:spPr>
                    <a:xfrm>
                      <a:off x="8520840" y="4207320"/>
                      <a:ext cx="1080" cy="10080"/>
                    </a:xfrm>
                    <a:prstGeom prst="line">
                      <a:avLst/>
                    </a:prstGeom>
                    <a:ln w="792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6720" bIns="-3672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99" name="Line 166"/>
                    <p:cNvSpPr/>
                    <p:nvPr/>
                  </p:nvSpPr>
                  <p:spPr>
                    <a:xfrm>
                      <a:off x="8536680" y="4207320"/>
                      <a:ext cx="720" cy="10080"/>
                    </a:xfrm>
                    <a:prstGeom prst="line">
                      <a:avLst/>
                    </a:prstGeom>
                    <a:ln w="792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6720" bIns="-3672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00" name="Line 167"/>
                    <p:cNvSpPr/>
                    <p:nvPr/>
                  </p:nvSpPr>
                  <p:spPr>
                    <a:xfrm>
                      <a:off x="8552880" y="4207320"/>
                      <a:ext cx="720" cy="31320"/>
                    </a:xfrm>
                    <a:prstGeom prst="line">
                      <a:avLst/>
                    </a:prstGeom>
                    <a:ln w="792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15480" bIns="-1548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</p:grpSp>
              <p:grpSp>
                <p:nvGrpSpPr>
                  <p:cNvPr id="201" name="Group 299"/>
                  <p:cNvGrpSpPr/>
                  <p:nvPr/>
                </p:nvGrpSpPr>
                <p:grpSpPr>
                  <a:xfrm>
                    <a:off x="7092360" y="4280400"/>
                    <a:ext cx="1593360" cy="152640"/>
                    <a:chOff x="7092360" y="4280400"/>
                    <a:chExt cx="1593360" cy="152640"/>
                  </a:xfrm>
                </p:grpSpPr>
                <p:sp>
                  <p:nvSpPr>
                    <p:cNvPr id="202" name="Rectangle 169"/>
                    <p:cNvSpPr/>
                    <p:nvPr/>
                  </p:nvSpPr>
                  <p:spPr>
                    <a:xfrm>
                      <a:off x="7092360" y="4280400"/>
                      <a:ext cx="181800" cy="15264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0</a:t>
                      </a:r>
                      <a:r>
                        <a:rPr b="1" lang="en-US" sz="1000" spc="-1" strike="noStrike" baseline="30000">
                          <a:solidFill>
                            <a:srgbClr val="000000"/>
                          </a:solidFill>
                          <a:latin typeface="Arial"/>
                        </a:rPr>
                        <a:t>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03" name="Rectangle 171"/>
                    <p:cNvSpPr/>
                    <p:nvPr/>
                  </p:nvSpPr>
                  <p:spPr>
                    <a:xfrm>
                      <a:off x="7442640" y="4280400"/>
                      <a:ext cx="181800" cy="15264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0</a:t>
                      </a:r>
                      <a:r>
                        <a:rPr b="1" lang="en-US" sz="1000" spc="-1" strike="noStrike" baseline="30000">
                          <a:solidFill>
                            <a:srgbClr val="000000"/>
                          </a:solidFill>
                          <a:latin typeface="Arial"/>
                        </a:rPr>
                        <a:t>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04" name="Rectangle 173"/>
                    <p:cNvSpPr/>
                    <p:nvPr/>
                  </p:nvSpPr>
                  <p:spPr>
                    <a:xfrm>
                      <a:off x="7799040" y="4280400"/>
                      <a:ext cx="181800" cy="15264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0</a:t>
                      </a:r>
                      <a:r>
                        <a:rPr b="1" lang="en-US" sz="1000" spc="-1" strike="noStrike" baseline="30000">
                          <a:solidFill>
                            <a:srgbClr val="000000"/>
                          </a:solidFill>
                          <a:latin typeface="Arial"/>
                        </a:rPr>
                        <a:t>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05" name="Rectangle 175"/>
                    <p:cNvSpPr/>
                    <p:nvPr/>
                  </p:nvSpPr>
                  <p:spPr>
                    <a:xfrm>
                      <a:off x="8154720" y="4280400"/>
                      <a:ext cx="181800" cy="15264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0</a:t>
                      </a:r>
                      <a:r>
                        <a:rPr b="1" lang="en-US" sz="1000" spc="-1" strike="noStrike" baseline="30000">
                          <a:solidFill>
                            <a:srgbClr val="000000"/>
                          </a:solidFill>
                          <a:latin typeface="Arial"/>
                        </a:rPr>
                        <a:t>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06" name="Rectangle 177"/>
                    <p:cNvSpPr/>
                    <p:nvPr/>
                  </p:nvSpPr>
                  <p:spPr>
                    <a:xfrm>
                      <a:off x="8503920" y="4280400"/>
                      <a:ext cx="181800" cy="15264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0</a:t>
                      </a:r>
                      <a:r>
                        <a:rPr b="1" lang="en-US" sz="1000" spc="-1" strike="noStrike" baseline="30000">
                          <a:solidFill>
                            <a:srgbClr val="000000"/>
                          </a:solidFill>
                          <a:latin typeface="Arial"/>
                        </a:rPr>
                        <a:t>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</p:grpSp>
              <p:sp>
                <p:nvSpPr>
                  <p:cNvPr id="207" name="Line 179"/>
                  <p:cNvSpPr/>
                  <p:nvPr/>
                </p:nvSpPr>
                <p:spPr>
                  <a:xfrm flipV="1">
                    <a:off x="7142040" y="2787120"/>
                    <a:ext cx="0" cy="1414080"/>
                  </a:xfrm>
                  <a:prstGeom prst="line">
                    <a:avLst/>
                  </a:prstGeom>
                  <a:ln w="792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grpSp>
                <p:nvGrpSpPr>
                  <p:cNvPr id="208" name="Group 180"/>
                  <p:cNvGrpSpPr/>
                  <p:nvPr/>
                </p:nvGrpSpPr>
                <p:grpSpPr>
                  <a:xfrm>
                    <a:off x="6842520" y="2758320"/>
                    <a:ext cx="227880" cy="1500840"/>
                    <a:chOff x="6842520" y="2758320"/>
                    <a:chExt cx="227880" cy="1500840"/>
                  </a:xfrm>
                </p:grpSpPr>
                <p:sp>
                  <p:nvSpPr>
                    <p:cNvPr id="209" name="Rectangle 181"/>
                    <p:cNvSpPr/>
                    <p:nvPr/>
                  </p:nvSpPr>
                  <p:spPr>
                    <a:xfrm>
                      <a:off x="6999480" y="4106520"/>
                      <a:ext cx="70920" cy="15264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10" name="Rectangle 182"/>
                    <p:cNvSpPr/>
                    <p:nvPr/>
                  </p:nvSpPr>
                  <p:spPr>
                    <a:xfrm>
                      <a:off x="6921720" y="3839400"/>
                      <a:ext cx="140760" cy="15264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11" name="Rectangle 183"/>
                    <p:cNvSpPr/>
                    <p:nvPr/>
                  </p:nvSpPr>
                  <p:spPr>
                    <a:xfrm>
                      <a:off x="6921720" y="3570480"/>
                      <a:ext cx="140760" cy="15264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4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12" name="Rectangle 184"/>
                    <p:cNvSpPr/>
                    <p:nvPr/>
                  </p:nvSpPr>
                  <p:spPr>
                    <a:xfrm>
                      <a:off x="6921720" y="3294000"/>
                      <a:ext cx="140760" cy="15264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6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13" name="Rectangle 185"/>
                    <p:cNvSpPr/>
                    <p:nvPr/>
                  </p:nvSpPr>
                  <p:spPr>
                    <a:xfrm>
                      <a:off x="6921720" y="3026520"/>
                      <a:ext cx="140760" cy="15264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8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14" name="Rectangle 186"/>
                    <p:cNvSpPr/>
                    <p:nvPr/>
                  </p:nvSpPr>
                  <p:spPr>
                    <a:xfrm>
                      <a:off x="6842520" y="2758320"/>
                      <a:ext cx="210960" cy="15264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0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</p:grpSp>
              <p:grpSp>
                <p:nvGrpSpPr>
                  <p:cNvPr id="215" name="Group 187"/>
                  <p:cNvGrpSpPr/>
                  <p:nvPr/>
                </p:nvGrpSpPr>
                <p:grpSpPr>
                  <a:xfrm>
                    <a:off x="7108560" y="2853000"/>
                    <a:ext cx="32760" cy="1349280"/>
                    <a:chOff x="7108560" y="2853000"/>
                    <a:chExt cx="32760" cy="1349280"/>
                  </a:xfrm>
                </p:grpSpPr>
                <p:sp>
                  <p:nvSpPr>
                    <p:cNvPr id="216" name="Line 188"/>
                    <p:cNvSpPr/>
                    <p:nvPr/>
                  </p:nvSpPr>
                  <p:spPr>
                    <a:xfrm flipH="1">
                      <a:off x="7108560" y="4201560"/>
                      <a:ext cx="32760" cy="720"/>
                    </a:xfrm>
                    <a:prstGeom prst="line">
                      <a:avLst/>
                    </a:prstGeom>
                    <a:ln w="792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080" bIns="-4608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17" name="Line 189"/>
                    <p:cNvSpPr/>
                    <p:nvPr/>
                  </p:nvSpPr>
                  <p:spPr>
                    <a:xfrm flipH="1">
                      <a:off x="7130520" y="4134960"/>
                      <a:ext cx="10440" cy="720"/>
                    </a:xfrm>
                    <a:prstGeom prst="line">
                      <a:avLst/>
                    </a:prstGeom>
                    <a:ln w="792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080" bIns="-4608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18" name="Line 190"/>
                    <p:cNvSpPr/>
                    <p:nvPr/>
                  </p:nvSpPr>
                  <p:spPr>
                    <a:xfrm flipH="1">
                      <a:off x="7130520" y="4070160"/>
                      <a:ext cx="10440" cy="720"/>
                    </a:xfrm>
                    <a:prstGeom prst="line">
                      <a:avLst/>
                    </a:prstGeom>
                    <a:ln w="792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080" bIns="-4608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19" name="Line 191"/>
                    <p:cNvSpPr/>
                    <p:nvPr/>
                  </p:nvSpPr>
                  <p:spPr>
                    <a:xfrm flipH="1">
                      <a:off x="7130520" y="3997800"/>
                      <a:ext cx="10440" cy="720"/>
                    </a:xfrm>
                    <a:prstGeom prst="line">
                      <a:avLst/>
                    </a:prstGeom>
                    <a:ln w="792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080" bIns="-4608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20" name="Line 192"/>
                    <p:cNvSpPr/>
                    <p:nvPr/>
                  </p:nvSpPr>
                  <p:spPr>
                    <a:xfrm flipH="1">
                      <a:off x="7108560" y="3932640"/>
                      <a:ext cx="32760" cy="720"/>
                    </a:xfrm>
                    <a:prstGeom prst="line">
                      <a:avLst/>
                    </a:prstGeom>
                    <a:ln w="792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080" bIns="-4608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21" name="Line 193"/>
                    <p:cNvSpPr/>
                    <p:nvPr/>
                  </p:nvSpPr>
                  <p:spPr>
                    <a:xfrm flipH="1">
                      <a:off x="7130520" y="3866400"/>
                      <a:ext cx="10440" cy="720"/>
                    </a:xfrm>
                    <a:prstGeom prst="line">
                      <a:avLst/>
                    </a:prstGeom>
                    <a:ln w="792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080" bIns="-4608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22" name="Line 194"/>
                    <p:cNvSpPr/>
                    <p:nvPr/>
                  </p:nvSpPr>
                  <p:spPr>
                    <a:xfrm flipH="1">
                      <a:off x="7130520" y="3795120"/>
                      <a:ext cx="10440" cy="1080"/>
                    </a:xfrm>
                    <a:prstGeom prst="line">
                      <a:avLst/>
                    </a:prstGeom>
                    <a:ln w="792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5720" bIns="-4572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23" name="Line 195"/>
                    <p:cNvSpPr/>
                    <p:nvPr/>
                  </p:nvSpPr>
                  <p:spPr>
                    <a:xfrm flipH="1">
                      <a:off x="7130520" y="3730320"/>
                      <a:ext cx="10440" cy="720"/>
                    </a:xfrm>
                    <a:prstGeom prst="line">
                      <a:avLst/>
                    </a:prstGeom>
                    <a:ln w="792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080" bIns="-4608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24" name="Line 196"/>
                    <p:cNvSpPr/>
                    <p:nvPr/>
                  </p:nvSpPr>
                  <p:spPr>
                    <a:xfrm flipH="1">
                      <a:off x="7108560" y="3663720"/>
                      <a:ext cx="32760" cy="1080"/>
                    </a:xfrm>
                    <a:prstGeom prst="line">
                      <a:avLst/>
                    </a:prstGeom>
                    <a:ln w="792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5720" bIns="-4572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25" name="Line 197"/>
                    <p:cNvSpPr/>
                    <p:nvPr/>
                  </p:nvSpPr>
                  <p:spPr>
                    <a:xfrm flipH="1">
                      <a:off x="7130520" y="3592800"/>
                      <a:ext cx="10440" cy="720"/>
                    </a:xfrm>
                    <a:prstGeom prst="line">
                      <a:avLst/>
                    </a:prstGeom>
                    <a:ln w="792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080" bIns="-4608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26" name="Line 198"/>
                    <p:cNvSpPr/>
                    <p:nvPr/>
                  </p:nvSpPr>
                  <p:spPr>
                    <a:xfrm flipH="1">
                      <a:off x="7130520" y="3526560"/>
                      <a:ext cx="10440" cy="1080"/>
                    </a:xfrm>
                    <a:prstGeom prst="line">
                      <a:avLst/>
                    </a:prstGeom>
                    <a:ln w="792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5720" bIns="-4572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27" name="Line 199"/>
                    <p:cNvSpPr/>
                    <p:nvPr/>
                  </p:nvSpPr>
                  <p:spPr>
                    <a:xfrm flipH="1">
                      <a:off x="7130520" y="3461400"/>
                      <a:ext cx="10440" cy="720"/>
                    </a:xfrm>
                    <a:prstGeom prst="line">
                      <a:avLst/>
                    </a:prstGeom>
                    <a:ln w="792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080" bIns="-4608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28" name="Line 200"/>
                    <p:cNvSpPr/>
                    <p:nvPr/>
                  </p:nvSpPr>
                  <p:spPr>
                    <a:xfrm flipH="1">
                      <a:off x="7108560" y="3389400"/>
                      <a:ext cx="32760" cy="720"/>
                    </a:xfrm>
                    <a:prstGeom prst="line">
                      <a:avLst/>
                    </a:prstGeom>
                    <a:ln w="792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080" bIns="-4608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29" name="Line 201"/>
                    <p:cNvSpPr/>
                    <p:nvPr/>
                  </p:nvSpPr>
                  <p:spPr>
                    <a:xfrm flipH="1">
                      <a:off x="7130520" y="3324240"/>
                      <a:ext cx="10440" cy="720"/>
                    </a:xfrm>
                    <a:prstGeom prst="line">
                      <a:avLst/>
                    </a:prstGeom>
                    <a:ln w="792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080" bIns="-4608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30" name="Line 202"/>
                    <p:cNvSpPr/>
                    <p:nvPr/>
                  </p:nvSpPr>
                  <p:spPr>
                    <a:xfrm flipH="1">
                      <a:off x="7130520" y="3257640"/>
                      <a:ext cx="10440" cy="720"/>
                    </a:xfrm>
                    <a:prstGeom prst="line">
                      <a:avLst/>
                    </a:prstGeom>
                    <a:ln w="792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080" bIns="-4608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31" name="Line 203"/>
                    <p:cNvSpPr/>
                    <p:nvPr/>
                  </p:nvSpPr>
                  <p:spPr>
                    <a:xfrm flipH="1">
                      <a:off x="7130520" y="3186720"/>
                      <a:ext cx="10440" cy="1080"/>
                    </a:xfrm>
                    <a:prstGeom prst="line">
                      <a:avLst/>
                    </a:prstGeom>
                    <a:ln w="792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5720" bIns="-4572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32" name="Line 204"/>
                    <p:cNvSpPr/>
                    <p:nvPr/>
                  </p:nvSpPr>
                  <p:spPr>
                    <a:xfrm flipH="1">
                      <a:off x="7108560" y="3120480"/>
                      <a:ext cx="32760" cy="720"/>
                    </a:xfrm>
                    <a:prstGeom prst="line">
                      <a:avLst/>
                    </a:prstGeom>
                    <a:ln w="792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080" bIns="-4608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33" name="Line 205"/>
                    <p:cNvSpPr/>
                    <p:nvPr/>
                  </p:nvSpPr>
                  <p:spPr>
                    <a:xfrm flipH="1">
                      <a:off x="7130520" y="3055320"/>
                      <a:ext cx="10440" cy="1080"/>
                    </a:xfrm>
                    <a:prstGeom prst="line">
                      <a:avLst/>
                    </a:prstGeom>
                    <a:ln w="792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5720" bIns="-4572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34" name="Line 206"/>
                    <p:cNvSpPr/>
                    <p:nvPr/>
                  </p:nvSpPr>
                  <p:spPr>
                    <a:xfrm flipH="1">
                      <a:off x="7130520" y="2984400"/>
                      <a:ext cx="10440" cy="720"/>
                    </a:xfrm>
                    <a:prstGeom prst="line">
                      <a:avLst/>
                    </a:prstGeom>
                    <a:ln w="792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080" bIns="-4608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35" name="Line 207"/>
                    <p:cNvSpPr/>
                    <p:nvPr/>
                  </p:nvSpPr>
                  <p:spPr>
                    <a:xfrm flipH="1">
                      <a:off x="7130520" y="2917800"/>
                      <a:ext cx="10440" cy="1080"/>
                    </a:xfrm>
                    <a:prstGeom prst="line">
                      <a:avLst/>
                    </a:prstGeom>
                    <a:ln w="792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5720" bIns="-4572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36" name="Line 208"/>
                    <p:cNvSpPr/>
                    <p:nvPr/>
                  </p:nvSpPr>
                  <p:spPr>
                    <a:xfrm flipH="1">
                      <a:off x="7108560" y="2853000"/>
                      <a:ext cx="32760" cy="720"/>
                    </a:xfrm>
                    <a:prstGeom prst="line">
                      <a:avLst/>
                    </a:prstGeom>
                    <a:ln w="792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080" bIns="-4608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</p:grpSp>
              <p:sp>
                <p:nvSpPr>
                  <p:cNvPr id="237" name="Rectangle 209"/>
                  <p:cNvSpPr/>
                  <p:nvPr/>
                </p:nvSpPr>
                <p:spPr>
                  <a:xfrm rot="16200000">
                    <a:off x="6421320" y="3423600"/>
                    <a:ext cx="662040" cy="18288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457200"/>
                        <a:tab algn="l" pos="914400"/>
                        <a:tab algn="l" pos="1371600"/>
                        <a:tab algn="l" pos="1828800"/>
                        <a:tab algn="l" pos="2286000"/>
                        <a:tab algn="l" pos="2743200"/>
                        <a:tab algn="l" pos="3200400"/>
                        <a:tab algn="l" pos="3657600"/>
                        <a:tab algn="l" pos="4114800"/>
                        <a:tab algn="l" pos="4572000"/>
                        <a:tab algn="l" pos="5029200"/>
                        <a:tab algn="l" pos="5486400"/>
                        <a:tab algn="l" pos="5943600"/>
                        <a:tab algn="l" pos="6400800"/>
                        <a:tab algn="l" pos="6858000"/>
                        <a:tab algn="l" pos="7315200"/>
                        <a:tab algn="l" pos="7772400"/>
                        <a:tab algn="l" pos="8229600"/>
                        <a:tab algn="l" pos="8686800"/>
                        <a:tab algn="l" pos="9144000"/>
                      </a:tabLst>
                    </a:pPr>
                    <a:r>
                      <a:rPr b="1" lang="en-US" sz="1200" spc="-1" strike="noStrike">
                        <a:solidFill>
                          <a:srgbClr val="000000"/>
                        </a:solidFill>
                        <a:latin typeface="Arial"/>
                      </a:rPr>
                      <a:t>% of Max</a:t>
                    </a:r>
                    <a:endParaRPr b="0" lang="en-US" sz="12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38" name="Text Box 211"/>
                  <p:cNvSpPr/>
                  <p:nvPr/>
                </p:nvSpPr>
                <p:spPr>
                  <a:xfrm>
                    <a:off x="8005680" y="2842200"/>
                    <a:ext cx="436680" cy="27648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t">
                    <a:spAutoFit/>
                  </a:bodyPr>
                  <a:p>
                    <a:pPr>
                      <a:tabLst>
                        <a:tab algn="l" pos="0"/>
                        <a:tab algn="l" pos="457200"/>
                        <a:tab algn="l" pos="914400"/>
                        <a:tab algn="l" pos="1371600"/>
                        <a:tab algn="l" pos="1828800"/>
                        <a:tab algn="l" pos="2286000"/>
                        <a:tab algn="l" pos="2743200"/>
                        <a:tab algn="l" pos="3200400"/>
                        <a:tab algn="l" pos="3657600"/>
                        <a:tab algn="l" pos="4114800"/>
                        <a:tab algn="l" pos="4572000"/>
                        <a:tab algn="l" pos="5029200"/>
                        <a:tab algn="l" pos="5486400"/>
                        <a:tab algn="l" pos="5943600"/>
                        <a:tab algn="l" pos="6400800"/>
                        <a:tab algn="l" pos="6858000"/>
                        <a:tab algn="l" pos="7315200"/>
                        <a:tab algn="l" pos="7772400"/>
                        <a:tab algn="l" pos="8229600"/>
                        <a:tab algn="l" pos="8686800"/>
                        <a:tab algn="l" pos="9144000"/>
                      </a:tabLst>
                    </a:pPr>
                    <a:r>
                      <a:rPr b="1" lang="en-US" sz="1200" spc="-1" strike="noStrike">
                        <a:solidFill>
                          <a:srgbClr val="000000"/>
                        </a:solidFill>
                        <a:latin typeface="Arial"/>
                      </a:rPr>
                      <a:t>465</a:t>
                    </a:r>
                    <a:endParaRPr b="0" lang="en-US" sz="12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39" name="Text Box 213"/>
                  <p:cNvSpPr/>
                  <p:nvPr/>
                </p:nvSpPr>
                <p:spPr>
                  <a:xfrm>
                    <a:off x="7373880" y="2842200"/>
                    <a:ext cx="436680" cy="27648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t">
                    <a:spAutoFit/>
                  </a:bodyPr>
                  <a:p>
                    <a:pPr>
                      <a:tabLst>
                        <a:tab algn="l" pos="0"/>
                        <a:tab algn="l" pos="457200"/>
                        <a:tab algn="l" pos="914400"/>
                        <a:tab algn="l" pos="1371600"/>
                        <a:tab algn="l" pos="1828800"/>
                        <a:tab algn="l" pos="2286000"/>
                        <a:tab algn="l" pos="2743200"/>
                        <a:tab algn="l" pos="3200400"/>
                        <a:tab algn="l" pos="3657600"/>
                        <a:tab algn="l" pos="4114800"/>
                        <a:tab algn="l" pos="4572000"/>
                        <a:tab algn="l" pos="5029200"/>
                        <a:tab algn="l" pos="5486400"/>
                        <a:tab algn="l" pos="5943600"/>
                        <a:tab algn="l" pos="6400800"/>
                        <a:tab algn="l" pos="6858000"/>
                        <a:tab algn="l" pos="7315200"/>
                        <a:tab algn="l" pos="7772400"/>
                        <a:tab algn="l" pos="8229600"/>
                        <a:tab algn="l" pos="8686800"/>
                        <a:tab algn="l" pos="9144000"/>
                      </a:tabLst>
                    </a:pPr>
                    <a:r>
                      <a:rPr b="1" lang="en-US" sz="1200" spc="-1" strike="noStrike">
                        <a:solidFill>
                          <a:srgbClr val="000000"/>
                        </a:solidFill>
                        <a:latin typeface="Arial"/>
                      </a:rPr>
                      <a:t>123</a:t>
                    </a:r>
                    <a:endParaRPr b="0" lang="en-US" sz="12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40" name="Freeform 214"/>
                  <p:cNvSpPr/>
                  <p:nvPr/>
                </p:nvSpPr>
                <p:spPr>
                  <a:xfrm>
                    <a:off x="7153200" y="2870280"/>
                    <a:ext cx="1389600" cy="1325520"/>
                  </a:xfrm>
                  <a:prstGeom prst="pie">
                    <a:avLst/>
                  </a:prstGeom>
                  <a:blipFill rotWithShape="0">
                    <a:blip r:embed="rId5"/>
                    <a:srcRect/>
                    <a:tile tx="0" ty="0" sx="100000" sy="100000" algn="ctr"/>
                  </a:blipFill>
                  <a:ln w="46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457200"/>
                        <a:tab algn="l" pos="914400"/>
                        <a:tab algn="l" pos="1371600"/>
                        <a:tab algn="l" pos="1828800"/>
                        <a:tab algn="l" pos="2286000"/>
                        <a:tab algn="l" pos="2743200"/>
                        <a:tab algn="l" pos="3200400"/>
                        <a:tab algn="l" pos="3657600"/>
                        <a:tab algn="l" pos="4114800"/>
                        <a:tab algn="l" pos="4572000"/>
                        <a:tab algn="l" pos="5029200"/>
                        <a:tab algn="l" pos="5486400"/>
                        <a:tab algn="l" pos="5943600"/>
                        <a:tab algn="l" pos="6400800"/>
                        <a:tab algn="l" pos="6858000"/>
                        <a:tab algn="l" pos="7315200"/>
                        <a:tab algn="l" pos="7772400"/>
                        <a:tab algn="l" pos="8229600"/>
                        <a:tab algn="l" pos="8686800"/>
                        <a:tab algn="l" pos="9144000"/>
                      </a:tabLst>
                    </a:pPr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41" name="Freeform 215"/>
                  <p:cNvSpPr/>
                  <p:nvPr/>
                </p:nvSpPr>
                <p:spPr>
                  <a:xfrm>
                    <a:off x="7153200" y="2870280"/>
                    <a:ext cx="1395360" cy="1325520"/>
                  </a:xfrm>
                  <a:prstGeom prst="pie">
                    <a:avLst/>
                  </a:prstGeom>
                  <a:solidFill>
                    <a:srgbClr val="000000"/>
                  </a:solidFill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457200"/>
                        <a:tab algn="l" pos="914400"/>
                        <a:tab algn="l" pos="1371600"/>
                        <a:tab algn="l" pos="1828800"/>
                        <a:tab algn="l" pos="2286000"/>
                        <a:tab algn="l" pos="2743200"/>
                        <a:tab algn="l" pos="3200400"/>
                        <a:tab algn="l" pos="3657600"/>
                        <a:tab algn="l" pos="4114800"/>
                        <a:tab algn="l" pos="4572000"/>
                        <a:tab algn="l" pos="5029200"/>
                        <a:tab algn="l" pos="5486400"/>
                        <a:tab algn="l" pos="5943600"/>
                        <a:tab algn="l" pos="6400800"/>
                        <a:tab algn="l" pos="6858000"/>
                        <a:tab algn="l" pos="7315200"/>
                        <a:tab algn="l" pos="7772400"/>
                        <a:tab algn="l" pos="8229600"/>
                        <a:tab algn="l" pos="8686800"/>
                        <a:tab algn="l" pos="9144000"/>
                      </a:tabLst>
                    </a:pPr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sp>
              <p:nvSpPr>
                <p:cNvPr id="242" name="Line 306"/>
                <p:cNvSpPr/>
                <p:nvPr/>
              </p:nvSpPr>
              <p:spPr>
                <a:xfrm>
                  <a:off x="7419960" y="4569840"/>
                  <a:ext cx="1114560" cy="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  <a:tailEnd len="med" type="triangle" w="med"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ctr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grpSp>
              <p:nvGrpSpPr>
                <p:cNvPr id="243" name="Group 289"/>
                <p:cNvGrpSpPr/>
                <p:nvPr/>
              </p:nvGrpSpPr>
              <p:grpSpPr>
                <a:xfrm>
                  <a:off x="4246560" y="2718720"/>
                  <a:ext cx="2017440" cy="1723680"/>
                  <a:chOff x="4246560" y="2718720"/>
                  <a:chExt cx="2017440" cy="1723680"/>
                </a:xfrm>
              </p:grpSpPr>
              <p:sp>
                <p:nvSpPr>
                  <p:cNvPr id="244" name="Rectangle 216"/>
                  <p:cNvSpPr/>
                  <p:nvPr/>
                </p:nvSpPr>
                <p:spPr>
                  <a:xfrm>
                    <a:off x="4717080" y="2796840"/>
                    <a:ext cx="1418760" cy="1419840"/>
                  </a:xfrm>
                  <a:prstGeom prst="rect">
                    <a:avLst/>
                  </a:prstGeom>
                  <a:solidFill>
                    <a:srgbClr val="ffffff"/>
                  </a:solidFill>
                  <a:ln w="792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457200"/>
                        <a:tab algn="l" pos="914400"/>
                        <a:tab algn="l" pos="1371600"/>
                        <a:tab algn="l" pos="1828800"/>
                        <a:tab algn="l" pos="2286000"/>
                        <a:tab algn="l" pos="2743200"/>
                        <a:tab algn="l" pos="3200400"/>
                        <a:tab algn="l" pos="3657600"/>
                        <a:tab algn="l" pos="4114800"/>
                        <a:tab algn="l" pos="4572000"/>
                        <a:tab algn="l" pos="5029200"/>
                        <a:tab algn="l" pos="5486400"/>
                        <a:tab algn="l" pos="5943600"/>
                        <a:tab algn="l" pos="6400800"/>
                        <a:tab algn="l" pos="6858000"/>
                        <a:tab algn="l" pos="7315200"/>
                        <a:tab algn="l" pos="7772400"/>
                        <a:tab algn="l" pos="8229600"/>
                        <a:tab algn="l" pos="8686800"/>
                        <a:tab algn="l" pos="9144000"/>
                      </a:tabLst>
                    </a:pPr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45" name="Line 217"/>
                  <p:cNvSpPr/>
                  <p:nvPr/>
                </p:nvSpPr>
                <p:spPr>
                  <a:xfrm>
                    <a:off x="4717080" y="4211280"/>
                    <a:ext cx="1413360" cy="1080"/>
                  </a:xfrm>
                  <a:prstGeom prst="line">
                    <a:avLst/>
                  </a:prstGeom>
                  <a:ln w="792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720" bIns="-4572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grpSp>
                <p:nvGrpSpPr>
                  <p:cNvPr id="246" name="Group 218"/>
                  <p:cNvGrpSpPr/>
                  <p:nvPr/>
                </p:nvGrpSpPr>
                <p:grpSpPr>
                  <a:xfrm>
                    <a:off x="4716360" y="4217040"/>
                    <a:ext cx="1413720" cy="31320"/>
                    <a:chOff x="4716360" y="4217040"/>
                    <a:chExt cx="1413720" cy="31320"/>
                  </a:xfrm>
                </p:grpSpPr>
                <p:sp>
                  <p:nvSpPr>
                    <p:cNvPr id="247" name="Line 219"/>
                    <p:cNvSpPr/>
                    <p:nvPr/>
                  </p:nvSpPr>
                  <p:spPr>
                    <a:xfrm>
                      <a:off x="4716360" y="4217040"/>
                      <a:ext cx="720" cy="31320"/>
                    </a:xfrm>
                    <a:prstGeom prst="line">
                      <a:avLst/>
                    </a:prstGeom>
                    <a:ln w="792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15480" bIns="-1548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48" name="Line 220"/>
                    <p:cNvSpPr/>
                    <p:nvPr/>
                  </p:nvSpPr>
                  <p:spPr>
                    <a:xfrm>
                      <a:off x="4820040" y="4217040"/>
                      <a:ext cx="720" cy="10080"/>
                    </a:xfrm>
                    <a:prstGeom prst="line">
                      <a:avLst/>
                    </a:prstGeom>
                    <a:ln w="792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6720" bIns="-3672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49" name="Line 221"/>
                    <p:cNvSpPr/>
                    <p:nvPr/>
                  </p:nvSpPr>
                  <p:spPr>
                    <a:xfrm>
                      <a:off x="4880520" y="4217040"/>
                      <a:ext cx="720" cy="10080"/>
                    </a:xfrm>
                    <a:prstGeom prst="line">
                      <a:avLst/>
                    </a:prstGeom>
                    <a:ln w="792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6720" bIns="-3672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50" name="Line 222"/>
                    <p:cNvSpPr/>
                    <p:nvPr/>
                  </p:nvSpPr>
                  <p:spPr>
                    <a:xfrm>
                      <a:off x="4925160" y="4217040"/>
                      <a:ext cx="720" cy="10080"/>
                    </a:xfrm>
                    <a:prstGeom prst="line">
                      <a:avLst/>
                    </a:prstGeom>
                    <a:ln w="792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6720" bIns="-3672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51" name="Line 223"/>
                    <p:cNvSpPr/>
                    <p:nvPr/>
                  </p:nvSpPr>
                  <p:spPr>
                    <a:xfrm>
                      <a:off x="4962960" y="4217040"/>
                      <a:ext cx="720" cy="21240"/>
                    </a:xfrm>
                    <a:prstGeom prst="line">
                      <a:avLst/>
                    </a:prstGeom>
                    <a:ln w="792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25560" bIns="-2556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52" name="Line 224"/>
                    <p:cNvSpPr/>
                    <p:nvPr/>
                  </p:nvSpPr>
                  <p:spPr>
                    <a:xfrm>
                      <a:off x="4990320" y="4217040"/>
                      <a:ext cx="720" cy="10080"/>
                    </a:xfrm>
                    <a:prstGeom prst="line">
                      <a:avLst/>
                    </a:prstGeom>
                    <a:ln w="792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6720" bIns="-3672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53" name="Line 225"/>
                    <p:cNvSpPr/>
                    <p:nvPr/>
                  </p:nvSpPr>
                  <p:spPr>
                    <a:xfrm>
                      <a:off x="5011920" y="4217040"/>
                      <a:ext cx="720" cy="10080"/>
                    </a:xfrm>
                    <a:prstGeom prst="line">
                      <a:avLst/>
                    </a:prstGeom>
                    <a:ln w="792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6720" bIns="-3672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54" name="Line 226"/>
                    <p:cNvSpPr/>
                    <p:nvPr/>
                  </p:nvSpPr>
                  <p:spPr>
                    <a:xfrm>
                      <a:off x="5033520" y="4217040"/>
                      <a:ext cx="1080" cy="10080"/>
                    </a:xfrm>
                    <a:prstGeom prst="line">
                      <a:avLst/>
                    </a:prstGeom>
                    <a:ln w="792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6720" bIns="-3672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55" name="Line 227"/>
                    <p:cNvSpPr/>
                    <p:nvPr/>
                  </p:nvSpPr>
                  <p:spPr>
                    <a:xfrm>
                      <a:off x="5050800" y="4217040"/>
                      <a:ext cx="720" cy="10080"/>
                    </a:xfrm>
                    <a:prstGeom prst="line">
                      <a:avLst/>
                    </a:prstGeom>
                    <a:ln w="792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6720" bIns="-3672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56" name="Line 228"/>
                    <p:cNvSpPr/>
                    <p:nvPr/>
                  </p:nvSpPr>
                  <p:spPr>
                    <a:xfrm>
                      <a:off x="5066640" y="4217040"/>
                      <a:ext cx="1080" cy="31320"/>
                    </a:xfrm>
                    <a:prstGeom prst="line">
                      <a:avLst/>
                    </a:prstGeom>
                    <a:ln w="792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15480" bIns="-1548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57" name="Line 229"/>
                    <p:cNvSpPr/>
                    <p:nvPr/>
                  </p:nvSpPr>
                  <p:spPr>
                    <a:xfrm>
                      <a:off x="5176440" y="4217040"/>
                      <a:ext cx="720" cy="10080"/>
                    </a:xfrm>
                    <a:prstGeom prst="line">
                      <a:avLst/>
                    </a:prstGeom>
                    <a:ln w="792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6720" bIns="-3672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58" name="Line 230"/>
                    <p:cNvSpPr/>
                    <p:nvPr/>
                  </p:nvSpPr>
                  <p:spPr>
                    <a:xfrm>
                      <a:off x="5236920" y="4217040"/>
                      <a:ext cx="1080" cy="10080"/>
                    </a:xfrm>
                    <a:prstGeom prst="line">
                      <a:avLst/>
                    </a:prstGeom>
                    <a:ln w="792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6720" bIns="-3672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59" name="Line 231"/>
                    <p:cNvSpPr/>
                    <p:nvPr/>
                  </p:nvSpPr>
                  <p:spPr>
                    <a:xfrm>
                      <a:off x="5280480" y="4217040"/>
                      <a:ext cx="720" cy="10080"/>
                    </a:xfrm>
                    <a:prstGeom prst="line">
                      <a:avLst/>
                    </a:prstGeom>
                    <a:ln w="792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6720" bIns="-3672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60" name="Line 232"/>
                    <p:cNvSpPr/>
                    <p:nvPr/>
                  </p:nvSpPr>
                  <p:spPr>
                    <a:xfrm>
                      <a:off x="5313600" y="4217040"/>
                      <a:ext cx="720" cy="21240"/>
                    </a:xfrm>
                    <a:prstGeom prst="line">
                      <a:avLst/>
                    </a:prstGeom>
                    <a:ln w="792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25560" bIns="-2556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61" name="Line 233"/>
                    <p:cNvSpPr/>
                    <p:nvPr/>
                  </p:nvSpPr>
                  <p:spPr>
                    <a:xfrm>
                      <a:off x="5346720" y="4217040"/>
                      <a:ext cx="720" cy="10080"/>
                    </a:xfrm>
                    <a:prstGeom prst="line">
                      <a:avLst/>
                    </a:prstGeom>
                    <a:ln w="792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6720" bIns="-3672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62" name="Line 234"/>
                    <p:cNvSpPr/>
                    <p:nvPr/>
                  </p:nvSpPr>
                  <p:spPr>
                    <a:xfrm>
                      <a:off x="5368320" y="4217040"/>
                      <a:ext cx="1080" cy="10080"/>
                    </a:xfrm>
                    <a:prstGeom prst="line">
                      <a:avLst/>
                    </a:prstGeom>
                    <a:ln w="792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6720" bIns="-3672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63" name="Line 235"/>
                    <p:cNvSpPr/>
                    <p:nvPr/>
                  </p:nvSpPr>
                  <p:spPr>
                    <a:xfrm>
                      <a:off x="5389920" y="4217040"/>
                      <a:ext cx="1080" cy="10080"/>
                    </a:xfrm>
                    <a:prstGeom prst="line">
                      <a:avLst/>
                    </a:prstGeom>
                    <a:ln w="792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6720" bIns="-3672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64" name="Line 236"/>
                    <p:cNvSpPr/>
                    <p:nvPr/>
                  </p:nvSpPr>
                  <p:spPr>
                    <a:xfrm>
                      <a:off x="5407200" y="4217040"/>
                      <a:ext cx="1080" cy="10080"/>
                    </a:xfrm>
                    <a:prstGeom prst="line">
                      <a:avLst/>
                    </a:prstGeom>
                    <a:ln w="792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6720" bIns="-3672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65" name="Line 237"/>
                    <p:cNvSpPr/>
                    <p:nvPr/>
                  </p:nvSpPr>
                  <p:spPr>
                    <a:xfrm>
                      <a:off x="5423040" y="4217040"/>
                      <a:ext cx="1080" cy="31320"/>
                    </a:xfrm>
                    <a:prstGeom prst="line">
                      <a:avLst/>
                    </a:prstGeom>
                    <a:ln w="792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15480" bIns="-1548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66" name="Line 238"/>
                    <p:cNvSpPr/>
                    <p:nvPr/>
                  </p:nvSpPr>
                  <p:spPr>
                    <a:xfrm>
                      <a:off x="5527080" y="4217040"/>
                      <a:ext cx="1080" cy="10080"/>
                    </a:xfrm>
                    <a:prstGeom prst="line">
                      <a:avLst/>
                    </a:prstGeom>
                    <a:ln w="792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6720" bIns="-3672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67" name="Line 239"/>
                    <p:cNvSpPr/>
                    <p:nvPr/>
                  </p:nvSpPr>
                  <p:spPr>
                    <a:xfrm>
                      <a:off x="5593320" y="4217040"/>
                      <a:ext cx="1080" cy="10080"/>
                    </a:xfrm>
                    <a:prstGeom prst="line">
                      <a:avLst/>
                    </a:prstGeom>
                    <a:ln w="792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6720" bIns="-3672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68" name="Line 240"/>
                    <p:cNvSpPr/>
                    <p:nvPr/>
                  </p:nvSpPr>
                  <p:spPr>
                    <a:xfrm>
                      <a:off x="5636880" y="4217040"/>
                      <a:ext cx="720" cy="10080"/>
                    </a:xfrm>
                    <a:prstGeom prst="line">
                      <a:avLst/>
                    </a:prstGeom>
                    <a:ln w="792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6720" bIns="-3672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69" name="Line 241"/>
                    <p:cNvSpPr/>
                    <p:nvPr/>
                  </p:nvSpPr>
                  <p:spPr>
                    <a:xfrm>
                      <a:off x="5670000" y="4217040"/>
                      <a:ext cx="720" cy="21240"/>
                    </a:xfrm>
                    <a:prstGeom prst="line">
                      <a:avLst/>
                    </a:prstGeom>
                    <a:ln w="792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25560" bIns="-2556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70" name="Line 242"/>
                    <p:cNvSpPr/>
                    <p:nvPr/>
                  </p:nvSpPr>
                  <p:spPr>
                    <a:xfrm>
                      <a:off x="5697360" y="4217040"/>
                      <a:ext cx="1080" cy="10080"/>
                    </a:xfrm>
                    <a:prstGeom prst="line">
                      <a:avLst/>
                    </a:prstGeom>
                    <a:ln w="792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6720" bIns="-3672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71" name="Line 243"/>
                    <p:cNvSpPr/>
                    <p:nvPr/>
                  </p:nvSpPr>
                  <p:spPr>
                    <a:xfrm>
                      <a:off x="5724720" y="4217040"/>
                      <a:ext cx="1080" cy="10080"/>
                    </a:xfrm>
                    <a:prstGeom prst="line">
                      <a:avLst/>
                    </a:prstGeom>
                    <a:ln w="792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6720" bIns="-3672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72" name="Line 244"/>
                    <p:cNvSpPr/>
                    <p:nvPr/>
                  </p:nvSpPr>
                  <p:spPr>
                    <a:xfrm>
                      <a:off x="5740920" y="4217040"/>
                      <a:ext cx="720" cy="10080"/>
                    </a:xfrm>
                    <a:prstGeom prst="line">
                      <a:avLst/>
                    </a:prstGeom>
                    <a:ln w="792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6720" bIns="-3672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73" name="Line 245"/>
                    <p:cNvSpPr/>
                    <p:nvPr/>
                  </p:nvSpPr>
                  <p:spPr>
                    <a:xfrm>
                      <a:off x="5762520" y="4217040"/>
                      <a:ext cx="720" cy="10080"/>
                    </a:xfrm>
                    <a:prstGeom prst="line">
                      <a:avLst/>
                    </a:prstGeom>
                    <a:ln w="792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6720" bIns="-3672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74" name="Line 246"/>
                    <p:cNvSpPr/>
                    <p:nvPr/>
                  </p:nvSpPr>
                  <p:spPr>
                    <a:xfrm>
                      <a:off x="5779440" y="4217040"/>
                      <a:ext cx="720" cy="31320"/>
                    </a:xfrm>
                    <a:prstGeom prst="line">
                      <a:avLst/>
                    </a:prstGeom>
                    <a:ln w="792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15480" bIns="-1548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75" name="Line 247"/>
                    <p:cNvSpPr/>
                    <p:nvPr/>
                  </p:nvSpPr>
                  <p:spPr>
                    <a:xfrm>
                      <a:off x="5883480" y="4217040"/>
                      <a:ext cx="1080" cy="10080"/>
                    </a:xfrm>
                    <a:prstGeom prst="line">
                      <a:avLst/>
                    </a:prstGeom>
                    <a:ln w="792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6720" bIns="-3672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76" name="Line 248"/>
                    <p:cNvSpPr/>
                    <p:nvPr/>
                  </p:nvSpPr>
                  <p:spPr>
                    <a:xfrm>
                      <a:off x="5948640" y="4217040"/>
                      <a:ext cx="720" cy="10080"/>
                    </a:xfrm>
                    <a:prstGeom prst="line">
                      <a:avLst/>
                    </a:prstGeom>
                    <a:ln w="792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6720" bIns="-3672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77" name="Line 249"/>
                    <p:cNvSpPr/>
                    <p:nvPr/>
                  </p:nvSpPr>
                  <p:spPr>
                    <a:xfrm>
                      <a:off x="5993280" y="4217040"/>
                      <a:ext cx="720" cy="10080"/>
                    </a:xfrm>
                    <a:prstGeom prst="line">
                      <a:avLst/>
                    </a:prstGeom>
                    <a:ln w="792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6720" bIns="-3672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78" name="Line 250"/>
                    <p:cNvSpPr/>
                    <p:nvPr/>
                  </p:nvSpPr>
                  <p:spPr>
                    <a:xfrm>
                      <a:off x="6025320" y="4217040"/>
                      <a:ext cx="720" cy="21240"/>
                    </a:xfrm>
                    <a:prstGeom prst="line">
                      <a:avLst/>
                    </a:prstGeom>
                    <a:ln w="792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25560" bIns="-2556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79" name="Line 251"/>
                    <p:cNvSpPr/>
                    <p:nvPr/>
                  </p:nvSpPr>
                  <p:spPr>
                    <a:xfrm>
                      <a:off x="6052680" y="4217040"/>
                      <a:ext cx="720" cy="10080"/>
                    </a:xfrm>
                    <a:prstGeom prst="line">
                      <a:avLst/>
                    </a:prstGeom>
                    <a:ln w="792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6720" bIns="-3672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80" name="Line 252"/>
                    <p:cNvSpPr/>
                    <p:nvPr/>
                  </p:nvSpPr>
                  <p:spPr>
                    <a:xfrm>
                      <a:off x="6075360" y="4217040"/>
                      <a:ext cx="1080" cy="10080"/>
                    </a:xfrm>
                    <a:prstGeom prst="line">
                      <a:avLst/>
                    </a:prstGeom>
                    <a:ln w="792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6720" bIns="-3672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81" name="Line 253"/>
                    <p:cNvSpPr/>
                    <p:nvPr/>
                  </p:nvSpPr>
                  <p:spPr>
                    <a:xfrm>
                      <a:off x="6097320" y="4217040"/>
                      <a:ext cx="720" cy="10080"/>
                    </a:xfrm>
                    <a:prstGeom prst="line">
                      <a:avLst/>
                    </a:prstGeom>
                    <a:ln w="792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6720" bIns="-3672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82" name="Line 254"/>
                    <p:cNvSpPr/>
                    <p:nvPr/>
                  </p:nvSpPr>
                  <p:spPr>
                    <a:xfrm>
                      <a:off x="6113160" y="4217040"/>
                      <a:ext cx="720" cy="10080"/>
                    </a:xfrm>
                    <a:prstGeom prst="line">
                      <a:avLst/>
                    </a:prstGeom>
                    <a:ln w="792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6720" bIns="-3672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83" name="Line 255"/>
                    <p:cNvSpPr/>
                    <p:nvPr/>
                  </p:nvSpPr>
                  <p:spPr>
                    <a:xfrm>
                      <a:off x="6129000" y="4217040"/>
                      <a:ext cx="1080" cy="31320"/>
                    </a:xfrm>
                    <a:prstGeom prst="line">
                      <a:avLst/>
                    </a:prstGeom>
                    <a:ln w="792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15480" bIns="-1548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</p:grpSp>
              <p:grpSp>
                <p:nvGrpSpPr>
                  <p:cNvPr id="284" name="Group 298"/>
                  <p:cNvGrpSpPr/>
                  <p:nvPr/>
                </p:nvGrpSpPr>
                <p:grpSpPr>
                  <a:xfrm>
                    <a:off x="4667760" y="4289760"/>
                    <a:ext cx="1596240" cy="152640"/>
                    <a:chOff x="4667760" y="4289760"/>
                    <a:chExt cx="1596240" cy="152640"/>
                  </a:xfrm>
                </p:grpSpPr>
                <p:sp>
                  <p:nvSpPr>
                    <p:cNvPr id="285" name="Rectangle 257"/>
                    <p:cNvSpPr/>
                    <p:nvPr/>
                  </p:nvSpPr>
                  <p:spPr>
                    <a:xfrm>
                      <a:off x="4667760" y="4289760"/>
                      <a:ext cx="181800" cy="15264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0</a:t>
                      </a:r>
                      <a:r>
                        <a:rPr b="1" lang="en-US" sz="1000" spc="-1" strike="noStrike" baseline="30000">
                          <a:solidFill>
                            <a:srgbClr val="000000"/>
                          </a:solidFill>
                          <a:latin typeface="Arial"/>
                        </a:rPr>
                        <a:t>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86" name="Rectangle 259"/>
                    <p:cNvSpPr/>
                    <p:nvPr/>
                  </p:nvSpPr>
                  <p:spPr>
                    <a:xfrm>
                      <a:off x="5018400" y="4289760"/>
                      <a:ext cx="181800" cy="15264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0</a:t>
                      </a:r>
                      <a:r>
                        <a:rPr b="1" lang="en-US" sz="1000" spc="-1" strike="noStrike" baseline="30000">
                          <a:solidFill>
                            <a:srgbClr val="000000"/>
                          </a:solidFill>
                          <a:latin typeface="Arial"/>
                        </a:rPr>
                        <a:t>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87" name="Rectangle 261"/>
                    <p:cNvSpPr/>
                    <p:nvPr/>
                  </p:nvSpPr>
                  <p:spPr>
                    <a:xfrm>
                      <a:off x="5375520" y="4289760"/>
                      <a:ext cx="181800" cy="15264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0</a:t>
                      </a:r>
                      <a:r>
                        <a:rPr b="1" lang="en-US" sz="1000" spc="-1" strike="noStrike" baseline="30000">
                          <a:solidFill>
                            <a:srgbClr val="000000"/>
                          </a:solidFill>
                          <a:latin typeface="Arial"/>
                        </a:rPr>
                        <a:t>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88" name="Rectangle 263"/>
                    <p:cNvSpPr/>
                    <p:nvPr/>
                  </p:nvSpPr>
                  <p:spPr>
                    <a:xfrm>
                      <a:off x="5733000" y="4289760"/>
                      <a:ext cx="181800" cy="15264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0</a:t>
                      </a:r>
                      <a:r>
                        <a:rPr b="1" lang="en-US" sz="1000" spc="-1" strike="noStrike" baseline="30000">
                          <a:solidFill>
                            <a:srgbClr val="000000"/>
                          </a:solidFill>
                          <a:latin typeface="Arial"/>
                        </a:rPr>
                        <a:t>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89" name="Rectangle 265"/>
                    <p:cNvSpPr/>
                    <p:nvPr/>
                  </p:nvSpPr>
                  <p:spPr>
                    <a:xfrm>
                      <a:off x="6082200" y="4289760"/>
                      <a:ext cx="181800" cy="15264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0</a:t>
                      </a:r>
                      <a:r>
                        <a:rPr b="1" lang="en-US" sz="1000" spc="-1" strike="noStrike" baseline="30000">
                          <a:solidFill>
                            <a:srgbClr val="000000"/>
                          </a:solidFill>
                          <a:latin typeface="Arial"/>
                        </a:rPr>
                        <a:t>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</p:grpSp>
              <p:sp>
                <p:nvSpPr>
                  <p:cNvPr id="290" name="Line 267"/>
                  <p:cNvSpPr/>
                  <p:nvPr/>
                </p:nvSpPr>
                <p:spPr>
                  <a:xfrm flipV="1">
                    <a:off x="4717080" y="2796480"/>
                    <a:ext cx="1080" cy="1414440"/>
                  </a:xfrm>
                  <a:prstGeom prst="line">
                    <a:avLst/>
                  </a:prstGeom>
                  <a:ln w="792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grpSp>
                <p:nvGrpSpPr>
                  <p:cNvPr id="291" name="Group 268"/>
                  <p:cNvGrpSpPr/>
                  <p:nvPr/>
                </p:nvGrpSpPr>
                <p:grpSpPr>
                  <a:xfrm>
                    <a:off x="4422960" y="2767680"/>
                    <a:ext cx="228240" cy="1501200"/>
                    <a:chOff x="4422960" y="2767680"/>
                    <a:chExt cx="228240" cy="1501200"/>
                  </a:xfrm>
                </p:grpSpPr>
                <p:sp>
                  <p:nvSpPr>
                    <p:cNvPr id="292" name="Rectangle 269"/>
                    <p:cNvSpPr/>
                    <p:nvPr/>
                  </p:nvSpPr>
                  <p:spPr>
                    <a:xfrm>
                      <a:off x="4580280" y="4116240"/>
                      <a:ext cx="70920" cy="15264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93" name="Rectangle 270"/>
                    <p:cNvSpPr/>
                    <p:nvPr/>
                  </p:nvSpPr>
                  <p:spPr>
                    <a:xfrm>
                      <a:off x="4500720" y="3848760"/>
                      <a:ext cx="140760" cy="15264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94" name="Rectangle 271"/>
                    <p:cNvSpPr/>
                    <p:nvPr/>
                  </p:nvSpPr>
                  <p:spPr>
                    <a:xfrm>
                      <a:off x="4500720" y="3580200"/>
                      <a:ext cx="140760" cy="15264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4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95" name="Rectangle 272"/>
                    <p:cNvSpPr/>
                    <p:nvPr/>
                  </p:nvSpPr>
                  <p:spPr>
                    <a:xfrm>
                      <a:off x="4500720" y="3303360"/>
                      <a:ext cx="140760" cy="15264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6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96" name="Rectangle 273"/>
                    <p:cNvSpPr/>
                    <p:nvPr/>
                  </p:nvSpPr>
                  <p:spPr>
                    <a:xfrm>
                      <a:off x="4500720" y="3035880"/>
                      <a:ext cx="140760" cy="15264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8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97" name="Rectangle 274"/>
                    <p:cNvSpPr/>
                    <p:nvPr/>
                  </p:nvSpPr>
                  <p:spPr>
                    <a:xfrm>
                      <a:off x="4422960" y="2767680"/>
                      <a:ext cx="210960" cy="15264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0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</p:grpSp>
              <p:grpSp>
                <p:nvGrpSpPr>
                  <p:cNvPr id="298" name="Group 275"/>
                  <p:cNvGrpSpPr/>
                  <p:nvPr/>
                </p:nvGrpSpPr>
                <p:grpSpPr>
                  <a:xfrm>
                    <a:off x="4685400" y="2862720"/>
                    <a:ext cx="31680" cy="1349640"/>
                    <a:chOff x="4685400" y="2862720"/>
                    <a:chExt cx="31680" cy="1349640"/>
                  </a:xfrm>
                </p:grpSpPr>
                <p:sp>
                  <p:nvSpPr>
                    <p:cNvPr id="299" name="Line 276"/>
                    <p:cNvSpPr/>
                    <p:nvPr/>
                  </p:nvSpPr>
                  <p:spPr>
                    <a:xfrm flipH="1">
                      <a:off x="4685400" y="4211640"/>
                      <a:ext cx="31320" cy="720"/>
                    </a:xfrm>
                    <a:prstGeom prst="line">
                      <a:avLst/>
                    </a:prstGeom>
                    <a:ln w="792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080" bIns="-4608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300" name="Line 277"/>
                    <p:cNvSpPr/>
                    <p:nvPr/>
                  </p:nvSpPr>
                  <p:spPr>
                    <a:xfrm flipH="1">
                      <a:off x="4707000" y="4145040"/>
                      <a:ext cx="10080" cy="720"/>
                    </a:xfrm>
                    <a:prstGeom prst="line">
                      <a:avLst/>
                    </a:prstGeom>
                    <a:ln w="792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080" bIns="-4608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301" name="Line 278"/>
                    <p:cNvSpPr/>
                    <p:nvPr/>
                  </p:nvSpPr>
                  <p:spPr>
                    <a:xfrm flipH="1">
                      <a:off x="4707000" y="4079880"/>
                      <a:ext cx="10080" cy="720"/>
                    </a:xfrm>
                    <a:prstGeom prst="line">
                      <a:avLst/>
                    </a:prstGeom>
                    <a:ln w="792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080" bIns="-4608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302" name="Line 279"/>
                    <p:cNvSpPr/>
                    <p:nvPr/>
                  </p:nvSpPr>
                  <p:spPr>
                    <a:xfrm flipH="1">
                      <a:off x="4707000" y="4007880"/>
                      <a:ext cx="10080" cy="720"/>
                    </a:xfrm>
                    <a:prstGeom prst="line">
                      <a:avLst/>
                    </a:prstGeom>
                    <a:ln w="792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080" bIns="-4608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303" name="Line 280"/>
                    <p:cNvSpPr/>
                    <p:nvPr/>
                  </p:nvSpPr>
                  <p:spPr>
                    <a:xfrm flipH="1">
                      <a:off x="4685400" y="3942720"/>
                      <a:ext cx="31320" cy="720"/>
                    </a:xfrm>
                    <a:prstGeom prst="line">
                      <a:avLst/>
                    </a:prstGeom>
                    <a:ln w="792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080" bIns="-4608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304" name="Line 281"/>
                    <p:cNvSpPr/>
                    <p:nvPr/>
                  </p:nvSpPr>
                  <p:spPr>
                    <a:xfrm flipH="1">
                      <a:off x="4707000" y="3876480"/>
                      <a:ext cx="10080" cy="720"/>
                    </a:xfrm>
                    <a:prstGeom prst="line">
                      <a:avLst/>
                    </a:prstGeom>
                    <a:ln w="792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080" bIns="-4608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305" name="Line 282"/>
                    <p:cNvSpPr/>
                    <p:nvPr/>
                  </p:nvSpPr>
                  <p:spPr>
                    <a:xfrm flipH="1">
                      <a:off x="4707000" y="3805200"/>
                      <a:ext cx="10080" cy="1080"/>
                    </a:xfrm>
                    <a:prstGeom prst="line">
                      <a:avLst/>
                    </a:prstGeom>
                    <a:ln w="792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5720" bIns="-4572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306" name="Line 283"/>
                    <p:cNvSpPr/>
                    <p:nvPr/>
                  </p:nvSpPr>
                  <p:spPr>
                    <a:xfrm flipH="1">
                      <a:off x="4707000" y="3740040"/>
                      <a:ext cx="10080" cy="720"/>
                    </a:xfrm>
                    <a:prstGeom prst="line">
                      <a:avLst/>
                    </a:prstGeom>
                    <a:ln w="792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080" bIns="-4608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307" name="Line 284"/>
                    <p:cNvSpPr/>
                    <p:nvPr/>
                  </p:nvSpPr>
                  <p:spPr>
                    <a:xfrm flipH="1">
                      <a:off x="4685400" y="3673800"/>
                      <a:ext cx="31320" cy="1080"/>
                    </a:xfrm>
                    <a:prstGeom prst="line">
                      <a:avLst/>
                    </a:prstGeom>
                    <a:ln w="792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5720" bIns="-4572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308" name="Line 285"/>
                    <p:cNvSpPr/>
                    <p:nvPr/>
                  </p:nvSpPr>
                  <p:spPr>
                    <a:xfrm flipH="1">
                      <a:off x="4707000" y="3602880"/>
                      <a:ext cx="10080" cy="720"/>
                    </a:xfrm>
                    <a:prstGeom prst="line">
                      <a:avLst/>
                    </a:prstGeom>
                    <a:ln w="792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080" bIns="-4608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309" name="Line 286"/>
                    <p:cNvSpPr/>
                    <p:nvPr/>
                  </p:nvSpPr>
                  <p:spPr>
                    <a:xfrm flipH="1">
                      <a:off x="4707000" y="3536280"/>
                      <a:ext cx="10080" cy="1080"/>
                    </a:xfrm>
                    <a:prstGeom prst="line">
                      <a:avLst/>
                    </a:prstGeom>
                    <a:ln w="792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5720" bIns="-4572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310" name="Line 287"/>
                    <p:cNvSpPr/>
                    <p:nvPr/>
                  </p:nvSpPr>
                  <p:spPr>
                    <a:xfrm flipH="1">
                      <a:off x="4707000" y="3471120"/>
                      <a:ext cx="10080" cy="720"/>
                    </a:xfrm>
                    <a:prstGeom prst="line">
                      <a:avLst/>
                    </a:prstGeom>
                    <a:ln w="792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080" bIns="-4608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311" name="Line 288"/>
                    <p:cNvSpPr/>
                    <p:nvPr/>
                  </p:nvSpPr>
                  <p:spPr>
                    <a:xfrm flipH="1">
                      <a:off x="4685400" y="3399120"/>
                      <a:ext cx="31320" cy="720"/>
                    </a:xfrm>
                    <a:prstGeom prst="line">
                      <a:avLst/>
                    </a:prstGeom>
                    <a:ln w="792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080" bIns="-4608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312" name="Line 289"/>
                    <p:cNvSpPr/>
                    <p:nvPr/>
                  </p:nvSpPr>
                  <p:spPr>
                    <a:xfrm flipH="1">
                      <a:off x="4707000" y="3333960"/>
                      <a:ext cx="10080" cy="720"/>
                    </a:xfrm>
                    <a:prstGeom prst="line">
                      <a:avLst/>
                    </a:prstGeom>
                    <a:ln w="792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080" bIns="-4608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313" name="Line 290"/>
                    <p:cNvSpPr/>
                    <p:nvPr/>
                  </p:nvSpPr>
                  <p:spPr>
                    <a:xfrm flipH="1">
                      <a:off x="4707000" y="3267720"/>
                      <a:ext cx="10080" cy="720"/>
                    </a:xfrm>
                    <a:prstGeom prst="line">
                      <a:avLst/>
                    </a:prstGeom>
                    <a:ln w="792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080" bIns="-4608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314" name="Line 291"/>
                    <p:cNvSpPr/>
                    <p:nvPr/>
                  </p:nvSpPr>
                  <p:spPr>
                    <a:xfrm flipH="1">
                      <a:off x="4707000" y="3196440"/>
                      <a:ext cx="10080" cy="1080"/>
                    </a:xfrm>
                    <a:prstGeom prst="line">
                      <a:avLst/>
                    </a:prstGeom>
                    <a:ln w="792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5720" bIns="-4572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315" name="Line 292"/>
                    <p:cNvSpPr/>
                    <p:nvPr/>
                  </p:nvSpPr>
                  <p:spPr>
                    <a:xfrm flipH="1">
                      <a:off x="4685400" y="3130200"/>
                      <a:ext cx="31320" cy="720"/>
                    </a:xfrm>
                    <a:prstGeom prst="line">
                      <a:avLst/>
                    </a:prstGeom>
                    <a:ln w="792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080" bIns="-4608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316" name="Line 293"/>
                    <p:cNvSpPr/>
                    <p:nvPr/>
                  </p:nvSpPr>
                  <p:spPr>
                    <a:xfrm flipH="1">
                      <a:off x="4707000" y="3065040"/>
                      <a:ext cx="10080" cy="1080"/>
                    </a:xfrm>
                    <a:prstGeom prst="line">
                      <a:avLst/>
                    </a:prstGeom>
                    <a:ln w="792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5720" bIns="-4572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317" name="Line 294"/>
                    <p:cNvSpPr/>
                    <p:nvPr/>
                  </p:nvSpPr>
                  <p:spPr>
                    <a:xfrm flipH="1">
                      <a:off x="4707000" y="2994120"/>
                      <a:ext cx="10080" cy="720"/>
                    </a:xfrm>
                    <a:prstGeom prst="line">
                      <a:avLst/>
                    </a:prstGeom>
                    <a:ln w="792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080" bIns="-4608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318" name="Line 295"/>
                    <p:cNvSpPr/>
                    <p:nvPr/>
                  </p:nvSpPr>
                  <p:spPr>
                    <a:xfrm flipH="1">
                      <a:off x="4707000" y="2927520"/>
                      <a:ext cx="10080" cy="1080"/>
                    </a:xfrm>
                    <a:prstGeom prst="line">
                      <a:avLst/>
                    </a:prstGeom>
                    <a:ln w="792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5720" bIns="-4572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319" name="Line 296"/>
                    <p:cNvSpPr/>
                    <p:nvPr/>
                  </p:nvSpPr>
                  <p:spPr>
                    <a:xfrm flipH="1">
                      <a:off x="4685400" y="2862720"/>
                      <a:ext cx="31320" cy="720"/>
                    </a:xfrm>
                    <a:prstGeom prst="line">
                      <a:avLst/>
                    </a:prstGeom>
                    <a:ln w="792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080" bIns="-4608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</p:grpSp>
              <p:sp>
                <p:nvSpPr>
                  <p:cNvPr id="320" name="Rectangle 297"/>
                  <p:cNvSpPr/>
                  <p:nvPr/>
                </p:nvSpPr>
                <p:spPr>
                  <a:xfrm rot="16200000">
                    <a:off x="4006800" y="3426840"/>
                    <a:ext cx="662040" cy="18288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457200"/>
                        <a:tab algn="l" pos="914400"/>
                        <a:tab algn="l" pos="1371600"/>
                        <a:tab algn="l" pos="1828800"/>
                        <a:tab algn="l" pos="2286000"/>
                        <a:tab algn="l" pos="2743200"/>
                        <a:tab algn="l" pos="3200400"/>
                        <a:tab algn="l" pos="3657600"/>
                        <a:tab algn="l" pos="4114800"/>
                        <a:tab algn="l" pos="4572000"/>
                        <a:tab algn="l" pos="5029200"/>
                        <a:tab algn="l" pos="5486400"/>
                        <a:tab algn="l" pos="5943600"/>
                        <a:tab algn="l" pos="6400800"/>
                        <a:tab algn="l" pos="6858000"/>
                        <a:tab algn="l" pos="7315200"/>
                        <a:tab algn="l" pos="7772400"/>
                        <a:tab algn="l" pos="8229600"/>
                        <a:tab algn="l" pos="8686800"/>
                        <a:tab algn="l" pos="9144000"/>
                      </a:tabLst>
                    </a:pPr>
                    <a:r>
                      <a:rPr b="1" lang="en-US" sz="1200" spc="-1" strike="noStrike">
                        <a:solidFill>
                          <a:srgbClr val="000000"/>
                        </a:solidFill>
                        <a:latin typeface="Arial"/>
                      </a:rPr>
                      <a:t>% of Max</a:t>
                    </a:r>
                    <a:endParaRPr b="0" lang="en-US" sz="12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21" name="Freeform 298"/>
                  <p:cNvSpPr/>
                  <p:nvPr/>
                </p:nvSpPr>
                <p:spPr>
                  <a:xfrm>
                    <a:off x="4728600" y="2879640"/>
                    <a:ext cx="1391760" cy="1325520"/>
                  </a:xfrm>
                  <a:prstGeom prst="pie">
                    <a:avLst/>
                  </a:prstGeom>
                  <a:noFill/>
                  <a:ln w="792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457200"/>
                        <a:tab algn="l" pos="914400"/>
                        <a:tab algn="l" pos="1371600"/>
                        <a:tab algn="l" pos="1828800"/>
                        <a:tab algn="l" pos="2286000"/>
                        <a:tab algn="l" pos="2743200"/>
                        <a:tab algn="l" pos="3200400"/>
                        <a:tab algn="l" pos="3657600"/>
                        <a:tab algn="l" pos="4114800"/>
                        <a:tab algn="l" pos="4572000"/>
                        <a:tab algn="l" pos="5029200"/>
                        <a:tab algn="l" pos="5486400"/>
                        <a:tab algn="l" pos="5943600"/>
                        <a:tab algn="l" pos="6400800"/>
                        <a:tab algn="l" pos="6858000"/>
                        <a:tab algn="l" pos="7315200"/>
                        <a:tab algn="l" pos="7772400"/>
                        <a:tab algn="l" pos="8229600"/>
                        <a:tab algn="l" pos="8686800"/>
                        <a:tab algn="l" pos="9144000"/>
                      </a:tabLst>
                    </a:pPr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22" name="Freeform 299"/>
                  <p:cNvSpPr/>
                  <p:nvPr/>
                </p:nvSpPr>
                <p:spPr>
                  <a:xfrm>
                    <a:off x="4728600" y="2879640"/>
                    <a:ext cx="1391760" cy="1325520"/>
                  </a:xfrm>
                  <a:prstGeom prst="pie">
                    <a:avLst/>
                  </a:prstGeom>
                  <a:blipFill rotWithShape="0">
                    <a:blip r:embed="rId6"/>
                    <a:srcRect/>
                    <a:tile tx="0" ty="0" sx="100000" sy="100000" algn="ctr"/>
                  </a:blipFill>
                  <a:ln w="468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457200"/>
                        <a:tab algn="l" pos="914400"/>
                        <a:tab algn="l" pos="1371600"/>
                        <a:tab algn="l" pos="1828800"/>
                        <a:tab algn="l" pos="2286000"/>
                        <a:tab algn="l" pos="2743200"/>
                        <a:tab algn="l" pos="3200400"/>
                        <a:tab algn="l" pos="3657600"/>
                        <a:tab algn="l" pos="4114800"/>
                        <a:tab algn="l" pos="4572000"/>
                        <a:tab algn="l" pos="5029200"/>
                        <a:tab algn="l" pos="5486400"/>
                        <a:tab algn="l" pos="5943600"/>
                        <a:tab algn="l" pos="6400800"/>
                        <a:tab algn="l" pos="6858000"/>
                        <a:tab algn="l" pos="7315200"/>
                        <a:tab algn="l" pos="7772400"/>
                        <a:tab algn="l" pos="8229600"/>
                        <a:tab algn="l" pos="8686800"/>
                        <a:tab algn="l" pos="9144000"/>
                      </a:tabLst>
                    </a:pPr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23" name="Freeform 300"/>
                  <p:cNvSpPr/>
                  <p:nvPr/>
                </p:nvSpPr>
                <p:spPr>
                  <a:xfrm>
                    <a:off x="4728600" y="2879640"/>
                    <a:ext cx="1397520" cy="1325520"/>
                  </a:xfrm>
                  <a:prstGeom prst="pie">
                    <a:avLst/>
                  </a:prstGeom>
                  <a:solidFill>
                    <a:srgbClr val="000000"/>
                  </a:solidFill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457200"/>
                        <a:tab algn="l" pos="914400"/>
                        <a:tab algn="l" pos="1371600"/>
                        <a:tab algn="l" pos="1828800"/>
                        <a:tab algn="l" pos="2286000"/>
                        <a:tab algn="l" pos="2743200"/>
                        <a:tab algn="l" pos="3200400"/>
                        <a:tab algn="l" pos="3657600"/>
                        <a:tab algn="l" pos="4114800"/>
                        <a:tab algn="l" pos="4572000"/>
                        <a:tab algn="l" pos="5029200"/>
                        <a:tab algn="l" pos="5486400"/>
                        <a:tab algn="l" pos="5943600"/>
                        <a:tab algn="l" pos="6400800"/>
                        <a:tab algn="l" pos="6858000"/>
                        <a:tab algn="l" pos="7315200"/>
                        <a:tab algn="l" pos="7772400"/>
                        <a:tab algn="l" pos="8229600"/>
                        <a:tab algn="l" pos="8686800"/>
                        <a:tab algn="l" pos="9144000"/>
                      </a:tabLst>
                    </a:pPr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24" name="Text Box 303"/>
                  <p:cNvSpPr/>
                  <p:nvPr/>
                </p:nvSpPr>
                <p:spPr>
                  <a:xfrm>
                    <a:off x="5421240" y="3040920"/>
                    <a:ext cx="436680" cy="27648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t">
                    <a:spAutoFit/>
                  </a:bodyPr>
                  <a:p>
                    <a:pPr>
                      <a:tabLst>
                        <a:tab algn="l" pos="0"/>
                        <a:tab algn="l" pos="457200"/>
                        <a:tab algn="l" pos="914400"/>
                        <a:tab algn="l" pos="1371600"/>
                        <a:tab algn="l" pos="1828800"/>
                        <a:tab algn="l" pos="2286000"/>
                        <a:tab algn="l" pos="2743200"/>
                        <a:tab algn="l" pos="3200400"/>
                        <a:tab algn="l" pos="3657600"/>
                        <a:tab algn="l" pos="4114800"/>
                        <a:tab algn="l" pos="4572000"/>
                        <a:tab algn="l" pos="5029200"/>
                        <a:tab algn="l" pos="5486400"/>
                        <a:tab algn="l" pos="5943600"/>
                        <a:tab algn="l" pos="6400800"/>
                        <a:tab algn="l" pos="6858000"/>
                        <a:tab algn="l" pos="7315200"/>
                        <a:tab algn="l" pos="7772400"/>
                        <a:tab algn="l" pos="8229600"/>
                        <a:tab algn="l" pos="8686800"/>
                        <a:tab algn="l" pos="9144000"/>
                      </a:tabLst>
                    </a:pPr>
                    <a:r>
                      <a:rPr b="1" lang="en-US" sz="1200" spc="-1" strike="noStrike">
                        <a:solidFill>
                          <a:srgbClr val="000000"/>
                        </a:solidFill>
                        <a:latin typeface="Arial"/>
                      </a:rPr>
                      <a:t>142</a:t>
                    </a:r>
                    <a:endParaRPr b="0" lang="en-US" sz="12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25" name="Text Box 304"/>
                  <p:cNvSpPr/>
                  <p:nvPr/>
                </p:nvSpPr>
                <p:spPr>
                  <a:xfrm>
                    <a:off x="5127480" y="2718720"/>
                    <a:ext cx="374400" cy="27648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spAutoFit/>
                  </a:bodyPr>
                  <a:p>
                    <a:pPr>
                      <a:tabLst>
                        <a:tab algn="l" pos="0"/>
                        <a:tab algn="l" pos="457200"/>
                        <a:tab algn="l" pos="914400"/>
                        <a:tab algn="l" pos="1371600"/>
                        <a:tab algn="l" pos="1828800"/>
                        <a:tab algn="l" pos="2286000"/>
                        <a:tab algn="l" pos="2743200"/>
                        <a:tab algn="l" pos="3200400"/>
                        <a:tab algn="l" pos="3657600"/>
                        <a:tab algn="l" pos="4114800"/>
                        <a:tab algn="l" pos="4572000"/>
                        <a:tab algn="l" pos="5029200"/>
                        <a:tab algn="l" pos="5486400"/>
                        <a:tab algn="l" pos="5943600"/>
                        <a:tab algn="l" pos="6400800"/>
                        <a:tab algn="l" pos="6858000"/>
                        <a:tab algn="l" pos="7315200"/>
                        <a:tab algn="l" pos="7772400"/>
                        <a:tab algn="l" pos="8229600"/>
                        <a:tab algn="l" pos="8686800"/>
                        <a:tab algn="l" pos="9144000"/>
                      </a:tabLst>
                    </a:pPr>
                    <a:r>
                      <a:rPr b="1" lang="en-US" sz="1200" spc="-1" strike="noStrike">
                        <a:solidFill>
                          <a:srgbClr val="000000"/>
                        </a:solidFill>
                        <a:latin typeface="Arial"/>
                      </a:rPr>
                      <a:t>53</a:t>
                    </a:r>
                    <a:endParaRPr b="0" lang="en-US" sz="12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sp>
              <p:nvSpPr>
                <p:cNvPr id="326" name="Line 307"/>
                <p:cNvSpPr/>
                <p:nvPr/>
              </p:nvSpPr>
              <p:spPr>
                <a:xfrm>
                  <a:off x="5105520" y="4595400"/>
                  <a:ext cx="1015920" cy="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  <a:tailEnd len="med" type="triangle" w="med"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ctr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27" name="TextBox 483"/>
                <p:cNvSpPr/>
                <p:nvPr/>
              </p:nvSpPr>
              <p:spPr>
                <a:xfrm>
                  <a:off x="3645000" y="415440"/>
                  <a:ext cx="444240" cy="3988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1" lang="en-US" sz="2000" spc="-1" strike="noStrike">
                      <a:solidFill>
                        <a:srgbClr val="000000"/>
                      </a:solidFill>
                      <a:latin typeface="Arial"/>
                    </a:rPr>
                    <a:t>C</a:t>
                  </a:r>
                  <a:endParaRPr b="0" lang="en-US" sz="2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grpSp>
              <p:nvGrpSpPr>
                <p:cNvPr id="328" name="Group 16"/>
                <p:cNvGrpSpPr/>
                <p:nvPr/>
              </p:nvGrpSpPr>
              <p:grpSpPr>
                <a:xfrm>
                  <a:off x="1097280" y="488520"/>
                  <a:ext cx="1652760" cy="1517400"/>
                  <a:chOff x="1097280" y="488520"/>
                  <a:chExt cx="1652760" cy="1517400"/>
                </a:xfrm>
              </p:grpSpPr>
              <p:sp>
                <p:nvSpPr>
                  <p:cNvPr id="329" name="Rectangle 18"/>
                  <p:cNvSpPr/>
                  <p:nvPr/>
                </p:nvSpPr>
                <p:spPr>
                  <a:xfrm>
                    <a:off x="1326240" y="504720"/>
                    <a:ext cx="1364040" cy="1157400"/>
                  </a:xfrm>
                  <a:prstGeom prst="rect">
                    <a:avLst/>
                  </a:prstGeom>
                  <a:solidFill>
                    <a:srgbClr val="ffffff"/>
                  </a:solidFill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457200"/>
                        <a:tab algn="l" pos="914400"/>
                        <a:tab algn="l" pos="1371600"/>
                        <a:tab algn="l" pos="1828800"/>
                        <a:tab algn="l" pos="2286000"/>
                        <a:tab algn="l" pos="2743200"/>
                        <a:tab algn="l" pos="3200400"/>
                        <a:tab algn="l" pos="3657600"/>
                        <a:tab algn="l" pos="4114800"/>
                        <a:tab algn="l" pos="4572000"/>
                        <a:tab algn="l" pos="5029200"/>
                        <a:tab algn="l" pos="5486400"/>
                        <a:tab algn="l" pos="5943600"/>
                        <a:tab algn="l" pos="6400800"/>
                        <a:tab algn="l" pos="6858000"/>
                        <a:tab algn="l" pos="7315200"/>
                        <a:tab algn="l" pos="7772400"/>
                        <a:tab algn="l" pos="8229600"/>
                        <a:tab algn="l" pos="8686800"/>
                        <a:tab algn="l" pos="9144000"/>
                      </a:tabLst>
                    </a:pPr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30" name="Line 6"/>
                  <p:cNvSpPr/>
                  <p:nvPr/>
                </p:nvSpPr>
                <p:spPr>
                  <a:xfrm>
                    <a:off x="1326240" y="1657440"/>
                    <a:ext cx="1359360" cy="72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080" bIns="-4608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grpSp>
                <p:nvGrpSpPr>
                  <p:cNvPr id="331" name="Group 20"/>
                  <p:cNvGrpSpPr/>
                  <p:nvPr/>
                </p:nvGrpSpPr>
                <p:grpSpPr>
                  <a:xfrm>
                    <a:off x="1325880" y="1662120"/>
                    <a:ext cx="1359720" cy="27000"/>
                    <a:chOff x="1325880" y="1662120"/>
                    <a:chExt cx="1359720" cy="27000"/>
                  </a:xfrm>
                </p:grpSpPr>
                <p:sp>
                  <p:nvSpPr>
                    <p:cNvPr id="332" name="Line 8"/>
                    <p:cNvSpPr/>
                    <p:nvPr/>
                  </p:nvSpPr>
                  <p:spPr>
                    <a:xfrm>
                      <a:off x="1325880" y="1662120"/>
                      <a:ext cx="720" cy="27000"/>
                    </a:xfrm>
                    <a:prstGeom prst="line">
                      <a:avLst/>
                    </a:prstGeom>
                    <a:ln w="1260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19800" bIns="-198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333" name="Line 9"/>
                    <p:cNvSpPr/>
                    <p:nvPr/>
                  </p:nvSpPr>
                  <p:spPr>
                    <a:xfrm>
                      <a:off x="1425600" y="1662120"/>
                      <a:ext cx="720" cy="8640"/>
                    </a:xfrm>
                    <a:prstGeom prst="line">
                      <a:avLst/>
                    </a:prstGeom>
                    <a:ln w="1260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8160" bIns="-3816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334" name="Line 10"/>
                    <p:cNvSpPr/>
                    <p:nvPr/>
                  </p:nvSpPr>
                  <p:spPr>
                    <a:xfrm>
                      <a:off x="1483920" y="1662120"/>
                      <a:ext cx="720" cy="8640"/>
                    </a:xfrm>
                    <a:prstGeom prst="line">
                      <a:avLst/>
                    </a:prstGeom>
                    <a:ln w="1260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8160" bIns="-3816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335" name="Line 11"/>
                    <p:cNvSpPr/>
                    <p:nvPr/>
                  </p:nvSpPr>
                  <p:spPr>
                    <a:xfrm>
                      <a:off x="1526040" y="1662120"/>
                      <a:ext cx="720" cy="8640"/>
                    </a:xfrm>
                    <a:prstGeom prst="line">
                      <a:avLst/>
                    </a:prstGeom>
                    <a:ln w="1260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8160" bIns="-3816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336" name="Line 12"/>
                    <p:cNvSpPr/>
                    <p:nvPr/>
                  </p:nvSpPr>
                  <p:spPr>
                    <a:xfrm>
                      <a:off x="1562760" y="1662120"/>
                      <a:ext cx="720" cy="17280"/>
                    </a:xfrm>
                    <a:prstGeom prst="line">
                      <a:avLst/>
                    </a:prstGeom>
                    <a:ln w="1260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29520" bIns="-2952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337" name="Line 13"/>
                    <p:cNvSpPr/>
                    <p:nvPr/>
                  </p:nvSpPr>
                  <p:spPr>
                    <a:xfrm>
                      <a:off x="1589400" y="1662120"/>
                      <a:ext cx="720" cy="8640"/>
                    </a:xfrm>
                    <a:prstGeom prst="line">
                      <a:avLst/>
                    </a:prstGeom>
                    <a:ln w="1260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8160" bIns="-3816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338" name="Line 14"/>
                    <p:cNvSpPr/>
                    <p:nvPr/>
                  </p:nvSpPr>
                  <p:spPr>
                    <a:xfrm>
                      <a:off x="1609920" y="1662120"/>
                      <a:ext cx="720" cy="8640"/>
                    </a:xfrm>
                    <a:prstGeom prst="line">
                      <a:avLst/>
                    </a:prstGeom>
                    <a:ln w="1260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8160" bIns="-3816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339" name="Line 15"/>
                    <p:cNvSpPr/>
                    <p:nvPr/>
                  </p:nvSpPr>
                  <p:spPr>
                    <a:xfrm>
                      <a:off x="1631520" y="1662120"/>
                      <a:ext cx="720" cy="8640"/>
                    </a:xfrm>
                    <a:prstGeom prst="line">
                      <a:avLst/>
                    </a:prstGeom>
                    <a:ln w="1260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8160" bIns="-3816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340" name="Line 16"/>
                    <p:cNvSpPr/>
                    <p:nvPr/>
                  </p:nvSpPr>
                  <p:spPr>
                    <a:xfrm>
                      <a:off x="1646640" y="1662120"/>
                      <a:ext cx="720" cy="8640"/>
                    </a:xfrm>
                    <a:prstGeom prst="line">
                      <a:avLst/>
                    </a:prstGeom>
                    <a:ln w="1260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8160" bIns="-3816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341" name="Line 17"/>
                    <p:cNvSpPr/>
                    <p:nvPr/>
                  </p:nvSpPr>
                  <p:spPr>
                    <a:xfrm>
                      <a:off x="1662840" y="1662120"/>
                      <a:ext cx="720" cy="27000"/>
                    </a:xfrm>
                    <a:prstGeom prst="line">
                      <a:avLst/>
                    </a:prstGeom>
                    <a:ln w="1260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19800" bIns="-198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342" name="Line 18"/>
                    <p:cNvSpPr/>
                    <p:nvPr/>
                  </p:nvSpPr>
                  <p:spPr>
                    <a:xfrm>
                      <a:off x="1767960" y="1662120"/>
                      <a:ext cx="720" cy="8640"/>
                    </a:xfrm>
                    <a:prstGeom prst="line">
                      <a:avLst/>
                    </a:prstGeom>
                    <a:ln w="1260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8160" bIns="-3816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343" name="Line 19"/>
                    <p:cNvSpPr/>
                    <p:nvPr/>
                  </p:nvSpPr>
                  <p:spPr>
                    <a:xfrm>
                      <a:off x="1826280" y="1662120"/>
                      <a:ext cx="720" cy="8640"/>
                    </a:xfrm>
                    <a:prstGeom prst="line">
                      <a:avLst/>
                    </a:prstGeom>
                    <a:ln w="1260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8160" bIns="-3816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344" name="Line 20"/>
                    <p:cNvSpPr/>
                    <p:nvPr/>
                  </p:nvSpPr>
                  <p:spPr>
                    <a:xfrm>
                      <a:off x="1867680" y="1662120"/>
                      <a:ext cx="720" cy="8640"/>
                    </a:xfrm>
                    <a:prstGeom prst="line">
                      <a:avLst/>
                    </a:prstGeom>
                    <a:ln w="1260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8160" bIns="-3816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345" name="Line 21"/>
                    <p:cNvSpPr/>
                    <p:nvPr/>
                  </p:nvSpPr>
                  <p:spPr>
                    <a:xfrm>
                      <a:off x="1899720" y="1662120"/>
                      <a:ext cx="720" cy="17280"/>
                    </a:xfrm>
                    <a:prstGeom prst="line">
                      <a:avLst/>
                    </a:prstGeom>
                    <a:ln w="1260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29520" bIns="-2952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346" name="Line 22"/>
                    <p:cNvSpPr/>
                    <p:nvPr/>
                  </p:nvSpPr>
                  <p:spPr>
                    <a:xfrm>
                      <a:off x="1931760" y="1662120"/>
                      <a:ext cx="720" cy="8640"/>
                    </a:xfrm>
                    <a:prstGeom prst="line">
                      <a:avLst/>
                    </a:prstGeom>
                    <a:ln w="1260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8160" bIns="-3816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347" name="Line 23"/>
                    <p:cNvSpPr/>
                    <p:nvPr/>
                  </p:nvSpPr>
                  <p:spPr>
                    <a:xfrm>
                      <a:off x="1952640" y="1662120"/>
                      <a:ext cx="720" cy="8640"/>
                    </a:xfrm>
                    <a:prstGeom prst="line">
                      <a:avLst/>
                    </a:prstGeom>
                    <a:ln w="1260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8160" bIns="-3816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348" name="Line 24"/>
                    <p:cNvSpPr/>
                    <p:nvPr/>
                  </p:nvSpPr>
                  <p:spPr>
                    <a:xfrm>
                      <a:off x="1973160" y="1662120"/>
                      <a:ext cx="720" cy="8640"/>
                    </a:xfrm>
                    <a:prstGeom prst="line">
                      <a:avLst/>
                    </a:prstGeom>
                    <a:ln w="1260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8160" bIns="-3816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349" name="Line 25"/>
                    <p:cNvSpPr/>
                    <p:nvPr/>
                  </p:nvSpPr>
                  <p:spPr>
                    <a:xfrm>
                      <a:off x="1989360" y="1662120"/>
                      <a:ext cx="720" cy="8640"/>
                    </a:xfrm>
                    <a:prstGeom prst="line">
                      <a:avLst/>
                    </a:prstGeom>
                    <a:ln w="1260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8160" bIns="-3816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350" name="Line 26"/>
                    <p:cNvSpPr/>
                    <p:nvPr/>
                  </p:nvSpPr>
                  <p:spPr>
                    <a:xfrm>
                      <a:off x="2005200" y="1662120"/>
                      <a:ext cx="720" cy="27000"/>
                    </a:xfrm>
                    <a:prstGeom prst="line">
                      <a:avLst/>
                    </a:prstGeom>
                    <a:ln w="1260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19800" bIns="-198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351" name="Line 27"/>
                    <p:cNvSpPr/>
                    <p:nvPr/>
                  </p:nvSpPr>
                  <p:spPr>
                    <a:xfrm>
                      <a:off x="2104920" y="1662120"/>
                      <a:ext cx="720" cy="8640"/>
                    </a:xfrm>
                    <a:prstGeom prst="line">
                      <a:avLst/>
                    </a:prstGeom>
                    <a:ln w="1260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8160" bIns="-3816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352" name="Line 28"/>
                    <p:cNvSpPr/>
                    <p:nvPr/>
                  </p:nvSpPr>
                  <p:spPr>
                    <a:xfrm>
                      <a:off x="2167920" y="1662120"/>
                      <a:ext cx="720" cy="8640"/>
                    </a:xfrm>
                    <a:prstGeom prst="line">
                      <a:avLst/>
                    </a:prstGeom>
                    <a:ln w="1260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8160" bIns="-3816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353" name="Line 29"/>
                    <p:cNvSpPr/>
                    <p:nvPr/>
                  </p:nvSpPr>
                  <p:spPr>
                    <a:xfrm>
                      <a:off x="2210400" y="1662120"/>
                      <a:ext cx="720" cy="8640"/>
                    </a:xfrm>
                    <a:prstGeom prst="line">
                      <a:avLst/>
                    </a:prstGeom>
                    <a:ln w="1260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8160" bIns="-3816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354" name="Line 30"/>
                    <p:cNvSpPr/>
                    <p:nvPr/>
                  </p:nvSpPr>
                  <p:spPr>
                    <a:xfrm>
                      <a:off x="2242440" y="1662120"/>
                      <a:ext cx="720" cy="17280"/>
                    </a:xfrm>
                    <a:prstGeom prst="line">
                      <a:avLst/>
                    </a:prstGeom>
                    <a:ln w="1260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29520" bIns="-2952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355" name="Line 31"/>
                    <p:cNvSpPr/>
                    <p:nvPr/>
                  </p:nvSpPr>
                  <p:spPr>
                    <a:xfrm>
                      <a:off x="2268720" y="1662120"/>
                      <a:ext cx="720" cy="8640"/>
                    </a:xfrm>
                    <a:prstGeom prst="line">
                      <a:avLst/>
                    </a:prstGeom>
                    <a:ln w="1260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8160" bIns="-3816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356" name="Line 32"/>
                    <p:cNvSpPr/>
                    <p:nvPr/>
                  </p:nvSpPr>
                  <p:spPr>
                    <a:xfrm>
                      <a:off x="2295000" y="1662120"/>
                      <a:ext cx="720" cy="8640"/>
                    </a:xfrm>
                    <a:prstGeom prst="line">
                      <a:avLst/>
                    </a:prstGeom>
                    <a:ln w="1260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8160" bIns="-3816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357" name="Line 33"/>
                    <p:cNvSpPr/>
                    <p:nvPr/>
                  </p:nvSpPr>
                  <p:spPr>
                    <a:xfrm>
                      <a:off x="2311200" y="1662120"/>
                      <a:ext cx="720" cy="8640"/>
                    </a:xfrm>
                    <a:prstGeom prst="line">
                      <a:avLst/>
                    </a:prstGeom>
                    <a:ln w="1260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8160" bIns="-3816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358" name="Line 34"/>
                    <p:cNvSpPr/>
                    <p:nvPr/>
                  </p:nvSpPr>
                  <p:spPr>
                    <a:xfrm>
                      <a:off x="2331720" y="1662120"/>
                      <a:ext cx="720" cy="8640"/>
                    </a:xfrm>
                    <a:prstGeom prst="line">
                      <a:avLst/>
                    </a:prstGeom>
                    <a:ln w="1260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8160" bIns="-3816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359" name="Line 35"/>
                    <p:cNvSpPr/>
                    <p:nvPr/>
                  </p:nvSpPr>
                  <p:spPr>
                    <a:xfrm>
                      <a:off x="2347560" y="1662120"/>
                      <a:ext cx="720" cy="27000"/>
                    </a:xfrm>
                    <a:prstGeom prst="line">
                      <a:avLst/>
                    </a:prstGeom>
                    <a:ln w="1260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19800" bIns="-198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360" name="Line 36"/>
                    <p:cNvSpPr/>
                    <p:nvPr/>
                  </p:nvSpPr>
                  <p:spPr>
                    <a:xfrm>
                      <a:off x="2447280" y="1662120"/>
                      <a:ext cx="720" cy="8640"/>
                    </a:xfrm>
                    <a:prstGeom prst="line">
                      <a:avLst/>
                    </a:prstGeom>
                    <a:ln w="1260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8160" bIns="-3816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361" name="Line 37"/>
                    <p:cNvSpPr/>
                    <p:nvPr/>
                  </p:nvSpPr>
                  <p:spPr>
                    <a:xfrm>
                      <a:off x="2510640" y="1662120"/>
                      <a:ext cx="720" cy="8640"/>
                    </a:xfrm>
                    <a:prstGeom prst="line">
                      <a:avLst/>
                    </a:prstGeom>
                    <a:ln w="1260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8160" bIns="-3816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362" name="Line 38"/>
                    <p:cNvSpPr/>
                    <p:nvPr/>
                  </p:nvSpPr>
                  <p:spPr>
                    <a:xfrm>
                      <a:off x="2552760" y="1662120"/>
                      <a:ext cx="720" cy="8640"/>
                    </a:xfrm>
                    <a:prstGeom prst="line">
                      <a:avLst/>
                    </a:prstGeom>
                    <a:ln w="1260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8160" bIns="-3816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363" name="Line 39"/>
                    <p:cNvSpPr/>
                    <p:nvPr/>
                  </p:nvSpPr>
                  <p:spPr>
                    <a:xfrm>
                      <a:off x="2584800" y="1662120"/>
                      <a:ext cx="720" cy="17280"/>
                    </a:xfrm>
                    <a:prstGeom prst="line">
                      <a:avLst/>
                    </a:prstGeom>
                    <a:ln w="1260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29520" bIns="-2952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364" name="Line 40"/>
                    <p:cNvSpPr/>
                    <p:nvPr/>
                  </p:nvSpPr>
                  <p:spPr>
                    <a:xfrm>
                      <a:off x="2610360" y="1662120"/>
                      <a:ext cx="720" cy="8640"/>
                    </a:xfrm>
                    <a:prstGeom prst="line">
                      <a:avLst/>
                    </a:prstGeom>
                    <a:ln w="1260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8160" bIns="-3816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365" name="Line 41"/>
                    <p:cNvSpPr/>
                    <p:nvPr/>
                  </p:nvSpPr>
                  <p:spPr>
                    <a:xfrm>
                      <a:off x="2631960" y="1662120"/>
                      <a:ext cx="720" cy="8640"/>
                    </a:xfrm>
                    <a:prstGeom prst="line">
                      <a:avLst/>
                    </a:prstGeom>
                    <a:ln w="1260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8160" bIns="-3816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366" name="Line 42"/>
                    <p:cNvSpPr/>
                    <p:nvPr/>
                  </p:nvSpPr>
                  <p:spPr>
                    <a:xfrm>
                      <a:off x="2652840" y="1662120"/>
                      <a:ext cx="720" cy="8640"/>
                    </a:xfrm>
                    <a:prstGeom prst="line">
                      <a:avLst/>
                    </a:prstGeom>
                    <a:ln w="1260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8160" bIns="-3816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367" name="Line 43"/>
                    <p:cNvSpPr/>
                    <p:nvPr/>
                  </p:nvSpPr>
                  <p:spPr>
                    <a:xfrm>
                      <a:off x="2668680" y="1662120"/>
                      <a:ext cx="720" cy="8640"/>
                    </a:xfrm>
                    <a:prstGeom prst="line">
                      <a:avLst/>
                    </a:prstGeom>
                    <a:ln w="1260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38160" bIns="-3816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368" name="Line 44"/>
                    <p:cNvSpPr/>
                    <p:nvPr/>
                  </p:nvSpPr>
                  <p:spPr>
                    <a:xfrm>
                      <a:off x="2684880" y="1662120"/>
                      <a:ext cx="720" cy="27000"/>
                    </a:xfrm>
                    <a:prstGeom prst="line">
                      <a:avLst/>
                    </a:prstGeom>
                    <a:ln w="1260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19800" bIns="-198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</p:grpSp>
              <p:sp>
                <p:nvSpPr>
                  <p:cNvPr id="369" name="Rectangle 295"/>
                  <p:cNvSpPr/>
                  <p:nvPr/>
                </p:nvSpPr>
                <p:spPr>
                  <a:xfrm>
                    <a:off x="1243800" y="1721520"/>
                    <a:ext cx="146880" cy="1220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457200"/>
                        <a:tab algn="l" pos="914400"/>
                        <a:tab algn="l" pos="1371600"/>
                        <a:tab algn="l" pos="1828800"/>
                        <a:tab algn="l" pos="2286000"/>
                        <a:tab algn="l" pos="2743200"/>
                        <a:tab algn="l" pos="3200400"/>
                        <a:tab algn="l" pos="3657600"/>
                        <a:tab algn="l" pos="4114800"/>
                        <a:tab algn="l" pos="4572000"/>
                        <a:tab algn="l" pos="5029200"/>
                        <a:tab algn="l" pos="5486400"/>
                        <a:tab algn="l" pos="5943600"/>
                        <a:tab algn="l" pos="6400800"/>
                        <a:tab algn="l" pos="6858000"/>
                        <a:tab algn="l" pos="7315200"/>
                        <a:tab algn="l" pos="7772400"/>
                        <a:tab algn="l" pos="8229600"/>
                        <a:tab algn="l" pos="8686800"/>
                        <a:tab algn="l" pos="9144000"/>
                      </a:tabLst>
                    </a:pPr>
                    <a:r>
                      <a:rPr b="1" lang="en-US" sz="800" spc="-1" strike="noStrike">
                        <a:solidFill>
                          <a:srgbClr val="000000"/>
                        </a:solidFill>
                        <a:latin typeface="Arial"/>
                      </a:rPr>
                      <a:t>10</a:t>
                    </a:r>
                    <a:r>
                      <a:rPr b="1" lang="en-US" sz="800" spc="-1" strike="noStrike" baseline="30000">
                        <a:solidFill>
                          <a:srgbClr val="000000"/>
                        </a:solidFill>
                        <a:latin typeface="Arial"/>
                      </a:rPr>
                      <a:t>0</a:t>
                    </a:r>
                    <a:endParaRPr b="0" lang="en-US" sz="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70" name="Rectangle 296"/>
                  <p:cNvSpPr/>
                  <p:nvPr/>
                </p:nvSpPr>
                <p:spPr>
                  <a:xfrm>
                    <a:off x="1582200" y="1721520"/>
                    <a:ext cx="146880" cy="1220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457200"/>
                        <a:tab algn="l" pos="914400"/>
                        <a:tab algn="l" pos="1371600"/>
                        <a:tab algn="l" pos="1828800"/>
                        <a:tab algn="l" pos="2286000"/>
                        <a:tab algn="l" pos="2743200"/>
                        <a:tab algn="l" pos="3200400"/>
                        <a:tab algn="l" pos="3657600"/>
                        <a:tab algn="l" pos="4114800"/>
                        <a:tab algn="l" pos="4572000"/>
                        <a:tab algn="l" pos="5029200"/>
                        <a:tab algn="l" pos="5486400"/>
                        <a:tab algn="l" pos="5943600"/>
                        <a:tab algn="l" pos="6400800"/>
                        <a:tab algn="l" pos="6858000"/>
                        <a:tab algn="l" pos="7315200"/>
                        <a:tab algn="l" pos="7772400"/>
                        <a:tab algn="l" pos="8229600"/>
                        <a:tab algn="l" pos="8686800"/>
                        <a:tab algn="l" pos="9144000"/>
                      </a:tabLst>
                    </a:pPr>
                    <a:r>
                      <a:rPr b="1" lang="en-US" sz="800" spc="-1" strike="noStrike">
                        <a:solidFill>
                          <a:srgbClr val="000000"/>
                        </a:solidFill>
                        <a:latin typeface="Arial"/>
                      </a:rPr>
                      <a:t>10</a:t>
                    </a:r>
                    <a:r>
                      <a:rPr b="1" lang="en-US" sz="800" spc="-1" strike="noStrike" baseline="30000">
                        <a:solidFill>
                          <a:srgbClr val="000000"/>
                        </a:solidFill>
                        <a:latin typeface="Arial"/>
                      </a:rPr>
                      <a:t>1</a:t>
                    </a:r>
                    <a:endParaRPr b="0" lang="en-US" sz="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71" name="Rectangle 297"/>
                  <p:cNvSpPr/>
                  <p:nvPr/>
                </p:nvSpPr>
                <p:spPr>
                  <a:xfrm>
                    <a:off x="1923480" y="1721520"/>
                    <a:ext cx="146880" cy="1220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457200"/>
                        <a:tab algn="l" pos="914400"/>
                        <a:tab algn="l" pos="1371600"/>
                        <a:tab algn="l" pos="1828800"/>
                        <a:tab algn="l" pos="2286000"/>
                        <a:tab algn="l" pos="2743200"/>
                        <a:tab algn="l" pos="3200400"/>
                        <a:tab algn="l" pos="3657600"/>
                        <a:tab algn="l" pos="4114800"/>
                        <a:tab algn="l" pos="4572000"/>
                        <a:tab algn="l" pos="5029200"/>
                        <a:tab algn="l" pos="5486400"/>
                        <a:tab algn="l" pos="5943600"/>
                        <a:tab algn="l" pos="6400800"/>
                        <a:tab algn="l" pos="6858000"/>
                        <a:tab algn="l" pos="7315200"/>
                        <a:tab algn="l" pos="7772400"/>
                        <a:tab algn="l" pos="8229600"/>
                        <a:tab algn="l" pos="8686800"/>
                        <a:tab algn="l" pos="9144000"/>
                      </a:tabLst>
                    </a:pPr>
                    <a:r>
                      <a:rPr b="1" lang="en-US" sz="800" spc="-1" strike="noStrike">
                        <a:solidFill>
                          <a:srgbClr val="000000"/>
                        </a:solidFill>
                        <a:latin typeface="Arial"/>
                      </a:rPr>
                      <a:t>10</a:t>
                    </a:r>
                    <a:r>
                      <a:rPr b="1" lang="en-US" sz="800" spc="-1" strike="noStrike" baseline="30000">
                        <a:solidFill>
                          <a:srgbClr val="000000"/>
                        </a:solidFill>
                        <a:latin typeface="Arial"/>
                      </a:rPr>
                      <a:t>2</a:t>
                    </a:r>
                    <a:endParaRPr b="0" lang="en-US" sz="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72" name="Rectangle 298"/>
                  <p:cNvSpPr/>
                  <p:nvPr/>
                </p:nvSpPr>
                <p:spPr>
                  <a:xfrm>
                    <a:off x="2266560" y="1721520"/>
                    <a:ext cx="146880" cy="1220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457200"/>
                        <a:tab algn="l" pos="914400"/>
                        <a:tab algn="l" pos="1371600"/>
                        <a:tab algn="l" pos="1828800"/>
                        <a:tab algn="l" pos="2286000"/>
                        <a:tab algn="l" pos="2743200"/>
                        <a:tab algn="l" pos="3200400"/>
                        <a:tab algn="l" pos="3657600"/>
                        <a:tab algn="l" pos="4114800"/>
                        <a:tab algn="l" pos="4572000"/>
                        <a:tab algn="l" pos="5029200"/>
                        <a:tab algn="l" pos="5486400"/>
                        <a:tab algn="l" pos="5943600"/>
                        <a:tab algn="l" pos="6400800"/>
                        <a:tab algn="l" pos="6858000"/>
                        <a:tab algn="l" pos="7315200"/>
                        <a:tab algn="l" pos="7772400"/>
                        <a:tab algn="l" pos="8229600"/>
                        <a:tab algn="l" pos="8686800"/>
                        <a:tab algn="l" pos="9144000"/>
                      </a:tabLst>
                    </a:pPr>
                    <a:r>
                      <a:rPr b="1" lang="en-US" sz="800" spc="-1" strike="noStrike">
                        <a:solidFill>
                          <a:srgbClr val="000000"/>
                        </a:solidFill>
                        <a:latin typeface="Arial"/>
                      </a:rPr>
                      <a:t>10</a:t>
                    </a:r>
                    <a:r>
                      <a:rPr b="1" lang="en-US" sz="800" spc="-1" strike="noStrike" baseline="30000">
                        <a:solidFill>
                          <a:srgbClr val="000000"/>
                        </a:solidFill>
                        <a:latin typeface="Arial"/>
                      </a:rPr>
                      <a:t>3</a:t>
                    </a:r>
                    <a:endParaRPr b="0" lang="en-US" sz="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73" name="Rectangle 299"/>
                  <p:cNvSpPr/>
                  <p:nvPr/>
                </p:nvSpPr>
                <p:spPr>
                  <a:xfrm>
                    <a:off x="2603160" y="1721520"/>
                    <a:ext cx="146880" cy="1220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457200"/>
                        <a:tab algn="l" pos="914400"/>
                        <a:tab algn="l" pos="1371600"/>
                        <a:tab algn="l" pos="1828800"/>
                        <a:tab algn="l" pos="2286000"/>
                        <a:tab algn="l" pos="2743200"/>
                        <a:tab algn="l" pos="3200400"/>
                        <a:tab algn="l" pos="3657600"/>
                        <a:tab algn="l" pos="4114800"/>
                        <a:tab algn="l" pos="4572000"/>
                        <a:tab algn="l" pos="5029200"/>
                        <a:tab algn="l" pos="5486400"/>
                        <a:tab algn="l" pos="5943600"/>
                        <a:tab algn="l" pos="6400800"/>
                        <a:tab algn="l" pos="6858000"/>
                        <a:tab algn="l" pos="7315200"/>
                        <a:tab algn="l" pos="7772400"/>
                        <a:tab algn="l" pos="8229600"/>
                        <a:tab algn="l" pos="8686800"/>
                        <a:tab algn="l" pos="9144000"/>
                      </a:tabLst>
                    </a:pPr>
                    <a:r>
                      <a:rPr b="1" lang="en-US" sz="800" spc="-1" strike="noStrike">
                        <a:solidFill>
                          <a:srgbClr val="000000"/>
                        </a:solidFill>
                        <a:latin typeface="Arial"/>
                      </a:rPr>
                      <a:t>10</a:t>
                    </a:r>
                    <a:r>
                      <a:rPr b="1" lang="en-US" sz="800" spc="-1" strike="noStrike" baseline="30000">
                        <a:solidFill>
                          <a:srgbClr val="000000"/>
                        </a:solidFill>
                        <a:latin typeface="Arial"/>
                      </a:rPr>
                      <a:t>4</a:t>
                    </a:r>
                    <a:endParaRPr b="0" lang="en-US" sz="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74" name="Rectangle 26"/>
                  <p:cNvSpPr/>
                  <p:nvPr/>
                </p:nvSpPr>
                <p:spPr>
                  <a:xfrm>
                    <a:off x="1249200" y="1853280"/>
                    <a:ext cx="323640" cy="1526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457200"/>
                        <a:tab algn="l" pos="914400"/>
                        <a:tab algn="l" pos="1371600"/>
                        <a:tab algn="l" pos="1828800"/>
                        <a:tab algn="l" pos="2286000"/>
                        <a:tab algn="l" pos="2743200"/>
                        <a:tab algn="l" pos="3200400"/>
                        <a:tab algn="l" pos="3657600"/>
                        <a:tab algn="l" pos="4114800"/>
                        <a:tab algn="l" pos="4572000"/>
                        <a:tab algn="l" pos="5029200"/>
                        <a:tab algn="l" pos="5486400"/>
                        <a:tab algn="l" pos="5943600"/>
                        <a:tab algn="l" pos="6400800"/>
                        <a:tab algn="l" pos="6858000"/>
                        <a:tab algn="l" pos="7315200"/>
                        <a:tab algn="l" pos="7772400"/>
                        <a:tab algn="l" pos="8229600"/>
                        <a:tab algn="l" pos="8686800"/>
                        <a:tab algn="l" pos="9144000"/>
                      </a:tabLst>
                    </a:pPr>
                    <a:r>
                      <a:rPr b="1" lang="en-US" sz="1000" spc="-1" strike="noStrike">
                        <a:solidFill>
                          <a:srgbClr val="000000"/>
                        </a:solidFill>
                        <a:latin typeface="Arial"/>
                      </a:rPr>
                      <a:t>CD81</a:t>
                    </a:r>
                    <a:endParaRPr b="0" lang="en-US" sz="10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75" name="Line 51"/>
                  <p:cNvSpPr/>
                  <p:nvPr/>
                </p:nvSpPr>
                <p:spPr>
                  <a:xfrm flipV="1">
                    <a:off x="1326240" y="504360"/>
                    <a:ext cx="720" cy="1152360"/>
                  </a:xfrm>
                  <a:prstGeom prst="line">
                    <a:avLst/>
                  </a:prstGeom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76" name="Rectangle 28"/>
                  <p:cNvSpPr/>
                  <p:nvPr/>
                </p:nvSpPr>
                <p:spPr>
                  <a:xfrm>
                    <a:off x="1210680" y="1588320"/>
                    <a:ext cx="57240" cy="1220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 algn="r">
                      <a:tabLst>
                        <a:tab algn="l" pos="0"/>
                        <a:tab algn="l" pos="457200"/>
                        <a:tab algn="l" pos="914400"/>
                        <a:tab algn="l" pos="1371600"/>
                        <a:tab algn="l" pos="1828800"/>
                        <a:tab algn="l" pos="2286000"/>
                        <a:tab algn="l" pos="2743200"/>
                        <a:tab algn="l" pos="3200400"/>
                        <a:tab algn="l" pos="3657600"/>
                        <a:tab algn="l" pos="4114800"/>
                        <a:tab algn="l" pos="4572000"/>
                        <a:tab algn="l" pos="5029200"/>
                        <a:tab algn="l" pos="5486400"/>
                        <a:tab algn="l" pos="5943600"/>
                        <a:tab algn="l" pos="6400800"/>
                        <a:tab algn="l" pos="6858000"/>
                        <a:tab algn="l" pos="7315200"/>
                        <a:tab algn="l" pos="7772400"/>
                        <a:tab algn="l" pos="8229600"/>
                        <a:tab algn="l" pos="8686800"/>
                        <a:tab algn="l" pos="9144000"/>
                      </a:tabLst>
                    </a:pPr>
                    <a:r>
                      <a:rPr b="1" lang="en-US" sz="800" spc="-1" strike="noStrike">
                        <a:solidFill>
                          <a:srgbClr val="000000"/>
                        </a:solidFill>
                        <a:latin typeface="Arial"/>
                      </a:rPr>
                      <a:t>0</a:t>
                    </a:r>
                    <a:endParaRPr b="0" lang="en-US" sz="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77" name="Rectangle 29"/>
                  <p:cNvSpPr/>
                  <p:nvPr/>
                </p:nvSpPr>
                <p:spPr>
                  <a:xfrm>
                    <a:off x="1153800" y="1369440"/>
                    <a:ext cx="113400" cy="1220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 algn="r">
                      <a:tabLst>
                        <a:tab algn="l" pos="0"/>
                        <a:tab algn="l" pos="457200"/>
                        <a:tab algn="l" pos="914400"/>
                        <a:tab algn="l" pos="1371600"/>
                        <a:tab algn="l" pos="1828800"/>
                        <a:tab algn="l" pos="2286000"/>
                        <a:tab algn="l" pos="2743200"/>
                        <a:tab algn="l" pos="3200400"/>
                        <a:tab algn="l" pos="3657600"/>
                        <a:tab algn="l" pos="4114800"/>
                        <a:tab algn="l" pos="4572000"/>
                        <a:tab algn="l" pos="5029200"/>
                        <a:tab algn="l" pos="5486400"/>
                        <a:tab algn="l" pos="5943600"/>
                        <a:tab algn="l" pos="6400800"/>
                        <a:tab algn="l" pos="6858000"/>
                        <a:tab algn="l" pos="7315200"/>
                        <a:tab algn="l" pos="7772400"/>
                        <a:tab algn="l" pos="8229600"/>
                        <a:tab algn="l" pos="8686800"/>
                        <a:tab algn="l" pos="9144000"/>
                      </a:tabLst>
                    </a:pPr>
                    <a:r>
                      <a:rPr b="1" lang="en-US" sz="800" spc="-1" strike="noStrike">
                        <a:solidFill>
                          <a:srgbClr val="000000"/>
                        </a:solidFill>
                        <a:latin typeface="Arial"/>
                      </a:rPr>
                      <a:t>20</a:t>
                    </a:r>
                    <a:endParaRPr b="0" lang="en-US" sz="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78" name="Rectangle 30"/>
                  <p:cNvSpPr/>
                  <p:nvPr/>
                </p:nvSpPr>
                <p:spPr>
                  <a:xfrm>
                    <a:off x="1153800" y="1149840"/>
                    <a:ext cx="113400" cy="1220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 algn="r">
                      <a:tabLst>
                        <a:tab algn="l" pos="0"/>
                        <a:tab algn="l" pos="457200"/>
                        <a:tab algn="l" pos="914400"/>
                        <a:tab algn="l" pos="1371600"/>
                        <a:tab algn="l" pos="1828800"/>
                        <a:tab algn="l" pos="2286000"/>
                        <a:tab algn="l" pos="2743200"/>
                        <a:tab algn="l" pos="3200400"/>
                        <a:tab algn="l" pos="3657600"/>
                        <a:tab algn="l" pos="4114800"/>
                        <a:tab algn="l" pos="4572000"/>
                        <a:tab algn="l" pos="5029200"/>
                        <a:tab algn="l" pos="5486400"/>
                        <a:tab algn="l" pos="5943600"/>
                        <a:tab algn="l" pos="6400800"/>
                        <a:tab algn="l" pos="6858000"/>
                        <a:tab algn="l" pos="7315200"/>
                        <a:tab algn="l" pos="7772400"/>
                        <a:tab algn="l" pos="8229600"/>
                        <a:tab algn="l" pos="8686800"/>
                        <a:tab algn="l" pos="9144000"/>
                      </a:tabLst>
                    </a:pPr>
                    <a:r>
                      <a:rPr b="1" lang="en-US" sz="800" spc="-1" strike="noStrike">
                        <a:solidFill>
                          <a:srgbClr val="000000"/>
                        </a:solidFill>
                        <a:latin typeface="Arial"/>
                      </a:rPr>
                      <a:t>40</a:t>
                    </a:r>
                    <a:endParaRPr b="0" lang="en-US" sz="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79" name="Rectangle 305"/>
                  <p:cNvSpPr/>
                  <p:nvPr/>
                </p:nvSpPr>
                <p:spPr>
                  <a:xfrm>
                    <a:off x="1153800" y="927000"/>
                    <a:ext cx="113400" cy="1220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 algn="r">
                      <a:tabLst>
                        <a:tab algn="l" pos="0"/>
                        <a:tab algn="l" pos="457200"/>
                        <a:tab algn="l" pos="914400"/>
                        <a:tab algn="l" pos="1371600"/>
                        <a:tab algn="l" pos="1828800"/>
                        <a:tab algn="l" pos="2286000"/>
                        <a:tab algn="l" pos="2743200"/>
                        <a:tab algn="l" pos="3200400"/>
                        <a:tab algn="l" pos="3657600"/>
                        <a:tab algn="l" pos="4114800"/>
                        <a:tab algn="l" pos="4572000"/>
                        <a:tab algn="l" pos="5029200"/>
                        <a:tab algn="l" pos="5486400"/>
                        <a:tab algn="l" pos="5943600"/>
                        <a:tab algn="l" pos="6400800"/>
                        <a:tab algn="l" pos="6858000"/>
                        <a:tab algn="l" pos="7315200"/>
                        <a:tab algn="l" pos="7772400"/>
                        <a:tab algn="l" pos="8229600"/>
                        <a:tab algn="l" pos="8686800"/>
                        <a:tab algn="l" pos="9144000"/>
                      </a:tabLst>
                    </a:pPr>
                    <a:r>
                      <a:rPr b="1" lang="en-US" sz="800" spc="-1" strike="noStrike">
                        <a:solidFill>
                          <a:srgbClr val="000000"/>
                        </a:solidFill>
                        <a:latin typeface="Arial"/>
                      </a:rPr>
                      <a:t>60</a:t>
                    </a:r>
                    <a:endParaRPr b="0" lang="en-US" sz="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80" name="Rectangle 306"/>
                  <p:cNvSpPr/>
                  <p:nvPr/>
                </p:nvSpPr>
                <p:spPr>
                  <a:xfrm>
                    <a:off x="1153800" y="708120"/>
                    <a:ext cx="113400" cy="1220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 algn="r">
                      <a:tabLst>
                        <a:tab algn="l" pos="0"/>
                        <a:tab algn="l" pos="457200"/>
                        <a:tab algn="l" pos="914400"/>
                        <a:tab algn="l" pos="1371600"/>
                        <a:tab algn="l" pos="1828800"/>
                        <a:tab algn="l" pos="2286000"/>
                        <a:tab algn="l" pos="2743200"/>
                        <a:tab algn="l" pos="3200400"/>
                        <a:tab algn="l" pos="3657600"/>
                        <a:tab algn="l" pos="4114800"/>
                        <a:tab algn="l" pos="4572000"/>
                        <a:tab algn="l" pos="5029200"/>
                        <a:tab algn="l" pos="5486400"/>
                        <a:tab algn="l" pos="5943600"/>
                        <a:tab algn="l" pos="6400800"/>
                        <a:tab algn="l" pos="6858000"/>
                        <a:tab algn="l" pos="7315200"/>
                        <a:tab algn="l" pos="7772400"/>
                        <a:tab algn="l" pos="8229600"/>
                        <a:tab algn="l" pos="8686800"/>
                        <a:tab algn="l" pos="9144000"/>
                      </a:tabLst>
                    </a:pPr>
                    <a:r>
                      <a:rPr b="1" lang="en-US" sz="800" spc="-1" strike="noStrike">
                        <a:solidFill>
                          <a:srgbClr val="000000"/>
                        </a:solidFill>
                        <a:latin typeface="Arial"/>
                      </a:rPr>
                      <a:t>80</a:t>
                    </a:r>
                    <a:endParaRPr b="0" lang="en-US" sz="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81" name="Rectangle 307"/>
                  <p:cNvSpPr/>
                  <p:nvPr/>
                </p:nvSpPr>
                <p:spPr>
                  <a:xfrm>
                    <a:off x="1097280" y="488520"/>
                    <a:ext cx="169920" cy="1220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 algn="r">
                      <a:tabLst>
                        <a:tab algn="l" pos="0"/>
                        <a:tab algn="l" pos="457200"/>
                        <a:tab algn="l" pos="914400"/>
                        <a:tab algn="l" pos="1371600"/>
                        <a:tab algn="l" pos="1828800"/>
                        <a:tab algn="l" pos="2286000"/>
                        <a:tab algn="l" pos="2743200"/>
                        <a:tab algn="l" pos="3200400"/>
                        <a:tab algn="l" pos="3657600"/>
                        <a:tab algn="l" pos="4114800"/>
                        <a:tab algn="l" pos="4572000"/>
                        <a:tab algn="l" pos="5029200"/>
                        <a:tab algn="l" pos="5486400"/>
                        <a:tab algn="l" pos="5943600"/>
                        <a:tab algn="l" pos="6400800"/>
                        <a:tab algn="l" pos="6858000"/>
                        <a:tab algn="l" pos="7315200"/>
                        <a:tab algn="l" pos="7772400"/>
                        <a:tab algn="l" pos="8229600"/>
                        <a:tab algn="l" pos="8686800"/>
                        <a:tab algn="l" pos="9144000"/>
                      </a:tabLst>
                    </a:pPr>
                    <a:r>
                      <a:rPr b="1" lang="en-US" sz="800" spc="-1" strike="noStrike">
                        <a:solidFill>
                          <a:srgbClr val="000000"/>
                        </a:solidFill>
                        <a:latin typeface="Arial"/>
                      </a:rPr>
                      <a:t>100</a:t>
                    </a:r>
                    <a:endParaRPr b="0" lang="en-US" sz="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grpSp>
                <p:nvGrpSpPr>
                  <p:cNvPr id="382" name="Group 34"/>
                  <p:cNvGrpSpPr/>
                  <p:nvPr/>
                </p:nvGrpSpPr>
                <p:grpSpPr>
                  <a:xfrm>
                    <a:off x="1294200" y="558360"/>
                    <a:ext cx="31680" cy="1099800"/>
                    <a:chOff x="1294200" y="558360"/>
                    <a:chExt cx="31680" cy="1099800"/>
                  </a:xfrm>
                </p:grpSpPr>
                <p:sp>
                  <p:nvSpPr>
                    <p:cNvPr id="383" name="Line 60"/>
                    <p:cNvSpPr/>
                    <p:nvPr/>
                  </p:nvSpPr>
                  <p:spPr>
                    <a:xfrm flipH="1">
                      <a:off x="1294200" y="1657440"/>
                      <a:ext cx="31680" cy="720"/>
                    </a:xfrm>
                    <a:prstGeom prst="line">
                      <a:avLst/>
                    </a:prstGeom>
                    <a:ln w="1260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080" bIns="-4608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384" name="Line 61"/>
                    <p:cNvSpPr/>
                    <p:nvPr/>
                  </p:nvSpPr>
                  <p:spPr>
                    <a:xfrm flipH="1">
                      <a:off x="1315800" y="1604160"/>
                      <a:ext cx="10080" cy="720"/>
                    </a:xfrm>
                    <a:prstGeom prst="line">
                      <a:avLst/>
                    </a:prstGeom>
                    <a:ln w="1260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080" bIns="-4608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385" name="Line 62"/>
                    <p:cNvSpPr/>
                    <p:nvPr/>
                  </p:nvSpPr>
                  <p:spPr>
                    <a:xfrm flipH="1">
                      <a:off x="1315800" y="1550520"/>
                      <a:ext cx="10080" cy="720"/>
                    </a:xfrm>
                    <a:prstGeom prst="line">
                      <a:avLst/>
                    </a:prstGeom>
                    <a:ln w="1260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080" bIns="-4608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386" name="Line 63"/>
                    <p:cNvSpPr/>
                    <p:nvPr/>
                  </p:nvSpPr>
                  <p:spPr>
                    <a:xfrm flipH="1">
                      <a:off x="1315800" y="1492200"/>
                      <a:ext cx="10080" cy="720"/>
                    </a:xfrm>
                    <a:prstGeom prst="line">
                      <a:avLst/>
                    </a:prstGeom>
                    <a:ln w="1260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080" bIns="-4608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387" name="Line 64"/>
                    <p:cNvSpPr/>
                    <p:nvPr/>
                  </p:nvSpPr>
                  <p:spPr>
                    <a:xfrm flipH="1">
                      <a:off x="1294200" y="1438920"/>
                      <a:ext cx="31680" cy="720"/>
                    </a:xfrm>
                    <a:prstGeom prst="line">
                      <a:avLst/>
                    </a:prstGeom>
                    <a:ln w="1260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080" bIns="-4608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388" name="Line 65"/>
                    <p:cNvSpPr/>
                    <p:nvPr/>
                  </p:nvSpPr>
                  <p:spPr>
                    <a:xfrm flipH="1">
                      <a:off x="1315800" y="1385280"/>
                      <a:ext cx="10080" cy="720"/>
                    </a:xfrm>
                    <a:prstGeom prst="line">
                      <a:avLst/>
                    </a:prstGeom>
                    <a:ln w="1260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080" bIns="-4608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389" name="Line 66"/>
                    <p:cNvSpPr/>
                    <p:nvPr/>
                  </p:nvSpPr>
                  <p:spPr>
                    <a:xfrm flipH="1">
                      <a:off x="1315800" y="1326960"/>
                      <a:ext cx="10080" cy="720"/>
                    </a:xfrm>
                    <a:prstGeom prst="line">
                      <a:avLst/>
                    </a:prstGeom>
                    <a:ln w="1260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080" bIns="-4608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390" name="Line 67"/>
                    <p:cNvSpPr/>
                    <p:nvPr/>
                  </p:nvSpPr>
                  <p:spPr>
                    <a:xfrm flipH="1">
                      <a:off x="1315800" y="1273320"/>
                      <a:ext cx="10080" cy="720"/>
                    </a:xfrm>
                    <a:prstGeom prst="line">
                      <a:avLst/>
                    </a:prstGeom>
                    <a:ln w="1260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080" bIns="-4608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391" name="Line 68"/>
                    <p:cNvSpPr/>
                    <p:nvPr/>
                  </p:nvSpPr>
                  <p:spPr>
                    <a:xfrm flipH="1">
                      <a:off x="1294200" y="1220040"/>
                      <a:ext cx="31680" cy="720"/>
                    </a:xfrm>
                    <a:prstGeom prst="line">
                      <a:avLst/>
                    </a:prstGeom>
                    <a:ln w="1260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080" bIns="-4608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392" name="Line 69"/>
                    <p:cNvSpPr/>
                    <p:nvPr/>
                  </p:nvSpPr>
                  <p:spPr>
                    <a:xfrm flipH="1">
                      <a:off x="1315800" y="1161360"/>
                      <a:ext cx="10080" cy="720"/>
                    </a:xfrm>
                    <a:prstGeom prst="line">
                      <a:avLst/>
                    </a:prstGeom>
                    <a:ln w="1260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080" bIns="-4608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393" name="Line 70"/>
                    <p:cNvSpPr/>
                    <p:nvPr/>
                  </p:nvSpPr>
                  <p:spPr>
                    <a:xfrm flipH="1">
                      <a:off x="1315800" y="1107720"/>
                      <a:ext cx="10080" cy="720"/>
                    </a:xfrm>
                    <a:prstGeom prst="line">
                      <a:avLst/>
                    </a:prstGeom>
                    <a:ln w="1260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080" bIns="-4608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394" name="Line 71"/>
                    <p:cNvSpPr/>
                    <p:nvPr/>
                  </p:nvSpPr>
                  <p:spPr>
                    <a:xfrm flipH="1">
                      <a:off x="1315800" y="1054440"/>
                      <a:ext cx="10080" cy="720"/>
                    </a:xfrm>
                    <a:prstGeom prst="line">
                      <a:avLst/>
                    </a:prstGeom>
                    <a:ln w="1260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080" bIns="-4608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395" name="Line 72"/>
                    <p:cNvSpPr/>
                    <p:nvPr/>
                  </p:nvSpPr>
                  <p:spPr>
                    <a:xfrm flipH="1">
                      <a:off x="1294200" y="996120"/>
                      <a:ext cx="31680" cy="720"/>
                    </a:xfrm>
                    <a:prstGeom prst="line">
                      <a:avLst/>
                    </a:prstGeom>
                    <a:ln w="1260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080" bIns="-4608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396" name="Line 73"/>
                    <p:cNvSpPr/>
                    <p:nvPr/>
                  </p:nvSpPr>
                  <p:spPr>
                    <a:xfrm flipH="1">
                      <a:off x="1315800" y="942480"/>
                      <a:ext cx="10080" cy="720"/>
                    </a:xfrm>
                    <a:prstGeom prst="line">
                      <a:avLst/>
                    </a:prstGeom>
                    <a:ln w="1260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080" bIns="-4608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397" name="Line 74"/>
                    <p:cNvSpPr/>
                    <p:nvPr/>
                  </p:nvSpPr>
                  <p:spPr>
                    <a:xfrm flipH="1">
                      <a:off x="1315800" y="889200"/>
                      <a:ext cx="10080" cy="720"/>
                    </a:xfrm>
                    <a:prstGeom prst="line">
                      <a:avLst/>
                    </a:prstGeom>
                    <a:ln w="1260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080" bIns="-4608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398" name="Line 75"/>
                    <p:cNvSpPr/>
                    <p:nvPr/>
                  </p:nvSpPr>
                  <p:spPr>
                    <a:xfrm flipH="1">
                      <a:off x="1315800" y="830520"/>
                      <a:ext cx="10080" cy="720"/>
                    </a:xfrm>
                    <a:prstGeom prst="line">
                      <a:avLst/>
                    </a:prstGeom>
                    <a:ln w="1260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080" bIns="-4608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399" name="Line 76"/>
                    <p:cNvSpPr/>
                    <p:nvPr/>
                  </p:nvSpPr>
                  <p:spPr>
                    <a:xfrm flipH="1">
                      <a:off x="1294200" y="777240"/>
                      <a:ext cx="31680" cy="720"/>
                    </a:xfrm>
                    <a:prstGeom prst="line">
                      <a:avLst/>
                    </a:prstGeom>
                    <a:ln w="1260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080" bIns="-4608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400" name="Line 77"/>
                    <p:cNvSpPr/>
                    <p:nvPr/>
                  </p:nvSpPr>
                  <p:spPr>
                    <a:xfrm flipH="1">
                      <a:off x="1315800" y="723600"/>
                      <a:ext cx="10080" cy="720"/>
                    </a:xfrm>
                    <a:prstGeom prst="line">
                      <a:avLst/>
                    </a:prstGeom>
                    <a:ln w="1260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080" bIns="-4608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401" name="Line 78"/>
                    <p:cNvSpPr/>
                    <p:nvPr/>
                  </p:nvSpPr>
                  <p:spPr>
                    <a:xfrm flipH="1">
                      <a:off x="1315800" y="665280"/>
                      <a:ext cx="10080" cy="720"/>
                    </a:xfrm>
                    <a:prstGeom prst="line">
                      <a:avLst/>
                    </a:prstGeom>
                    <a:ln w="1260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080" bIns="-4608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402" name="Line 79"/>
                    <p:cNvSpPr/>
                    <p:nvPr/>
                  </p:nvSpPr>
                  <p:spPr>
                    <a:xfrm flipH="1">
                      <a:off x="1315800" y="611640"/>
                      <a:ext cx="10080" cy="720"/>
                    </a:xfrm>
                    <a:prstGeom prst="line">
                      <a:avLst/>
                    </a:prstGeom>
                    <a:ln w="1260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080" bIns="-4608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403" name="Line 80"/>
                    <p:cNvSpPr/>
                    <p:nvPr/>
                  </p:nvSpPr>
                  <p:spPr>
                    <a:xfrm flipH="1">
                      <a:off x="1294200" y="558360"/>
                      <a:ext cx="31680" cy="720"/>
                    </a:xfrm>
                    <a:prstGeom prst="line">
                      <a:avLst/>
                    </a:prstGeom>
                    <a:ln w="1260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080" bIns="-4608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</p:grpSp>
              <p:sp>
                <p:nvSpPr>
                  <p:cNvPr id="404" name="Freeform 309"/>
                  <p:cNvSpPr/>
                  <p:nvPr/>
                </p:nvSpPr>
                <p:spPr>
                  <a:xfrm>
                    <a:off x="1344240" y="513360"/>
                    <a:ext cx="1338480" cy="1139760"/>
                  </a:xfrm>
                  <a:prstGeom prst="pie">
                    <a:avLst/>
                  </a:prstGeom>
                  <a:solidFill>
                    <a:srgbClr val="000000"/>
                  </a:solidFill>
                  <a:ln w="9360">
                    <a:solidFill>
                      <a:srgbClr val="7f7f7f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457200"/>
                        <a:tab algn="l" pos="914400"/>
                        <a:tab algn="l" pos="1371600"/>
                        <a:tab algn="l" pos="1828800"/>
                        <a:tab algn="l" pos="2286000"/>
                        <a:tab algn="l" pos="2743200"/>
                        <a:tab algn="l" pos="3200400"/>
                        <a:tab algn="l" pos="3657600"/>
                        <a:tab algn="l" pos="4114800"/>
                        <a:tab algn="l" pos="4572000"/>
                        <a:tab algn="l" pos="5029200"/>
                        <a:tab algn="l" pos="5486400"/>
                        <a:tab algn="l" pos="5943600"/>
                        <a:tab algn="l" pos="6400800"/>
                        <a:tab algn="l" pos="6858000"/>
                        <a:tab algn="l" pos="7315200"/>
                        <a:tab algn="l" pos="7772400"/>
                        <a:tab algn="l" pos="8229600"/>
                        <a:tab algn="l" pos="8686800"/>
                        <a:tab algn="l" pos="9144000"/>
                      </a:tabLst>
                    </a:pPr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grpSp>
                <p:nvGrpSpPr>
                  <p:cNvPr id="405" name="Group 36"/>
                  <p:cNvGrpSpPr/>
                  <p:nvPr/>
                </p:nvGrpSpPr>
                <p:grpSpPr>
                  <a:xfrm>
                    <a:off x="1335600" y="515160"/>
                    <a:ext cx="1343160" cy="1139760"/>
                    <a:chOff x="1335600" y="515160"/>
                    <a:chExt cx="1343160" cy="1139760"/>
                  </a:xfrm>
                </p:grpSpPr>
                <p:sp>
                  <p:nvSpPr>
                    <p:cNvPr id="406" name="Freeform 313"/>
                    <p:cNvSpPr/>
                    <p:nvPr/>
                  </p:nvSpPr>
                  <p:spPr>
                    <a:xfrm>
                      <a:off x="1335600" y="515160"/>
                      <a:ext cx="1343160" cy="1139760"/>
                    </a:xfrm>
                    <a:prstGeom prst="pie">
                      <a:avLst/>
                    </a:prstGeom>
                    <a:solidFill>
                      <a:srgbClr val="ffffff">
                        <a:alpha val="67000"/>
                      </a:srgbClr>
                    </a:solidFill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407" name="Freeform 40"/>
                    <p:cNvSpPr/>
                    <p:nvPr/>
                  </p:nvSpPr>
                  <p:spPr>
                    <a:xfrm>
                      <a:off x="1335600" y="515160"/>
                      <a:ext cx="1338480" cy="1139760"/>
                    </a:xfrm>
                    <a:prstGeom prst="pie">
                      <a:avLst/>
                    </a:prstGeom>
                    <a:noFill/>
                    <a:ln w="9360">
                      <a:solidFill>
                        <a:srgbClr val="333333"/>
                      </a:solidFill>
                      <a:round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</p:grpSp>
              <p:sp>
                <p:nvSpPr>
                  <p:cNvPr id="408" name="Freeform 311"/>
                  <p:cNvSpPr/>
                  <p:nvPr/>
                </p:nvSpPr>
                <p:spPr>
                  <a:xfrm>
                    <a:off x="1336680" y="571680"/>
                    <a:ext cx="1338480" cy="1081440"/>
                  </a:xfrm>
                  <a:prstGeom prst="pie">
                    <a:avLst/>
                  </a:prstGeom>
                  <a:noFill/>
                  <a:ln w="936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457200"/>
                        <a:tab algn="l" pos="914400"/>
                        <a:tab algn="l" pos="1371600"/>
                        <a:tab algn="l" pos="1828800"/>
                        <a:tab algn="l" pos="2286000"/>
                        <a:tab algn="l" pos="2743200"/>
                        <a:tab algn="l" pos="3200400"/>
                        <a:tab algn="l" pos="3657600"/>
                        <a:tab algn="l" pos="4114800"/>
                        <a:tab algn="l" pos="4572000"/>
                        <a:tab algn="l" pos="5029200"/>
                        <a:tab algn="l" pos="5486400"/>
                        <a:tab algn="l" pos="5943600"/>
                        <a:tab algn="l" pos="6400800"/>
                        <a:tab algn="l" pos="6858000"/>
                        <a:tab algn="l" pos="7315200"/>
                        <a:tab algn="l" pos="7772400"/>
                        <a:tab algn="l" pos="8229600"/>
                        <a:tab algn="l" pos="8686800"/>
                        <a:tab algn="l" pos="9144000"/>
                      </a:tabLst>
                    </a:pPr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09" name="Line 86"/>
                  <p:cNvSpPr/>
                  <p:nvPr/>
                </p:nvSpPr>
                <p:spPr>
                  <a:xfrm>
                    <a:off x="1680120" y="1930320"/>
                    <a:ext cx="908280" cy="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  <a:tailEnd len="med" type="triangle" w="med"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ctr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sp>
              <p:nvSpPr>
                <p:cNvPr id="410" name="TextBox 483"/>
                <p:cNvSpPr/>
                <p:nvPr/>
              </p:nvSpPr>
              <p:spPr>
                <a:xfrm>
                  <a:off x="343080" y="2053800"/>
                  <a:ext cx="444240" cy="3988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1" lang="en-US" sz="2000" spc="-1" strike="noStrike">
                      <a:solidFill>
                        <a:srgbClr val="000000"/>
                      </a:solidFill>
                      <a:latin typeface="Arial"/>
                    </a:rPr>
                    <a:t>B</a:t>
                  </a:r>
                  <a:endParaRPr b="0" lang="en-US" sz="2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11" name="Rectangle 297"/>
                <p:cNvSpPr/>
                <p:nvPr/>
              </p:nvSpPr>
              <p:spPr>
                <a:xfrm rot="16200000">
                  <a:off x="681840" y="999000"/>
                  <a:ext cx="610200" cy="1677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1" lang="en-US" sz="1100" spc="-1" strike="noStrike">
                      <a:solidFill>
                        <a:srgbClr val="000000"/>
                      </a:solidFill>
                      <a:latin typeface="Arial"/>
                    </a:rPr>
                    <a:t>% of Max</a:t>
                  </a:r>
                  <a:endParaRPr b="0" lang="en-US" sz="11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</p:grp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2" name="Rectangle 107"/>
          <p:cNvSpPr/>
          <p:nvPr/>
        </p:nvSpPr>
        <p:spPr>
          <a:xfrm>
            <a:off x="6180120" y="5727600"/>
            <a:ext cx="136440" cy="559080"/>
          </a:xfrm>
          <a:prstGeom prst="rect">
            <a:avLst/>
          </a:prstGeom>
          <a:solidFill>
            <a:srgbClr val="ffffff"/>
          </a:solidFill>
          <a:ln w="9360">
            <a:solidFill>
              <a:srgbClr val="fffff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13" name=""/>
          <p:cNvGrpSpPr/>
          <p:nvPr/>
        </p:nvGrpSpPr>
        <p:grpSpPr>
          <a:xfrm>
            <a:off x="415800" y="244440"/>
            <a:ext cx="8312400" cy="6463440"/>
            <a:chOff x="415800" y="244440"/>
            <a:chExt cx="8312400" cy="6463440"/>
          </a:xfrm>
        </p:grpSpPr>
        <p:sp>
          <p:nvSpPr>
            <p:cNvPr id="414" name="TextBox 1"/>
            <p:cNvSpPr/>
            <p:nvPr/>
          </p:nvSpPr>
          <p:spPr>
            <a:xfrm>
              <a:off x="415800" y="4971240"/>
              <a:ext cx="8312400" cy="1736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spAutoFit/>
            </a:bodyPr>
            <a:p>
              <a:pPr algn="just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Figure S5. (D) Inhibition of HCVrp infectivity by anti-CD81 and -SR-BI antibodies. </a:t>
              </a: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Huh-7.5 cells were pre-incubated with a mixture of anti-CD81 and anti-SR-BI antibodies (or IgG control) for 1 hr at 37</a:t>
              </a: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°</a:t>
              </a: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C, then incubated with aliquots of sucrose fractions.</a:t>
              </a: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 (E) Inhibition of HCVrp infectivity by anti-HCV E2 HVR-1 antibodies. </a:t>
              </a: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HCVrp were pre-incubated with anti-HVR-1 </a:t>
              </a: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(solid bar) or control (open bar) </a:t>
              </a: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polyclonal antibodies for 1 hr prior to addition onto Huh-7.5 cells; control values were subtracted and error bars represent SD HCVrp + SD control. </a:t>
              </a: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(F)</a:t>
              </a: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 </a:t>
              </a: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Effect of NS2 on HCVrp infectivity. </a:t>
              </a: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HCVrp produced with (filled symbols; </a:t>
              </a: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left) or without (open symbols; right</a:t>
              </a: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) NS2 in BHK-WNV cells was fractionated on a 20-60% sucrose gradient, then aliquots of each fraction were incubated with Huh-7.5 cells (in triplicate) for 1 hr. In </a:t>
              </a: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D-F</a:t>
              </a: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, after virus removal, cells were transfected with the reporter system plasmids and FFL activities were measured 24 hr later.</a:t>
              </a: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 </a:t>
              </a: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The errors bars represent SD of triplicate values. 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415" name="Group 56"/>
            <p:cNvGrpSpPr/>
            <p:nvPr/>
          </p:nvGrpSpPr>
          <p:grpSpPr>
            <a:xfrm>
              <a:off x="446040" y="244440"/>
              <a:ext cx="8251920" cy="4726080"/>
              <a:chOff x="446040" y="244440"/>
              <a:chExt cx="8251920" cy="4726080"/>
            </a:xfrm>
          </p:grpSpPr>
          <p:grpSp>
            <p:nvGrpSpPr>
              <p:cNvPr id="416" name="Group 4"/>
              <p:cNvGrpSpPr/>
              <p:nvPr/>
            </p:nvGrpSpPr>
            <p:grpSpPr>
              <a:xfrm>
                <a:off x="964440" y="244440"/>
                <a:ext cx="3270240" cy="2423520"/>
                <a:chOff x="964440" y="244440"/>
                <a:chExt cx="3270240" cy="2423520"/>
              </a:xfrm>
            </p:grpSpPr>
            <p:pic>
              <p:nvPicPr>
                <p:cNvPr id="417" name="Chart 5" descr=""/>
                <p:cNvPicPr/>
                <p:nvPr/>
              </p:nvPicPr>
              <p:blipFill>
                <a:blip r:embed="rId1"/>
                <a:stretch/>
              </p:blipFill>
              <p:spPr>
                <a:xfrm>
                  <a:off x="964440" y="244440"/>
                  <a:ext cx="3270240" cy="2423520"/>
                </a:xfrm>
                <a:prstGeom prst="rect">
                  <a:avLst/>
                </a:prstGeom>
                <a:ln w="0">
                  <a:noFill/>
                </a:ln>
              </p:spPr>
            </p:pic>
            <p:sp>
              <p:nvSpPr>
                <p:cNvPr id="418" name="Text Box 118"/>
                <p:cNvSpPr/>
                <p:nvPr/>
              </p:nvSpPr>
              <p:spPr>
                <a:xfrm rot="16200000">
                  <a:off x="221400" y="1188720"/>
                  <a:ext cx="1840320" cy="2462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1" lang="en-US" sz="1000" spc="-1" strike="noStrike">
                      <a:solidFill>
                        <a:srgbClr val="000000"/>
                      </a:solidFill>
                      <a:latin typeface="Arial"/>
                    </a:rPr>
                    <a:t>Firefly luciferase (RLU/well)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419" name="TextBox 20"/>
              <p:cNvSpPr/>
              <p:nvPr/>
            </p:nvSpPr>
            <p:spPr>
              <a:xfrm>
                <a:off x="446040" y="244440"/>
                <a:ext cx="39996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1800" spc="-1" strike="noStrike">
                    <a:solidFill>
                      <a:srgbClr val="000000"/>
                    </a:solidFill>
                    <a:latin typeface="Arial"/>
                  </a:rPr>
                  <a:t>D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20" name="TextBox 223"/>
              <p:cNvSpPr/>
              <p:nvPr/>
            </p:nvSpPr>
            <p:spPr>
              <a:xfrm>
                <a:off x="4687200" y="244440"/>
                <a:ext cx="39996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1800" spc="-1" strike="noStrike">
                    <a:solidFill>
                      <a:srgbClr val="000000"/>
                    </a:solidFill>
                    <a:latin typeface="Arial"/>
                  </a:rPr>
                  <a:t>E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21" name="TextBox 20"/>
              <p:cNvSpPr/>
              <p:nvPr/>
            </p:nvSpPr>
            <p:spPr>
              <a:xfrm>
                <a:off x="446040" y="2620080"/>
                <a:ext cx="35532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1800" spc="-1" strike="noStrike">
                    <a:solidFill>
                      <a:srgbClr val="000000"/>
                    </a:solidFill>
                    <a:latin typeface="Arial"/>
                  </a:rPr>
                  <a:t>F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422" name="Group 11"/>
              <p:cNvGrpSpPr/>
              <p:nvPr/>
            </p:nvGrpSpPr>
            <p:grpSpPr>
              <a:xfrm>
                <a:off x="5193360" y="2620080"/>
                <a:ext cx="3504600" cy="2350440"/>
                <a:chOff x="5193360" y="2620080"/>
                <a:chExt cx="3504600" cy="2350440"/>
              </a:xfrm>
            </p:grpSpPr>
            <p:pic>
              <p:nvPicPr>
                <p:cNvPr id="423" name="Object 6" descr=""/>
                <p:cNvPicPr/>
                <p:nvPr/>
              </p:nvPicPr>
              <p:blipFill>
                <a:blip r:embed="rId2"/>
                <a:stretch/>
              </p:blipFill>
              <p:spPr>
                <a:xfrm>
                  <a:off x="5193360" y="2794680"/>
                  <a:ext cx="3504600" cy="2175840"/>
                </a:xfrm>
                <a:prstGeom prst="rect">
                  <a:avLst/>
                </a:prstGeom>
                <a:ln w="0">
                  <a:noFill/>
                </a:ln>
              </p:spPr>
            </p:pic>
            <p:sp>
              <p:nvSpPr>
                <p:cNvPr id="424" name="Straight Connector 33"/>
                <p:cNvSpPr/>
                <p:nvPr/>
              </p:nvSpPr>
              <p:spPr>
                <a:xfrm flipV="1">
                  <a:off x="8540640" y="4312080"/>
                  <a:ext cx="1080" cy="355680"/>
                </a:xfrm>
                <a:prstGeom prst="line">
                  <a:avLst/>
                </a:prstGeom>
                <a:ln w="19080">
                  <a:solidFill>
                    <a:srgbClr val="000000"/>
                  </a:solidFill>
                  <a:prstDash val="dash"/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grpSp>
              <p:nvGrpSpPr>
                <p:cNvPr id="425" name="Group 128"/>
                <p:cNvGrpSpPr/>
                <p:nvPr/>
              </p:nvGrpSpPr>
              <p:grpSpPr>
                <a:xfrm>
                  <a:off x="5269320" y="2620080"/>
                  <a:ext cx="77400" cy="308520"/>
                  <a:chOff x="5269320" y="2620080"/>
                  <a:chExt cx="77400" cy="308520"/>
                </a:xfrm>
              </p:grpSpPr>
              <p:sp>
                <p:nvSpPr>
                  <p:cNvPr id="426" name="Straight Connector 37"/>
                  <p:cNvSpPr/>
                  <p:nvPr/>
                </p:nvSpPr>
                <p:spPr>
                  <a:xfrm flipH="1">
                    <a:off x="5307120" y="2620080"/>
                    <a:ext cx="1080" cy="308520"/>
                  </a:xfrm>
                  <a:prstGeom prst="line">
                    <a:avLst/>
                  </a:prstGeom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27" name="Oval 36"/>
                  <p:cNvSpPr/>
                  <p:nvPr/>
                </p:nvSpPr>
                <p:spPr>
                  <a:xfrm>
                    <a:off x="5269320" y="2736720"/>
                    <a:ext cx="77400" cy="81000"/>
                  </a:xfrm>
                  <a:prstGeom prst="ellipse">
                    <a:avLst/>
                  </a:prstGeom>
                  <a:solidFill>
                    <a:srgbClr val="ffffff"/>
                  </a:solidFill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10440" bIns="10440" anchor="ctr">
                    <a:no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457200"/>
                        <a:tab algn="l" pos="914400"/>
                        <a:tab algn="l" pos="1371600"/>
                        <a:tab algn="l" pos="1828800"/>
                        <a:tab algn="l" pos="2286000"/>
                        <a:tab algn="l" pos="2743200"/>
                        <a:tab algn="l" pos="3200400"/>
                        <a:tab algn="l" pos="3657600"/>
                        <a:tab algn="l" pos="4114800"/>
                        <a:tab algn="l" pos="4572000"/>
                        <a:tab algn="l" pos="5029200"/>
                        <a:tab algn="l" pos="5486400"/>
                        <a:tab algn="l" pos="5943600"/>
                        <a:tab algn="l" pos="6400800"/>
                        <a:tab algn="l" pos="6858000"/>
                        <a:tab algn="l" pos="7315200"/>
                        <a:tab algn="l" pos="7772400"/>
                        <a:tab algn="l" pos="8229600"/>
                        <a:tab algn="l" pos="8686800"/>
                        <a:tab algn="l" pos="9144000"/>
                      </a:tabLst>
                    </a:pPr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</p:grpSp>
          <p:grpSp>
            <p:nvGrpSpPr>
              <p:cNvPr id="428" name="Group 17"/>
              <p:cNvGrpSpPr/>
              <p:nvPr/>
            </p:nvGrpSpPr>
            <p:grpSpPr>
              <a:xfrm>
                <a:off x="1015560" y="2620080"/>
                <a:ext cx="3476880" cy="2328840"/>
                <a:chOff x="1015560" y="2620080"/>
                <a:chExt cx="3476880" cy="2328840"/>
              </a:xfrm>
            </p:grpSpPr>
            <p:pic>
              <p:nvPicPr>
                <p:cNvPr id="429" name="Object 3" descr=""/>
                <p:cNvPicPr/>
                <p:nvPr/>
              </p:nvPicPr>
              <p:blipFill>
                <a:blip r:embed="rId3"/>
                <a:stretch/>
              </p:blipFill>
              <p:spPr>
                <a:xfrm>
                  <a:off x="1302120" y="2818440"/>
                  <a:ext cx="3014640" cy="2130480"/>
                </a:xfrm>
                <a:prstGeom prst="rect">
                  <a:avLst/>
                </a:prstGeom>
                <a:ln w="0">
                  <a:noFill/>
                </a:ln>
              </p:spPr>
            </p:pic>
            <p:sp>
              <p:nvSpPr>
                <p:cNvPr id="430" name="Straight Connector 33"/>
                <p:cNvSpPr/>
                <p:nvPr/>
              </p:nvSpPr>
              <p:spPr>
                <a:xfrm flipV="1">
                  <a:off x="4394880" y="4275720"/>
                  <a:ext cx="1080" cy="355680"/>
                </a:xfrm>
                <a:prstGeom prst="line">
                  <a:avLst/>
                </a:prstGeom>
                <a:ln w="19080">
                  <a:solidFill>
                    <a:srgbClr val="000000"/>
                  </a:solidFill>
                  <a:prstDash val="dash"/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grpSp>
              <p:nvGrpSpPr>
                <p:cNvPr id="431" name="Group 40"/>
                <p:cNvGrpSpPr/>
                <p:nvPr/>
              </p:nvGrpSpPr>
              <p:grpSpPr>
                <a:xfrm>
                  <a:off x="1119240" y="2620080"/>
                  <a:ext cx="69120" cy="308160"/>
                  <a:chOff x="1119240" y="2620080"/>
                  <a:chExt cx="69120" cy="308160"/>
                </a:xfrm>
              </p:grpSpPr>
              <p:sp>
                <p:nvSpPr>
                  <p:cNvPr id="432" name="Straight Connector 37"/>
                  <p:cNvSpPr/>
                  <p:nvPr/>
                </p:nvSpPr>
                <p:spPr>
                  <a:xfrm flipH="1">
                    <a:off x="1153800" y="2620080"/>
                    <a:ext cx="1080" cy="308160"/>
                  </a:xfrm>
                  <a:prstGeom prst="line">
                    <a:avLst/>
                  </a:prstGeom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33" name="Oval 36"/>
                  <p:cNvSpPr/>
                  <p:nvPr/>
                </p:nvSpPr>
                <p:spPr>
                  <a:xfrm>
                    <a:off x="1119240" y="2734560"/>
                    <a:ext cx="69120" cy="72360"/>
                  </a:xfrm>
                  <a:prstGeom prst="ellipse">
                    <a:avLst/>
                  </a:prstGeom>
                  <a:solidFill>
                    <a:srgbClr val="000000"/>
                  </a:solidFill>
                  <a:ln w="1260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" bIns="4680" anchor="ctr">
                    <a:no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457200"/>
                        <a:tab algn="l" pos="914400"/>
                        <a:tab algn="l" pos="1371600"/>
                        <a:tab algn="l" pos="1828800"/>
                        <a:tab algn="l" pos="2286000"/>
                        <a:tab algn="l" pos="2743200"/>
                        <a:tab algn="l" pos="3200400"/>
                        <a:tab algn="l" pos="3657600"/>
                        <a:tab algn="l" pos="4114800"/>
                        <a:tab algn="l" pos="4572000"/>
                        <a:tab algn="l" pos="5029200"/>
                        <a:tab algn="l" pos="5486400"/>
                        <a:tab algn="l" pos="5943600"/>
                        <a:tab algn="l" pos="6400800"/>
                        <a:tab algn="l" pos="6858000"/>
                        <a:tab algn="l" pos="7315200"/>
                        <a:tab algn="l" pos="7772400"/>
                        <a:tab algn="l" pos="8229600"/>
                        <a:tab algn="l" pos="8686800"/>
                        <a:tab algn="l" pos="9144000"/>
                      </a:tabLst>
                    </a:pPr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sp>
              <p:nvSpPr>
                <p:cNvPr id="434" name="Text Box 14"/>
                <p:cNvSpPr/>
                <p:nvPr/>
              </p:nvSpPr>
              <p:spPr>
                <a:xfrm rot="16200000">
                  <a:off x="338040" y="3569760"/>
                  <a:ext cx="1600920" cy="2462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1" lang="en-US" sz="1000" spc="-1" strike="noStrike">
                      <a:solidFill>
                        <a:srgbClr val="000000"/>
                      </a:solidFill>
                      <a:latin typeface="Arial"/>
                    </a:rPr>
                    <a:t>Firefly luciferase  (RLU)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35" name="Rectangle 231"/>
                <p:cNvSpPr/>
                <p:nvPr/>
              </p:nvSpPr>
              <p:spPr>
                <a:xfrm flipH="1" rot="5400000">
                  <a:off x="3693960" y="3438720"/>
                  <a:ext cx="1443960" cy="152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 algn="ctr"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1" lang="en-US" sz="1000" spc="-1" strike="noStrike">
                      <a:solidFill>
                        <a:srgbClr val="000000"/>
                      </a:solidFill>
                      <a:latin typeface="Arial"/>
                    </a:rPr>
                    <a:t>Buoyant density (g/cm</a:t>
                  </a:r>
                  <a:r>
                    <a:rPr b="1" lang="en-US" sz="1000" spc="-1" strike="noStrike" baseline="30000">
                      <a:solidFill>
                        <a:srgbClr val="000000"/>
                      </a:solidFill>
                      <a:latin typeface="Arial"/>
                    </a:rPr>
                    <a:t>3</a:t>
                  </a:r>
                  <a:r>
                    <a:rPr b="1" lang="en-US" sz="1000" spc="-1" strike="noStrike">
                      <a:solidFill>
                        <a:srgbClr val="000000"/>
                      </a:solidFill>
                      <a:latin typeface="Arial"/>
                    </a:rPr>
                    <a:t>)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36" name="Straight Connector 25"/>
                <p:cNvSpPr/>
                <p:nvPr/>
              </p:nvSpPr>
              <p:spPr>
                <a:xfrm>
                  <a:off x="2502360" y="2894040"/>
                  <a:ext cx="50760" cy="1080"/>
                </a:xfrm>
                <a:prstGeom prst="line">
                  <a:avLst/>
                </a:prstGeom>
                <a:ln w="32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720" bIns="-4572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437" name="Group 53"/>
              <p:cNvGrpSpPr/>
              <p:nvPr/>
            </p:nvGrpSpPr>
            <p:grpSpPr>
              <a:xfrm>
                <a:off x="5310720" y="307800"/>
                <a:ext cx="2465280" cy="2140920"/>
                <a:chOff x="5310720" y="307800"/>
                <a:chExt cx="2465280" cy="2140920"/>
              </a:xfrm>
            </p:grpSpPr>
            <p:sp>
              <p:nvSpPr>
                <p:cNvPr id="438" name="Text Box 118"/>
                <p:cNvSpPr/>
                <p:nvPr/>
              </p:nvSpPr>
              <p:spPr>
                <a:xfrm rot="16200000">
                  <a:off x="4513680" y="1194840"/>
                  <a:ext cx="1840320" cy="2462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 algn="ctr"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1" lang="en-US" sz="10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Firefly luciferase (RLU/well)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39" name="Line 11"/>
                <p:cNvSpPr/>
                <p:nvPr/>
              </p:nvSpPr>
              <p:spPr>
                <a:xfrm>
                  <a:off x="6027840" y="2193480"/>
                  <a:ext cx="770040" cy="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40" name="Line 6"/>
                <p:cNvSpPr/>
                <p:nvPr/>
              </p:nvSpPr>
              <p:spPr>
                <a:xfrm>
                  <a:off x="6027840" y="399600"/>
                  <a:ext cx="0" cy="179424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41" name="Line 7"/>
                <p:cNvSpPr/>
                <p:nvPr/>
              </p:nvSpPr>
              <p:spPr>
                <a:xfrm>
                  <a:off x="5994720" y="2194200"/>
                  <a:ext cx="32760" cy="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42" name="Line 8"/>
                <p:cNvSpPr/>
                <p:nvPr/>
              </p:nvSpPr>
              <p:spPr>
                <a:xfrm>
                  <a:off x="5994720" y="1596600"/>
                  <a:ext cx="32760" cy="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43" name="Line 9"/>
                <p:cNvSpPr/>
                <p:nvPr/>
              </p:nvSpPr>
              <p:spPr>
                <a:xfrm>
                  <a:off x="5994720" y="998640"/>
                  <a:ext cx="32760" cy="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44" name="Line 10"/>
                <p:cNvSpPr/>
                <p:nvPr/>
              </p:nvSpPr>
              <p:spPr>
                <a:xfrm>
                  <a:off x="5994720" y="399600"/>
                  <a:ext cx="32760" cy="108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720" bIns="-4572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45" name="Line 12"/>
                <p:cNvSpPr/>
                <p:nvPr/>
              </p:nvSpPr>
              <p:spPr>
                <a:xfrm flipV="1">
                  <a:off x="6027840" y="2193840"/>
                  <a:ext cx="0" cy="2772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9080" bIns="-190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46" name="Rectangle 101"/>
                <p:cNvSpPr/>
                <p:nvPr/>
              </p:nvSpPr>
              <p:spPr>
                <a:xfrm>
                  <a:off x="5648760" y="1516320"/>
                  <a:ext cx="281160" cy="152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 algn="r"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1" lang="en-US" sz="10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6000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47" name="Rectangle 102"/>
                <p:cNvSpPr/>
                <p:nvPr/>
              </p:nvSpPr>
              <p:spPr>
                <a:xfrm>
                  <a:off x="5578200" y="918720"/>
                  <a:ext cx="351360" cy="152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 algn="r"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1" lang="en-US" sz="10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12000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48" name="Rectangle 103"/>
                <p:cNvSpPr/>
                <p:nvPr/>
              </p:nvSpPr>
              <p:spPr>
                <a:xfrm>
                  <a:off x="5578200" y="319680"/>
                  <a:ext cx="351360" cy="152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 algn="r"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1" lang="en-US" sz="10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18000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49" name="Rectangle 101"/>
                <p:cNvSpPr/>
                <p:nvPr/>
              </p:nvSpPr>
              <p:spPr>
                <a:xfrm>
                  <a:off x="5861160" y="2114280"/>
                  <a:ext cx="70920" cy="152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 algn="r"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1" lang="en-US" sz="10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0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50" name="Line 67"/>
                <p:cNvSpPr/>
                <p:nvPr/>
              </p:nvSpPr>
              <p:spPr>
                <a:xfrm flipV="1">
                  <a:off x="6529680" y="1819800"/>
                  <a:ext cx="0" cy="24336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51" name="Line 68"/>
                <p:cNvSpPr/>
                <p:nvPr/>
              </p:nvSpPr>
              <p:spPr>
                <a:xfrm>
                  <a:off x="6499080" y="1822320"/>
                  <a:ext cx="61200" cy="252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4280" bIns="-442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52" name="Rectangle 41"/>
                <p:cNvSpPr/>
                <p:nvPr/>
              </p:nvSpPr>
              <p:spPr>
                <a:xfrm>
                  <a:off x="6446880" y="2066760"/>
                  <a:ext cx="164880" cy="126720"/>
                </a:xfrm>
                <a:prstGeom prst="rect">
                  <a:avLst/>
                </a:prstGeom>
                <a:solidFill>
                  <a:srgbClr val="000000"/>
                </a:solidFill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ctr">
                  <a:noAutofit/>
                </a:bodyPr>
                <a:p>
                  <a:pPr algn="ctr"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grpSp>
              <p:nvGrpSpPr>
                <p:cNvPr id="453" name="Group 116"/>
                <p:cNvGrpSpPr/>
                <p:nvPr/>
              </p:nvGrpSpPr>
              <p:grpSpPr>
                <a:xfrm>
                  <a:off x="6924960" y="659160"/>
                  <a:ext cx="851040" cy="365040"/>
                  <a:chOff x="6924960" y="659160"/>
                  <a:chExt cx="851040" cy="365040"/>
                </a:xfrm>
              </p:grpSpPr>
              <p:sp>
                <p:nvSpPr>
                  <p:cNvPr id="454" name="Rectangle 95"/>
                  <p:cNvSpPr/>
                  <p:nvPr/>
                </p:nvSpPr>
                <p:spPr>
                  <a:xfrm>
                    <a:off x="7098480" y="659160"/>
                    <a:ext cx="677520" cy="1526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457200"/>
                        <a:tab algn="l" pos="914400"/>
                        <a:tab algn="l" pos="1371600"/>
                        <a:tab algn="l" pos="1828800"/>
                        <a:tab algn="l" pos="2286000"/>
                        <a:tab algn="l" pos="2743200"/>
                        <a:tab algn="l" pos="3200400"/>
                        <a:tab algn="l" pos="3657600"/>
                        <a:tab algn="l" pos="4114800"/>
                        <a:tab algn="l" pos="4572000"/>
                        <a:tab algn="l" pos="5029200"/>
                        <a:tab algn="l" pos="5486400"/>
                        <a:tab algn="l" pos="5943600"/>
                        <a:tab algn="l" pos="6400800"/>
                        <a:tab algn="l" pos="6858000"/>
                        <a:tab algn="l" pos="7315200"/>
                        <a:tab algn="l" pos="7772400"/>
                        <a:tab algn="l" pos="8229600"/>
                        <a:tab algn="l" pos="8686800"/>
                        <a:tab algn="l" pos="9144000"/>
                      </a:tabLst>
                    </a:pPr>
                    <a:r>
                      <a:rPr b="1" lang="en-US" sz="1000" spc="-1" strike="noStrike">
                        <a:solidFill>
                          <a:srgbClr val="000000"/>
                        </a:solidFill>
                        <a:latin typeface="Arial"/>
                        <a:ea typeface="Arial"/>
                      </a:rPr>
                      <a:t>control IgG</a:t>
                    </a:r>
                    <a:endParaRPr b="0" lang="en-US" sz="10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55" name="Rectangle 117"/>
                  <p:cNvSpPr/>
                  <p:nvPr/>
                </p:nvSpPr>
                <p:spPr>
                  <a:xfrm>
                    <a:off x="7098480" y="861120"/>
                    <a:ext cx="605880" cy="1526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457200"/>
                        <a:tab algn="l" pos="914400"/>
                        <a:tab algn="l" pos="1371600"/>
                        <a:tab algn="l" pos="1828800"/>
                        <a:tab algn="l" pos="2286000"/>
                        <a:tab algn="l" pos="2743200"/>
                        <a:tab algn="l" pos="3200400"/>
                        <a:tab algn="l" pos="3657600"/>
                        <a:tab algn="l" pos="4114800"/>
                        <a:tab algn="l" pos="4572000"/>
                        <a:tab algn="l" pos="5029200"/>
                        <a:tab algn="l" pos="5486400"/>
                        <a:tab algn="l" pos="5943600"/>
                        <a:tab algn="l" pos="6400800"/>
                        <a:tab algn="l" pos="6858000"/>
                        <a:tab algn="l" pos="7315200"/>
                        <a:tab algn="l" pos="7772400"/>
                        <a:tab algn="l" pos="8229600"/>
                        <a:tab algn="l" pos="8686800"/>
                        <a:tab algn="l" pos="9144000"/>
                      </a:tabLst>
                    </a:pPr>
                    <a:r>
                      <a:rPr b="1" lang="en-US" sz="1000" spc="-1" strike="noStrike">
                        <a:solidFill>
                          <a:srgbClr val="000000"/>
                        </a:solidFill>
                        <a:latin typeface="Arial"/>
                        <a:ea typeface="Arial"/>
                      </a:rPr>
                      <a:t>anti-HVR1</a:t>
                    </a:r>
                    <a:endParaRPr b="0" lang="en-US" sz="10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56" name="Rectangle 45"/>
                  <p:cNvSpPr/>
                  <p:nvPr/>
                </p:nvSpPr>
                <p:spPr>
                  <a:xfrm>
                    <a:off x="6924960" y="911160"/>
                    <a:ext cx="101520" cy="113040"/>
                  </a:xfrm>
                  <a:prstGeom prst="rect">
                    <a:avLst/>
                  </a:prstGeom>
                  <a:solidFill>
                    <a:srgbClr val="000000"/>
                  </a:solidFill>
                  <a:ln w="1260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ctr">
                    <a:noAutofit/>
                  </a:bodyPr>
                  <a:p>
                    <a:pPr algn="ctr">
                      <a:tabLst>
                        <a:tab algn="l" pos="0"/>
                        <a:tab algn="l" pos="457200"/>
                        <a:tab algn="l" pos="914400"/>
                        <a:tab algn="l" pos="1371600"/>
                        <a:tab algn="l" pos="1828800"/>
                        <a:tab algn="l" pos="2286000"/>
                        <a:tab algn="l" pos="2743200"/>
                        <a:tab algn="l" pos="3200400"/>
                        <a:tab algn="l" pos="3657600"/>
                        <a:tab algn="l" pos="4114800"/>
                        <a:tab algn="l" pos="4572000"/>
                        <a:tab algn="l" pos="5029200"/>
                        <a:tab algn="l" pos="5486400"/>
                        <a:tab algn="l" pos="5943600"/>
                        <a:tab algn="l" pos="6400800"/>
                        <a:tab algn="l" pos="6858000"/>
                        <a:tab algn="l" pos="7315200"/>
                        <a:tab algn="l" pos="7772400"/>
                        <a:tab algn="l" pos="8229600"/>
                        <a:tab algn="l" pos="8686800"/>
                        <a:tab algn="l" pos="9144000"/>
                      </a:tabLst>
                    </a:pPr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57" name="Rectangle 46"/>
                  <p:cNvSpPr/>
                  <p:nvPr/>
                </p:nvSpPr>
                <p:spPr>
                  <a:xfrm>
                    <a:off x="6924960" y="721080"/>
                    <a:ext cx="101520" cy="109800"/>
                  </a:xfrm>
                  <a:prstGeom prst="rect">
                    <a:avLst/>
                  </a:prstGeom>
                  <a:solidFill>
                    <a:srgbClr val="ffffff"/>
                  </a:solidFill>
                  <a:ln w="1260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ctr">
                    <a:noAutofit/>
                  </a:bodyPr>
                  <a:p>
                    <a:pPr algn="ctr">
                      <a:tabLst>
                        <a:tab algn="l" pos="0"/>
                        <a:tab algn="l" pos="457200"/>
                        <a:tab algn="l" pos="914400"/>
                        <a:tab algn="l" pos="1371600"/>
                        <a:tab algn="l" pos="1828800"/>
                        <a:tab algn="l" pos="2286000"/>
                        <a:tab algn="l" pos="2743200"/>
                        <a:tab algn="l" pos="3200400"/>
                        <a:tab algn="l" pos="3657600"/>
                        <a:tab algn="l" pos="4114800"/>
                        <a:tab algn="l" pos="4572000"/>
                        <a:tab algn="l" pos="5029200"/>
                        <a:tab algn="l" pos="5486400"/>
                        <a:tab algn="l" pos="5943600"/>
                        <a:tab algn="l" pos="6400800"/>
                        <a:tab algn="l" pos="6858000"/>
                        <a:tab algn="l" pos="7315200"/>
                        <a:tab algn="l" pos="7772400"/>
                        <a:tab algn="l" pos="8229600"/>
                        <a:tab algn="l" pos="8686800"/>
                        <a:tab algn="l" pos="9144000"/>
                      </a:tabLst>
                    </a:pPr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sp>
              <p:nvSpPr>
                <p:cNvPr id="458" name="Rectangle 47"/>
                <p:cNvSpPr/>
                <p:nvPr/>
              </p:nvSpPr>
              <p:spPr>
                <a:xfrm>
                  <a:off x="6276960" y="1109520"/>
                  <a:ext cx="164880" cy="1084320"/>
                </a:xfrm>
                <a:prstGeom prst="rect">
                  <a:avLst/>
                </a:prstGeom>
                <a:solidFill>
                  <a:srgbClr val="ffffff"/>
                </a:solidFill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ctr">
                  <a:noAutofit/>
                </a:bodyPr>
                <a:p>
                  <a:pPr algn="ctr"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59" name="Line 46"/>
                <p:cNvSpPr/>
                <p:nvPr/>
              </p:nvSpPr>
              <p:spPr>
                <a:xfrm flipV="1">
                  <a:off x="6359760" y="662400"/>
                  <a:ext cx="0" cy="44100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60" name="Line 47"/>
                <p:cNvSpPr/>
                <p:nvPr/>
              </p:nvSpPr>
              <p:spPr>
                <a:xfrm>
                  <a:off x="6329160" y="662760"/>
                  <a:ext cx="61200" cy="252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4280" bIns="-442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61" name="TextBox 50"/>
                <p:cNvSpPr/>
                <p:nvPr/>
              </p:nvSpPr>
              <p:spPr>
                <a:xfrm>
                  <a:off x="5949360" y="307800"/>
                  <a:ext cx="1125720" cy="2462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ctr"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en-US" sz="1000" spc="-1" strike="noStrike">
                      <a:solidFill>
                        <a:srgbClr val="000000"/>
                      </a:solidFill>
                      <a:latin typeface="Arial"/>
                    </a:rPr>
                    <a:t>1/8 (p &lt; 0.02)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62" name="Right Bracket 51"/>
                <p:cNvSpPr/>
                <p:nvPr/>
              </p:nvSpPr>
              <p:spPr>
                <a:xfrm rot="16200000">
                  <a:off x="6419880" y="515880"/>
                  <a:ext cx="47520" cy="168120"/>
                </a:xfrm>
                <a:custGeom>
                  <a:avLst/>
                  <a:gdLst>
                    <a:gd name="textAreaLeft" fmla="*/ 0 w 47520"/>
                    <a:gd name="textAreaRight" fmla="*/ 33480 w 47520"/>
                    <a:gd name="textAreaTop" fmla="*/ 1800 h 168120"/>
                    <a:gd name="textAreaBottom" fmla="*/ 166320 h 168120"/>
                  </a:gdLst>
                  <a:ahLst/>
                  <a:rect l="textAreaLeft" t="textAreaTop" r="textAreaRight" b="textAreaBottom"/>
                  <a:pathLst>
                    <a:path w="21600" h="21600">
                      <a:moveTo>
                        <a:pt x="0" y="0"/>
                      </a:moveTo>
                      <a:cubicBezTo>
                        <a:pt x="10800" y="0"/>
                        <a:pt x="21600" y="255"/>
                        <a:pt x="21600" y="509"/>
                      </a:cubicBezTo>
                      <a:lnTo>
                        <a:pt x="21600" y="21091"/>
                      </a:lnTo>
                      <a:cubicBezTo>
                        <a:pt x="21600" y="21346"/>
                        <a:pt x="10800" y="21600"/>
                        <a:pt x="0" y="21600"/>
                      </a:cubicBezTo>
                    </a:path>
                  </a:pathLst>
                </a:custGeom>
                <a:noFill/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63" name="TextBox 52"/>
                <p:cNvSpPr/>
                <p:nvPr/>
              </p:nvSpPr>
              <p:spPr>
                <a:xfrm>
                  <a:off x="6151320" y="2202480"/>
                  <a:ext cx="573840" cy="2462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1" lang="en-US" sz="1000" spc="-1" strike="noStrike">
                      <a:solidFill>
                        <a:srgbClr val="000000"/>
                      </a:solidFill>
                      <a:latin typeface="Arial"/>
                    </a:rPr>
                    <a:t>HCVrp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</p:grp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569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2-28T07:00:19Z</dcterms:created>
  <dc:creator>bertrand saunier</dc:creator>
  <dc:description/>
  <dc:language>en-US</dc:language>
  <cp:lastModifiedBy>triyatnm</cp:lastModifiedBy>
  <dcterms:modified xsi:type="dcterms:W3CDTF">2011-03-09T18:29:11Z</dcterms:modified>
  <cp:revision>138</cp:revision>
  <dc:subject/>
  <dc:title>Slide 1</dc:title>
</cp:coreProperties>
</file>